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65" r:id="rId3"/>
    <p:sldId id="266" r:id="rId4"/>
  </p:sldIdLst>
  <p:sldSz cx="9906000" cy="6858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1.8766103631880283E-2"/>
          <c:y val="2.7393176982018277E-2"/>
          <c:w val="0.7861962559677208"/>
          <c:h val="0.73604689981270233"/>
        </c:manualLayout>
      </c:layout>
      <c:scatterChart>
        <c:scatterStyle val="lineMarker"/>
        <c:varyColors val="0"/>
        <c:ser>
          <c:idx val="0"/>
          <c:order val="0"/>
          <c:tx>
            <c:strRef>
              <c:f>Figure1!$AM$1</c:f>
              <c:strCache>
                <c:ptCount val="1"/>
                <c:pt idx="0">
                  <c:v>Have you ever been diagnosed with pneumonia? 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M$2:$AM$102</c:f>
              <c:numCache>
                <c:formatCode>General</c:formatCode>
                <c:ptCount val="101"/>
                <c:pt idx="0">
                  <c:v>0.17720379999999999</c:v>
                </c:pt>
                <c:pt idx="1">
                  <c:v>0.177204</c:v>
                </c:pt>
                <c:pt idx="2">
                  <c:v>0.1772041</c:v>
                </c:pt>
                <c:pt idx="3">
                  <c:v>0.17720430000000001</c:v>
                </c:pt>
                <c:pt idx="4">
                  <c:v>0.17720449999999999</c:v>
                </c:pt>
                <c:pt idx="5">
                  <c:v>0.17720459999999999</c:v>
                </c:pt>
                <c:pt idx="6">
                  <c:v>0.1772048</c:v>
                </c:pt>
                <c:pt idx="7">
                  <c:v>0.177205</c:v>
                </c:pt>
                <c:pt idx="8">
                  <c:v>0.1772051</c:v>
                </c:pt>
                <c:pt idx="9">
                  <c:v>0.17720530000000001</c:v>
                </c:pt>
                <c:pt idx="10">
                  <c:v>0.17720549999999999</c:v>
                </c:pt>
                <c:pt idx="11">
                  <c:v>0.17720559999999999</c:v>
                </c:pt>
                <c:pt idx="12">
                  <c:v>0.1772058</c:v>
                </c:pt>
                <c:pt idx="13">
                  <c:v>0.177206</c:v>
                </c:pt>
                <c:pt idx="14">
                  <c:v>0.17720620000000001</c:v>
                </c:pt>
                <c:pt idx="15">
                  <c:v>0.17720630000000001</c:v>
                </c:pt>
                <c:pt idx="16">
                  <c:v>0.17720649999999999</c:v>
                </c:pt>
                <c:pt idx="17">
                  <c:v>0.17720669999999999</c:v>
                </c:pt>
                <c:pt idx="18">
                  <c:v>0.1772069</c:v>
                </c:pt>
                <c:pt idx="19">
                  <c:v>0.17720710000000001</c:v>
                </c:pt>
                <c:pt idx="20">
                  <c:v>0.17720730000000001</c:v>
                </c:pt>
                <c:pt idx="21">
                  <c:v>0.17720749999999999</c:v>
                </c:pt>
                <c:pt idx="22">
                  <c:v>0.1772077</c:v>
                </c:pt>
                <c:pt idx="23">
                  <c:v>0.1772078</c:v>
                </c:pt>
                <c:pt idx="24">
                  <c:v>0.177208</c:v>
                </c:pt>
                <c:pt idx="25">
                  <c:v>0.17720820000000001</c:v>
                </c:pt>
                <c:pt idx="26">
                  <c:v>0.17720839999999999</c:v>
                </c:pt>
                <c:pt idx="27">
                  <c:v>0.17720859999999999</c:v>
                </c:pt>
                <c:pt idx="28">
                  <c:v>0.1772088</c:v>
                </c:pt>
                <c:pt idx="29">
                  <c:v>0.17720900000000001</c:v>
                </c:pt>
                <c:pt idx="30">
                  <c:v>0.17720929999999999</c:v>
                </c:pt>
                <c:pt idx="31">
                  <c:v>0.17720949999999999</c:v>
                </c:pt>
                <c:pt idx="32">
                  <c:v>0.1772097</c:v>
                </c:pt>
                <c:pt idx="33">
                  <c:v>0.1772099</c:v>
                </c:pt>
                <c:pt idx="34">
                  <c:v>0.17721010000000001</c:v>
                </c:pt>
                <c:pt idx="35">
                  <c:v>0.17721029999999999</c:v>
                </c:pt>
                <c:pt idx="36">
                  <c:v>0.17721049999999999</c:v>
                </c:pt>
                <c:pt idx="37">
                  <c:v>0.1772107</c:v>
                </c:pt>
                <c:pt idx="38">
                  <c:v>0.17721100000000001</c:v>
                </c:pt>
                <c:pt idx="39">
                  <c:v>0.17721120000000001</c:v>
                </c:pt>
                <c:pt idx="40">
                  <c:v>0.17721139999999999</c:v>
                </c:pt>
                <c:pt idx="41">
                  <c:v>0.1772116</c:v>
                </c:pt>
                <c:pt idx="42">
                  <c:v>0.17721190000000001</c:v>
                </c:pt>
                <c:pt idx="43">
                  <c:v>0.17721210000000001</c:v>
                </c:pt>
                <c:pt idx="44">
                  <c:v>0.17721229999999999</c:v>
                </c:pt>
                <c:pt idx="45">
                  <c:v>0.1772126</c:v>
                </c:pt>
                <c:pt idx="46">
                  <c:v>0.1772128</c:v>
                </c:pt>
                <c:pt idx="47">
                  <c:v>0.17721310000000001</c:v>
                </c:pt>
                <c:pt idx="48">
                  <c:v>0.17721329999999999</c:v>
                </c:pt>
                <c:pt idx="49">
                  <c:v>0.1772135</c:v>
                </c:pt>
                <c:pt idx="50">
                  <c:v>0.1772138</c:v>
                </c:pt>
                <c:pt idx="51">
                  <c:v>0.17721400000000001</c:v>
                </c:pt>
                <c:pt idx="52">
                  <c:v>0.17721429999999999</c:v>
                </c:pt>
                <c:pt idx="53">
                  <c:v>0.1772145</c:v>
                </c:pt>
                <c:pt idx="54">
                  <c:v>0.17721480000000001</c:v>
                </c:pt>
                <c:pt idx="55">
                  <c:v>0.17721509999999999</c:v>
                </c:pt>
                <c:pt idx="56">
                  <c:v>0.17721529999999999</c:v>
                </c:pt>
                <c:pt idx="57">
                  <c:v>0.1772156</c:v>
                </c:pt>
                <c:pt idx="58">
                  <c:v>0.17721580000000001</c:v>
                </c:pt>
                <c:pt idx="59">
                  <c:v>0.17721609999999999</c:v>
                </c:pt>
                <c:pt idx="60">
                  <c:v>0.1772164</c:v>
                </c:pt>
                <c:pt idx="61">
                  <c:v>0.1772167</c:v>
                </c:pt>
                <c:pt idx="62">
                  <c:v>0.17721690000000001</c:v>
                </c:pt>
                <c:pt idx="63">
                  <c:v>0.17721719999999999</c:v>
                </c:pt>
                <c:pt idx="64">
                  <c:v>0.1772175</c:v>
                </c:pt>
                <c:pt idx="65">
                  <c:v>0.17721780000000001</c:v>
                </c:pt>
                <c:pt idx="66">
                  <c:v>0.17721809999999999</c:v>
                </c:pt>
                <c:pt idx="67">
                  <c:v>0.1772183</c:v>
                </c:pt>
                <c:pt idx="68">
                  <c:v>0.1772186</c:v>
                </c:pt>
                <c:pt idx="69">
                  <c:v>0.17721890000000001</c:v>
                </c:pt>
                <c:pt idx="70">
                  <c:v>0.17721919999999999</c:v>
                </c:pt>
                <c:pt idx="71">
                  <c:v>0.1772195</c:v>
                </c:pt>
                <c:pt idx="72">
                  <c:v>0.17721980000000001</c:v>
                </c:pt>
                <c:pt idx="73">
                  <c:v>0.17722009999999999</c:v>
                </c:pt>
                <c:pt idx="74">
                  <c:v>0.1772204</c:v>
                </c:pt>
                <c:pt idx="75">
                  <c:v>0.17722070000000001</c:v>
                </c:pt>
                <c:pt idx="76">
                  <c:v>0.17722109999999999</c:v>
                </c:pt>
                <c:pt idx="77">
                  <c:v>0.1772214</c:v>
                </c:pt>
                <c:pt idx="78">
                  <c:v>0.17722170000000001</c:v>
                </c:pt>
                <c:pt idx="79">
                  <c:v>0.17722199999999999</c:v>
                </c:pt>
                <c:pt idx="80">
                  <c:v>0.1772223</c:v>
                </c:pt>
                <c:pt idx="81">
                  <c:v>0.17722270000000001</c:v>
                </c:pt>
                <c:pt idx="82">
                  <c:v>0.17722299999999999</c:v>
                </c:pt>
                <c:pt idx="83">
                  <c:v>0.1772233</c:v>
                </c:pt>
                <c:pt idx="84">
                  <c:v>0.17722370000000001</c:v>
                </c:pt>
                <c:pt idx="85">
                  <c:v>0.17722399999999999</c:v>
                </c:pt>
                <c:pt idx="86">
                  <c:v>0.1772243</c:v>
                </c:pt>
                <c:pt idx="87">
                  <c:v>0.17722470000000001</c:v>
                </c:pt>
                <c:pt idx="88">
                  <c:v>0.17722499999999999</c:v>
                </c:pt>
                <c:pt idx="89">
                  <c:v>0.17722540000000001</c:v>
                </c:pt>
                <c:pt idx="90">
                  <c:v>0.17722570000000001</c:v>
                </c:pt>
                <c:pt idx="91">
                  <c:v>0.1772261</c:v>
                </c:pt>
                <c:pt idx="92">
                  <c:v>0.17722640000000001</c:v>
                </c:pt>
                <c:pt idx="93">
                  <c:v>0.17722679999999999</c:v>
                </c:pt>
                <c:pt idx="94">
                  <c:v>0.1772272</c:v>
                </c:pt>
                <c:pt idx="95">
                  <c:v>0.17722750000000001</c:v>
                </c:pt>
                <c:pt idx="96">
                  <c:v>0.17722789999999999</c:v>
                </c:pt>
                <c:pt idx="97">
                  <c:v>0.17722830000000001</c:v>
                </c:pt>
                <c:pt idx="98">
                  <c:v>0.17722869999999999</c:v>
                </c:pt>
                <c:pt idx="99">
                  <c:v>0.1772291</c:v>
                </c:pt>
                <c:pt idx="100">
                  <c:v>0.1772294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086-4159-BC08-37745C7198BB}"/>
            </c:ext>
          </c:extLst>
        </c:ser>
        <c:ser>
          <c:idx val="1"/>
          <c:order val="1"/>
          <c:tx>
            <c:strRef>
              <c:f>Figure1!$AN$1</c:f>
              <c:strCache>
                <c:ptCount val="1"/>
                <c:pt idx="0">
                  <c:v>Have you been losing weight?  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lgDash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N$2:$AN$102</c:f>
              <c:numCache>
                <c:formatCode>General</c:formatCode>
                <c:ptCount val="101"/>
                <c:pt idx="0">
                  <c:v>0.16122990000000001</c:v>
                </c:pt>
                <c:pt idx="1">
                  <c:v>0.16122990000000001</c:v>
                </c:pt>
                <c:pt idx="2">
                  <c:v>0.16122990000000001</c:v>
                </c:pt>
                <c:pt idx="3">
                  <c:v>0.16122990000000001</c:v>
                </c:pt>
                <c:pt idx="4">
                  <c:v>0.16122990000000001</c:v>
                </c:pt>
                <c:pt idx="5">
                  <c:v>0.16122990000000001</c:v>
                </c:pt>
                <c:pt idx="6">
                  <c:v>0.16122990000000001</c:v>
                </c:pt>
                <c:pt idx="7">
                  <c:v>0.16122990000000001</c:v>
                </c:pt>
                <c:pt idx="8">
                  <c:v>0.16122990000000001</c:v>
                </c:pt>
                <c:pt idx="9">
                  <c:v>0.16122990000000001</c:v>
                </c:pt>
                <c:pt idx="10">
                  <c:v>0.16122990000000001</c:v>
                </c:pt>
                <c:pt idx="11">
                  <c:v>0.16122990000000001</c:v>
                </c:pt>
                <c:pt idx="12">
                  <c:v>0.16122990000000001</c:v>
                </c:pt>
                <c:pt idx="13">
                  <c:v>0.16122990000000001</c:v>
                </c:pt>
                <c:pt idx="14">
                  <c:v>0.16122990000000001</c:v>
                </c:pt>
                <c:pt idx="15">
                  <c:v>0.16122990000000001</c:v>
                </c:pt>
                <c:pt idx="16">
                  <c:v>0.16122990000000001</c:v>
                </c:pt>
                <c:pt idx="17">
                  <c:v>0.16122990000000001</c:v>
                </c:pt>
                <c:pt idx="18">
                  <c:v>0.16122990000000001</c:v>
                </c:pt>
                <c:pt idx="19">
                  <c:v>0.16122990000000001</c:v>
                </c:pt>
                <c:pt idx="20">
                  <c:v>0.16122990000000001</c:v>
                </c:pt>
                <c:pt idx="21">
                  <c:v>0.16122990000000001</c:v>
                </c:pt>
                <c:pt idx="22">
                  <c:v>0.16122990000000001</c:v>
                </c:pt>
                <c:pt idx="23">
                  <c:v>0.16122990000000001</c:v>
                </c:pt>
                <c:pt idx="24">
                  <c:v>0.16122990000000001</c:v>
                </c:pt>
                <c:pt idx="25">
                  <c:v>0.16123000000000001</c:v>
                </c:pt>
                <c:pt idx="26">
                  <c:v>0.16123000000000001</c:v>
                </c:pt>
                <c:pt idx="27">
                  <c:v>0.16123009999999999</c:v>
                </c:pt>
                <c:pt idx="28">
                  <c:v>0.16123029999999999</c:v>
                </c:pt>
                <c:pt idx="29">
                  <c:v>0.1612305</c:v>
                </c:pt>
                <c:pt idx="30">
                  <c:v>0.16123090000000001</c:v>
                </c:pt>
                <c:pt idx="31">
                  <c:v>0.1612315</c:v>
                </c:pt>
                <c:pt idx="32">
                  <c:v>0.1612325</c:v>
                </c:pt>
                <c:pt idx="33">
                  <c:v>0.16123419999999999</c:v>
                </c:pt>
                <c:pt idx="34">
                  <c:v>0.16123680000000001</c:v>
                </c:pt>
                <c:pt idx="35">
                  <c:v>0.161241</c:v>
                </c:pt>
                <c:pt idx="36">
                  <c:v>0.16124769999999999</c:v>
                </c:pt>
                <c:pt idx="37">
                  <c:v>0.1612586</c:v>
                </c:pt>
                <c:pt idx="38">
                  <c:v>0.161276</c:v>
                </c:pt>
                <c:pt idx="39">
                  <c:v>0.16130410000000001</c:v>
                </c:pt>
                <c:pt idx="40">
                  <c:v>0.1613492</c:v>
                </c:pt>
                <c:pt idx="41">
                  <c:v>0.1614218</c:v>
                </c:pt>
                <c:pt idx="42">
                  <c:v>0.1615385</c:v>
                </c:pt>
                <c:pt idx="43">
                  <c:v>0.16172610000000001</c:v>
                </c:pt>
                <c:pt idx="44">
                  <c:v>0.1620277</c:v>
                </c:pt>
                <c:pt idx="45">
                  <c:v>0.1625123</c:v>
                </c:pt>
                <c:pt idx="46">
                  <c:v>0.16329050000000001</c:v>
                </c:pt>
                <c:pt idx="47">
                  <c:v>0.16453899999999999</c:v>
                </c:pt>
                <c:pt idx="48">
                  <c:v>0.1665394</c:v>
                </c:pt>
                <c:pt idx="49">
                  <c:v>0.16973650000000001</c:v>
                </c:pt>
                <c:pt idx="50">
                  <c:v>0.1748275</c:v>
                </c:pt>
                <c:pt idx="51">
                  <c:v>0.18288579999999999</c:v>
                </c:pt>
                <c:pt idx="52">
                  <c:v>0.1955211</c:v>
                </c:pt>
                <c:pt idx="53">
                  <c:v>0.21504309999999999</c:v>
                </c:pt>
                <c:pt idx="54">
                  <c:v>0.2445283</c:v>
                </c:pt>
                <c:pt idx="55">
                  <c:v>0.28756870000000001</c:v>
                </c:pt>
                <c:pt idx="56">
                  <c:v>0.34736860000000003</c:v>
                </c:pt>
                <c:pt idx="57">
                  <c:v>0.42499419999999999</c:v>
                </c:pt>
                <c:pt idx="58">
                  <c:v>0.51732860000000003</c:v>
                </c:pt>
                <c:pt idx="59">
                  <c:v>0.61639940000000004</c:v>
                </c:pt>
                <c:pt idx="60">
                  <c:v>0.71160409999999996</c:v>
                </c:pt>
                <c:pt idx="61">
                  <c:v>0.79388020000000004</c:v>
                </c:pt>
                <c:pt idx="62">
                  <c:v>0.85870970000000002</c:v>
                </c:pt>
                <c:pt idx="63">
                  <c:v>0.9061728</c:v>
                </c:pt>
                <c:pt idx="64">
                  <c:v>0.93908429999999998</c:v>
                </c:pt>
                <c:pt idx="65">
                  <c:v>0.96105510000000005</c:v>
                </c:pt>
                <c:pt idx="66">
                  <c:v>0.97535260000000001</c:v>
                </c:pt>
                <c:pt idx="67">
                  <c:v>0.98450289999999996</c:v>
                </c:pt>
                <c:pt idx="68">
                  <c:v>0.99029670000000003</c:v>
                </c:pt>
                <c:pt idx="69">
                  <c:v>0.9939403</c:v>
                </c:pt>
                <c:pt idx="70">
                  <c:v>0.99622200000000005</c:v>
                </c:pt>
                <c:pt idx="71">
                  <c:v>0.99764699999999995</c:v>
                </c:pt>
                <c:pt idx="72">
                  <c:v>0.99853539999999996</c:v>
                </c:pt>
                <c:pt idx="73">
                  <c:v>0.9990888</c:v>
                </c:pt>
                <c:pt idx="74">
                  <c:v>0.99943320000000002</c:v>
                </c:pt>
                <c:pt idx="75">
                  <c:v>0.99964750000000002</c:v>
                </c:pt>
                <c:pt idx="76">
                  <c:v>0.99978080000000003</c:v>
                </c:pt>
                <c:pt idx="77">
                  <c:v>0.99986370000000002</c:v>
                </c:pt>
                <c:pt idx="78">
                  <c:v>0.9999152</c:v>
                </c:pt>
                <c:pt idx="79">
                  <c:v>0.99994729999999998</c:v>
                </c:pt>
                <c:pt idx="80">
                  <c:v>0.99996719999999994</c:v>
                </c:pt>
                <c:pt idx="81">
                  <c:v>0.99997959999999997</c:v>
                </c:pt>
                <c:pt idx="82">
                  <c:v>0.99998730000000002</c:v>
                </c:pt>
                <c:pt idx="83">
                  <c:v>0.99999210000000005</c:v>
                </c:pt>
                <c:pt idx="84">
                  <c:v>0.99999510000000003</c:v>
                </c:pt>
                <c:pt idx="85">
                  <c:v>0.99999700000000002</c:v>
                </c:pt>
                <c:pt idx="86">
                  <c:v>0.9999981</c:v>
                </c:pt>
                <c:pt idx="87">
                  <c:v>0.99999879999999997</c:v>
                </c:pt>
                <c:pt idx="88">
                  <c:v>0.99999930000000004</c:v>
                </c:pt>
                <c:pt idx="89">
                  <c:v>0.99999950000000004</c:v>
                </c:pt>
                <c:pt idx="90">
                  <c:v>0.99999970000000005</c:v>
                </c:pt>
                <c:pt idx="91">
                  <c:v>0.99999979999999999</c:v>
                </c:pt>
                <c:pt idx="92">
                  <c:v>0.99999990000000005</c:v>
                </c:pt>
                <c:pt idx="93">
                  <c:v>0.99999990000000005</c:v>
                </c:pt>
                <c:pt idx="94">
                  <c:v>1</c:v>
                </c:pt>
                <c:pt idx="95">
                  <c:v>1</c:v>
                </c:pt>
                <c:pt idx="96">
                  <c:v>1</c:v>
                </c:pt>
                <c:pt idx="97">
                  <c:v>1</c:v>
                </c:pt>
                <c:pt idx="98">
                  <c:v>1</c:v>
                </c:pt>
                <c:pt idx="99">
                  <c:v>1</c:v>
                </c:pt>
                <c:pt idx="100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086-4159-BC08-37745C7198BB}"/>
            </c:ext>
          </c:extLst>
        </c:ser>
        <c:ser>
          <c:idx val="2"/>
          <c:order val="2"/>
          <c:tx>
            <c:strRef>
              <c:f>Figure1!$AO$1</c:f>
              <c:strCache>
                <c:ptCount val="1"/>
                <c:pt idx="0">
                  <c:v>Do you feel that bolus of food are hard to swallow? 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O$2:$AO$102</c:f>
              <c:numCache>
                <c:formatCode>General</c:formatCode>
                <c:ptCount val="101"/>
                <c:pt idx="0">
                  <c:v>3.479612E-2</c:v>
                </c:pt>
                <c:pt idx="1">
                  <c:v>3.479612E-2</c:v>
                </c:pt>
                <c:pt idx="2">
                  <c:v>3.479612E-2</c:v>
                </c:pt>
                <c:pt idx="3">
                  <c:v>3.479612E-2</c:v>
                </c:pt>
                <c:pt idx="4">
                  <c:v>3.479612E-2</c:v>
                </c:pt>
                <c:pt idx="5">
                  <c:v>3.479612E-2</c:v>
                </c:pt>
                <c:pt idx="6">
                  <c:v>3.479612E-2</c:v>
                </c:pt>
                <c:pt idx="7">
                  <c:v>3.479612E-2</c:v>
                </c:pt>
                <c:pt idx="8">
                  <c:v>3.479612E-2</c:v>
                </c:pt>
                <c:pt idx="9">
                  <c:v>3.479612E-2</c:v>
                </c:pt>
                <c:pt idx="10">
                  <c:v>3.479612E-2</c:v>
                </c:pt>
                <c:pt idx="11">
                  <c:v>3.479612E-2</c:v>
                </c:pt>
                <c:pt idx="12">
                  <c:v>3.4796130000000002E-2</c:v>
                </c:pt>
                <c:pt idx="13">
                  <c:v>3.4796130000000002E-2</c:v>
                </c:pt>
                <c:pt idx="14">
                  <c:v>3.4796140000000003E-2</c:v>
                </c:pt>
                <c:pt idx="15">
                  <c:v>3.4796149999999998E-2</c:v>
                </c:pt>
                <c:pt idx="16">
                  <c:v>3.479616E-2</c:v>
                </c:pt>
                <c:pt idx="17">
                  <c:v>3.4796180000000003E-2</c:v>
                </c:pt>
                <c:pt idx="18">
                  <c:v>3.4796199999999999E-2</c:v>
                </c:pt>
                <c:pt idx="19">
                  <c:v>3.4796239999999999E-2</c:v>
                </c:pt>
                <c:pt idx="20">
                  <c:v>3.4796290000000001E-2</c:v>
                </c:pt>
                <c:pt idx="21">
                  <c:v>3.479637E-2</c:v>
                </c:pt>
                <c:pt idx="22">
                  <c:v>3.4796479999999998E-2</c:v>
                </c:pt>
                <c:pt idx="23">
                  <c:v>3.4796630000000002E-2</c:v>
                </c:pt>
                <c:pt idx="24">
                  <c:v>3.4796859999999999E-2</c:v>
                </c:pt>
                <c:pt idx="25">
                  <c:v>3.4797189999999999E-2</c:v>
                </c:pt>
                <c:pt idx="26">
                  <c:v>3.4797670000000003E-2</c:v>
                </c:pt>
                <c:pt idx="27">
                  <c:v>3.4798349999999999E-2</c:v>
                </c:pt>
                <c:pt idx="28">
                  <c:v>3.4799339999999998E-2</c:v>
                </c:pt>
                <c:pt idx="29">
                  <c:v>3.480076E-2</c:v>
                </c:pt>
                <c:pt idx="30">
                  <c:v>3.4802819999999998E-2</c:v>
                </c:pt>
                <c:pt idx="31">
                  <c:v>3.4805780000000001E-2</c:v>
                </c:pt>
                <c:pt idx="32">
                  <c:v>3.4810050000000002E-2</c:v>
                </c:pt>
                <c:pt idx="33">
                  <c:v>3.481621E-2</c:v>
                </c:pt>
                <c:pt idx="34">
                  <c:v>3.4825090000000003E-2</c:v>
                </c:pt>
                <c:pt idx="35">
                  <c:v>3.4837899999999998E-2</c:v>
                </c:pt>
                <c:pt idx="36">
                  <c:v>3.4856369999999998E-2</c:v>
                </c:pt>
                <c:pt idx="37">
                  <c:v>3.4883009999999999E-2</c:v>
                </c:pt>
                <c:pt idx="38">
                  <c:v>3.4921420000000002E-2</c:v>
                </c:pt>
                <c:pt idx="39">
                  <c:v>3.4976809999999997E-2</c:v>
                </c:pt>
                <c:pt idx="40">
                  <c:v>3.5056669999999998E-2</c:v>
                </c:pt>
                <c:pt idx="41">
                  <c:v>3.5171819999999999E-2</c:v>
                </c:pt>
                <c:pt idx="42">
                  <c:v>3.5337819999999999E-2</c:v>
                </c:pt>
                <c:pt idx="43">
                  <c:v>3.5577110000000002E-2</c:v>
                </c:pt>
                <c:pt idx="44">
                  <c:v>3.5921990000000001E-2</c:v>
                </c:pt>
                <c:pt idx="45">
                  <c:v>3.6418899999999997E-2</c:v>
                </c:pt>
                <c:pt idx="46">
                  <c:v>3.7134599999999997E-2</c:v>
                </c:pt>
                <c:pt idx="47">
                  <c:v>3.8164839999999998E-2</c:v>
                </c:pt>
                <c:pt idx="48">
                  <c:v>3.9646670000000002E-2</c:v>
                </c:pt>
                <c:pt idx="49">
                  <c:v>4.1775600000000003E-2</c:v>
                </c:pt>
                <c:pt idx="50">
                  <c:v>4.4829170000000002E-2</c:v>
                </c:pt>
                <c:pt idx="51">
                  <c:v>4.9198609999999997E-2</c:v>
                </c:pt>
                <c:pt idx="52">
                  <c:v>5.5429859999999997E-2</c:v>
                </c:pt>
                <c:pt idx="53">
                  <c:v>6.4273479999999994E-2</c:v>
                </c:pt>
                <c:pt idx="54">
                  <c:v>7.6739180000000004E-2</c:v>
                </c:pt>
                <c:pt idx="55">
                  <c:v>9.4142149999999994E-2</c:v>
                </c:pt>
                <c:pt idx="56">
                  <c:v>0.11811431999999999</c:v>
                </c:pt>
                <c:pt idx="57">
                  <c:v>0.15053258999999999</c:v>
                </c:pt>
                <c:pt idx="58">
                  <c:v>0.19329745000000001</c:v>
                </c:pt>
                <c:pt idx="59">
                  <c:v>0.24789986999999999</c:v>
                </c:pt>
                <c:pt idx="60">
                  <c:v>0.31478382999999999</c:v>
                </c:pt>
                <c:pt idx="61">
                  <c:v>0.39267106000000002</c:v>
                </c:pt>
                <c:pt idx="62">
                  <c:v>0.47820433000000001</c:v>
                </c:pt>
                <c:pt idx="63">
                  <c:v>0.56629021000000002</c:v>
                </c:pt>
                <c:pt idx="64">
                  <c:v>0.65120321999999997</c:v>
                </c:pt>
                <c:pt idx="65">
                  <c:v>0.72799955999999999</c:v>
                </c:pt>
                <c:pt idx="66">
                  <c:v>0.79355038</c:v>
                </c:pt>
                <c:pt idx="67">
                  <c:v>0.84679515000000005</c:v>
                </c:pt>
                <c:pt idx="68">
                  <c:v>0.88832878999999998</c:v>
                </c:pt>
                <c:pt idx="69">
                  <c:v>0.91971599000000004</c:v>
                </c:pt>
                <c:pt idx="70">
                  <c:v>0.94287171999999997</c:v>
                </c:pt>
                <c:pt idx="71">
                  <c:v>0.95965330999999998</c:v>
                </c:pt>
                <c:pt idx="72">
                  <c:v>0.97165911999999999</c:v>
                </c:pt>
                <c:pt idx="73">
                  <c:v>0.98016901000000001</c:v>
                </c:pt>
                <c:pt idx="74">
                  <c:v>0.98616137999999998</c:v>
                </c:pt>
                <c:pt idx="75">
                  <c:v>0.99036148999999996</c:v>
                </c:pt>
                <c:pt idx="76">
                  <c:v>0.99329582000000005</c:v>
                </c:pt>
                <c:pt idx="77">
                  <c:v>0.99534118999999999</c:v>
                </c:pt>
                <c:pt idx="78">
                  <c:v>0.99676463999999998</c:v>
                </c:pt>
                <c:pt idx="79">
                  <c:v>0.99775418999999999</c:v>
                </c:pt>
                <c:pt idx="80">
                  <c:v>0.99844157</c:v>
                </c:pt>
                <c:pt idx="81">
                  <c:v>0.9989188</c:v>
                </c:pt>
                <c:pt idx="82">
                  <c:v>0.99924999999999997</c:v>
                </c:pt>
                <c:pt idx="83">
                  <c:v>0.99947980000000003</c:v>
                </c:pt>
                <c:pt idx="84">
                  <c:v>0.99963922000000005</c:v>
                </c:pt>
                <c:pt idx="85">
                  <c:v>0.99974978999999997</c:v>
                </c:pt>
                <c:pt idx="86">
                  <c:v>0.99982649000000001</c:v>
                </c:pt>
                <c:pt idx="87">
                  <c:v>0.99987967</c:v>
                </c:pt>
                <c:pt idx="88">
                  <c:v>0.99991655999999995</c:v>
                </c:pt>
                <c:pt idx="89">
                  <c:v>0.99994214000000003</c:v>
                </c:pt>
                <c:pt idx="90">
                  <c:v>0.99995988000000002</c:v>
                </c:pt>
                <c:pt idx="91">
                  <c:v>0.99997217999999999</c:v>
                </c:pt>
                <c:pt idx="92">
                  <c:v>0.99998070999999999</c:v>
                </c:pt>
                <c:pt idx="93">
                  <c:v>0.99998662000000005</c:v>
                </c:pt>
                <c:pt idx="94">
                  <c:v>0.99999072</c:v>
                </c:pt>
                <c:pt idx="95">
                  <c:v>0.99999357</c:v>
                </c:pt>
                <c:pt idx="96">
                  <c:v>0.99999554000000002</c:v>
                </c:pt>
                <c:pt idx="97">
                  <c:v>0.99999691000000002</c:v>
                </c:pt>
                <c:pt idx="98">
                  <c:v>0.99999784999999997</c:v>
                </c:pt>
                <c:pt idx="99">
                  <c:v>0.99999850999999995</c:v>
                </c:pt>
                <c:pt idx="100">
                  <c:v>0.99999897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086-4159-BC08-37745C7198BB}"/>
            </c:ext>
          </c:extLst>
        </c:ser>
        <c:ser>
          <c:idx val="3"/>
          <c:order val="3"/>
          <c:tx>
            <c:strRef>
              <c:f>Figure1!$AP$1</c:f>
              <c:strCache>
                <c:ptCount val="1"/>
                <c:pt idx="0">
                  <c:v>Do you choke during your meal? 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P$2:$AP$102</c:f>
              <c:numCache>
                <c:formatCode>General</c:formatCode>
                <c:ptCount val="101"/>
                <c:pt idx="0">
                  <c:v>3.5699149999999999E-2</c:v>
                </c:pt>
                <c:pt idx="1">
                  <c:v>3.5699149999999999E-2</c:v>
                </c:pt>
                <c:pt idx="2">
                  <c:v>3.5699149999999999E-2</c:v>
                </c:pt>
                <c:pt idx="3">
                  <c:v>3.5699149999999999E-2</c:v>
                </c:pt>
                <c:pt idx="4">
                  <c:v>3.5699149999999999E-2</c:v>
                </c:pt>
                <c:pt idx="5">
                  <c:v>3.5699149999999999E-2</c:v>
                </c:pt>
                <c:pt idx="6">
                  <c:v>3.5699149999999999E-2</c:v>
                </c:pt>
                <c:pt idx="7">
                  <c:v>3.5699149999999999E-2</c:v>
                </c:pt>
                <c:pt idx="8">
                  <c:v>3.5699149999999999E-2</c:v>
                </c:pt>
                <c:pt idx="9">
                  <c:v>3.5699149999999999E-2</c:v>
                </c:pt>
                <c:pt idx="10">
                  <c:v>3.5699149999999999E-2</c:v>
                </c:pt>
                <c:pt idx="11">
                  <c:v>3.5699149999999999E-2</c:v>
                </c:pt>
                <c:pt idx="12">
                  <c:v>3.5699149999999999E-2</c:v>
                </c:pt>
                <c:pt idx="13">
                  <c:v>3.5699149999999999E-2</c:v>
                </c:pt>
                <c:pt idx="14">
                  <c:v>3.5699149999999999E-2</c:v>
                </c:pt>
                <c:pt idx="15">
                  <c:v>3.5699149999999999E-2</c:v>
                </c:pt>
                <c:pt idx="16">
                  <c:v>3.5699149999999999E-2</c:v>
                </c:pt>
                <c:pt idx="17">
                  <c:v>3.5699149999999999E-2</c:v>
                </c:pt>
                <c:pt idx="18">
                  <c:v>3.5699149999999999E-2</c:v>
                </c:pt>
                <c:pt idx="19">
                  <c:v>3.5699149999999999E-2</c:v>
                </c:pt>
                <c:pt idx="20">
                  <c:v>3.5699149999999999E-2</c:v>
                </c:pt>
                <c:pt idx="21">
                  <c:v>3.5699160000000001E-2</c:v>
                </c:pt>
                <c:pt idx="22">
                  <c:v>3.5699160000000001E-2</c:v>
                </c:pt>
                <c:pt idx="23">
                  <c:v>3.5699160000000001E-2</c:v>
                </c:pt>
                <c:pt idx="24">
                  <c:v>3.5699170000000002E-2</c:v>
                </c:pt>
                <c:pt idx="25">
                  <c:v>3.5699189999999999E-2</c:v>
                </c:pt>
                <c:pt idx="26">
                  <c:v>3.5699210000000002E-2</c:v>
                </c:pt>
                <c:pt idx="27">
                  <c:v>3.569924E-2</c:v>
                </c:pt>
                <c:pt idx="28">
                  <c:v>3.5699300000000003E-2</c:v>
                </c:pt>
                <c:pt idx="29">
                  <c:v>3.5699389999999998E-2</c:v>
                </c:pt>
                <c:pt idx="30">
                  <c:v>3.569953E-2</c:v>
                </c:pt>
                <c:pt idx="31">
                  <c:v>3.5699769999999999E-2</c:v>
                </c:pt>
                <c:pt idx="32">
                  <c:v>3.570015E-2</c:v>
                </c:pt>
                <c:pt idx="33">
                  <c:v>3.5700750000000003E-2</c:v>
                </c:pt>
                <c:pt idx="34">
                  <c:v>3.5701730000000001E-2</c:v>
                </c:pt>
                <c:pt idx="35">
                  <c:v>3.5703310000000002E-2</c:v>
                </c:pt>
                <c:pt idx="36">
                  <c:v>3.5705849999999997E-2</c:v>
                </c:pt>
                <c:pt idx="37">
                  <c:v>3.5709940000000003E-2</c:v>
                </c:pt>
                <c:pt idx="38">
                  <c:v>3.5716530000000003E-2</c:v>
                </c:pt>
                <c:pt idx="39">
                  <c:v>3.5727139999999998E-2</c:v>
                </c:pt>
                <c:pt idx="40">
                  <c:v>3.574422E-2</c:v>
                </c:pt>
                <c:pt idx="41">
                  <c:v>3.5771730000000002E-2</c:v>
                </c:pt>
                <c:pt idx="42">
                  <c:v>3.5816029999999999E-2</c:v>
                </c:pt>
                <c:pt idx="43">
                  <c:v>3.5887370000000002E-2</c:v>
                </c:pt>
                <c:pt idx="44">
                  <c:v>3.6002230000000003E-2</c:v>
                </c:pt>
                <c:pt idx="45">
                  <c:v>3.6187150000000001E-2</c:v>
                </c:pt>
                <c:pt idx="46">
                  <c:v>3.6484820000000001E-2</c:v>
                </c:pt>
                <c:pt idx="47">
                  <c:v>3.6963820000000001E-2</c:v>
                </c:pt>
                <c:pt idx="48">
                  <c:v>3.7734219999999999E-2</c:v>
                </c:pt>
                <c:pt idx="49">
                  <c:v>3.8972350000000003E-2</c:v>
                </c:pt>
                <c:pt idx="50">
                  <c:v>4.0959629999999997E-2</c:v>
                </c:pt>
                <c:pt idx="51">
                  <c:v>4.4142849999999997E-2</c:v>
                </c:pt>
                <c:pt idx="52">
                  <c:v>4.9225140000000001E-2</c:v>
                </c:pt>
                <c:pt idx="53">
                  <c:v>5.729737E-2</c:v>
                </c:pt>
                <c:pt idx="54">
                  <c:v>7.0013179999999994E-2</c:v>
                </c:pt>
                <c:pt idx="55">
                  <c:v>8.9785809999999994E-2</c:v>
                </c:pt>
                <c:pt idx="56">
                  <c:v>0.11992013999999999</c:v>
                </c:pt>
                <c:pt idx="57">
                  <c:v>0.16446857000000001</c:v>
                </c:pt>
                <c:pt idx="58">
                  <c:v>0.22744679000000001</c:v>
                </c:pt>
                <c:pt idx="59">
                  <c:v>0.31107473000000002</c:v>
                </c:pt>
                <c:pt idx="60">
                  <c:v>0.41334662</c:v>
                </c:pt>
                <c:pt idx="61">
                  <c:v>0.52653961000000005</c:v>
                </c:pt>
                <c:pt idx="62">
                  <c:v>0.63878241000000002</c:v>
                </c:pt>
                <c:pt idx="63">
                  <c:v>0.73858754000000004</c:v>
                </c:pt>
                <c:pt idx="64">
                  <c:v>0.81908859999999994</c:v>
                </c:pt>
                <c:pt idx="65">
                  <c:v>0.87906487</c:v>
                </c:pt>
                <c:pt idx="66">
                  <c:v>0.92115873000000004</c:v>
                </c:pt>
                <c:pt idx="67">
                  <c:v>0.94947868999999996</c:v>
                </c:pt>
                <c:pt idx="68">
                  <c:v>0.96799376000000004</c:v>
                </c:pt>
                <c:pt idx="69">
                  <c:v>0.97987287999999995</c:v>
                </c:pt>
                <c:pt idx="70">
                  <c:v>0.98740262999999995</c:v>
                </c:pt>
                <c:pt idx="71">
                  <c:v>0.99213889</c:v>
                </c:pt>
                <c:pt idx="72">
                  <c:v>0.99510361000000003</c:v>
                </c:pt>
                <c:pt idx="73">
                  <c:v>0.99695378000000001</c:v>
                </c:pt>
                <c:pt idx="74">
                  <c:v>0.99810622000000004</c:v>
                </c:pt>
                <c:pt idx="75">
                  <c:v>0.99882320000000002</c:v>
                </c:pt>
                <c:pt idx="76">
                  <c:v>0.99926893999999999</c:v>
                </c:pt>
                <c:pt idx="77">
                  <c:v>0.99954593000000003</c:v>
                </c:pt>
                <c:pt idx="78">
                  <c:v>0.999718</c:v>
                </c:pt>
                <c:pt idx="79">
                  <c:v>0.99982488000000003</c:v>
                </c:pt>
                <c:pt idx="80">
                  <c:v>0.99989125000000001</c:v>
                </c:pt>
                <c:pt idx="81">
                  <c:v>0.99993246999999996</c:v>
                </c:pt>
                <c:pt idx="82">
                  <c:v>0.99995807000000003</c:v>
                </c:pt>
                <c:pt idx="83">
                  <c:v>0.99997396000000005</c:v>
                </c:pt>
                <c:pt idx="84">
                  <c:v>0.99998383000000002</c:v>
                </c:pt>
                <c:pt idx="85">
                  <c:v>0.99998995999999996</c:v>
                </c:pt>
                <c:pt idx="86">
                  <c:v>0.99999377</c:v>
                </c:pt>
                <c:pt idx="87">
                  <c:v>0.99999612999999998</c:v>
                </c:pt>
                <c:pt idx="88">
                  <c:v>0.99999760000000004</c:v>
                </c:pt>
                <c:pt idx="89">
                  <c:v>0.99999850999999995</c:v>
                </c:pt>
                <c:pt idx="90">
                  <c:v>0.99999906999999999</c:v>
                </c:pt>
                <c:pt idx="91">
                  <c:v>0.99999941999999997</c:v>
                </c:pt>
                <c:pt idx="92">
                  <c:v>0.99999963999999997</c:v>
                </c:pt>
                <c:pt idx="93">
                  <c:v>0.99999978</c:v>
                </c:pt>
                <c:pt idx="94">
                  <c:v>0.99999985999999996</c:v>
                </c:pt>
                <c:pt idx="95">
                  <c:v>0.99999990999999999</c:v>
                </c:pt>
                <c:pt idx="96">
                  <c:v>0.99999994999999997</c:v>
                </c:pt>
                <c:pt idx="97">
                  <c:v>0.99999996999999996</c:v>
                </c:pt>
                <c:pt idx="98">
                  <c:v>0.99999998000000001</c:v>
                </c:pt>
                <c:pt idx="99">
                  <c:v>0.99999998999999995</c:v>
                </c:pt>
                <c:pt idx="100">
                  <c:v>0.99999998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086-4159-BC08-37745C7198BB}"/>
            </c:ext>
          </c:extLst>
        </c:ser>
        <c:ser>
          <c:idx val="4"/>
          <c:order val="4"/>
          <c:tx>
            <c:strRef>
              <c:f>Figure1!$AQ$1</c:f>
              <c:strCache>
                <c:ptCount val="1"/>
                <c:pt idx="0">
                  <c:v>Do choke when drinking tea?  </c:v>
                </c:pt>
              </c:strCache>
            </c:strRef>
          </c:tx>
          <c:spPr>
            <a:ln w="19050" cap="rnd">
              <a:solidFill>
                <a:srgbClr val="FFC000"/>
              </a:solidFill>
              <a:prstDash val="lgDash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Q$2:$AQ$102</c:f>
              <c:numCache>
                <c:formatCode>0.00E+00</c:formatCode>
                <c:ptCount val="101"/>
                <c:pt idx="0">
                  <c:v>1.2307190000000001E-5</c:v>
                </c:pt>
                <c:pt idx="1">
                  <c:v>1.349342E-5</c:v>
                </c:pt>
                <c:pt idx="2">
                  <c:v>1.492793E-5</c:v>
                </c:pt>
                <c:pt idx="3">
                  <c:v>1.666271E-5</c:v>
                </c:pt>
                <c:pt idx="4">
                  <c:v>1.8760600000000001E-5</c:v>
                </c:pt>
                <c:pt idx="5">
                  <c:v>2.129759E-5</c:v>
                </c:pt>
                <c:pt idx="6">
                  <c:v>2.436561E-5</c:v>
                </c:pt>
                <c:pt idx="7">
                  <c:v>2.8075779999999998E-5</c:v>
                </c:pt>
                <c:pt idx="8">
                  <c:v>3.256252E-5</c:v>
                </c:pt>
                <c:pt idx="9">
                  <c:v>3.798835E-5</c:v>
                </c:pt>
                <c:pt idx="10">
                  <c:v>4.454982E-5</c:v>
                </c:pt>
                <c:pt idx="11">
                  <c:v>5.2484590000000002E-5</c:v>
                </c:pt>
                <c:pt idx="12">
                  <c:v>6.2080079999999994E-5</c:v>
                </c:pt>
                <c:pt idx="13">
                  <c:v>7.3683799999999994E-5</c:v>
                </c:pt>
                <c:pt idx="14">
                  <c:v>8.771602E-5</c:v>
                </c:pt>
                <c:pt idx="15">
                  <c:v>1.046849E-4</c:v>
                </c:pt>
                <c:pt idx="16">
                  <c:v>1.2520479999999999E-4</c:v>
                </c:pt>
                <c:pt idx="17">
                  <c:v>1.500188E-4</c:v>
                </c:pt>
                <c:pt idx="18">
                  <c:v>1.8002510000000001E-4</c:v>
                </c:pt>
                <c:pt idx="19">
                  <c:v>2.1630989999999999E-4</c:v>
                </c:pt>
                <c:pt idx="20">
                  <c:v>2.6018599999999998E-4</c:v>
                </c:pt>
                <c:pt idx="21">
                  <c:v>3.132411E-4</c:v>
                </c:pt>
                <c:pt idx="22">
                  <c:v>3.7739389999999999E-4</c:v>
                </c:pt>
                <c:pt idx="23">
                  <c:v>4.549639E-4</c:v>
                </c:pt>
                <c:pt idx="24">
                  <c:v>5.4875449999999999E-4</c:v>
                </c:pt>
                <c:pt idx="25">
                  <c:v>6.6215350000000002E-4</c:v>
                </c:pt>
                <c:pt idx="26">
                  <c:v>7.9925440000000003E-4</c:v>
                </c:pt>
                <c:pt idx="27">
                  <c:v>9.6500250000000002E-4</c:v>
                </c:pt>
                <c:pt idx="28">
                  <c:v>1.1653709999999999E-3</c:v>
                </c:pt>
                <c:pt idx="29">
                  <c:v>1.4075719999999999E-3</c:v>
                </c:pt>
                <c:pt idx="30">
                  <c:v>1.7003140000000001E-3</c:v>
                </c:pt>
                <c:pt idx="31">
                  <c:v>2.054101E-3</c:v>
                </c:pt>
                <c:pt idx="32">
                  <c:v>2.4816080000000002E-3</c:v>
                </c:pt>
                <c:pt idx="33">
                  <c:v>2.9981090000000001E-3</c:v>
                </c:pt>
                <c:pt idx="34">
                  <c:v>3.6220079999999999E-3</c:v>
                </c:pt>
                <c:pt idx="35">
                  <c:v>4.3754570000000001E-3</c:v>
                </c:pt>
                <c:pt idx="36">
                  <c:v>5.2850950000000001E-3</c:v>
                </c:pt>
                <c:pt idx="37">
                  <c:v>6.3829170000000001E-3</c:v>
                </c:pt>
                <c:pt idx="38">
                  <c:v>7.7072970000000001E-3</c:v>
                </c:pt>
                <c:pt idx="39">
                  <c:v>9.3041840000000001E-3</c:v>
                </c:pt>
                <c:pt idx="40">
                  <c:v>1.1228470000000001E-2</c:v>
                </c:pt>
                <c:pt idx="41">
                  <c:v>1.354558E-2</c:v>
                </c:pt>
                <c:pt idx="42">
                  <c:v>1.6333230000000001E-2</c:v>
                </c:pt>
                <c:pt idx="43">
                  <c:v>1.9683409999999998E-2</c:v>
                </c:pt>
                <c:pt idx="44">
                  <c:v>2.370448E-2</c:v>
                </c:pt>
                <c:pt idx="45">
                  <c:v>2.8523369999999999E-2</c:v>
                </c:pt>
                <c:pt idx="46">
                  <c:v>3.4287749999999999E-2</c:v>
                </c:pt>
                <c:pt idx="47">
                  <c:v>4.1167990000000002E-2</c:v>
                </c:pt>
                <c:pt idx="48">
                  <c:v>4.9358529999999998E-2</c:v>
                </c:pt>
                <c:pt idx="49">
                  <c:v>5.9078449999999998E-2</c:v>
                </c:pt>
                <c:pt idx="50">
                  <c:v>7.0570640000000004E-2</c:v>
                </c:pt>
                <c:pt idx="51">
                  <c:v>8.4098770000000003E-2</c:v>
                </c:pt>
                <c:pt idx="52">
                  <c:v>9.9941569999999993E-2</c:v>
                </c:pt>
                <c:pt idx="53">
                  <c:v>0.1183834</c:v>
                </c:pt>
                <c:pt idx="54">
                  <c:v>0.1397002</c:v>
                </c:pt>
                <c:pt idx="55">
                  <c:v>0.16414090000000001</c:v>
                </c:pt>
                <c:pt idx="56">
                  <c:v>0.19190409999999999</c:v>
                </c:pt>
                <c:pt idx="57">
                  <c:v>0.2231098</c:v>
                </c:pt>
                <c:pt idx="58">
                  <c:v>0.25777149999999999</c:v>
                </c:pt>
                <c:pt idx="59">
                  <c:v>0.29576809999999998</c:v>
                </c:pt>
                <c:pt idx="60">
                  <c:v>0.33682410000000002</c:v>
                </c:pt>
                <c:pt idx="61">
                  <c:v>0.3805</c:v>
                </c:pt>
                <c:pt idx="62">
                  <c:v>0.42619970000000001</c:v>
                </c:pt>
                <c:pt idx="63">
                  <c:v>0.4731958</c:v>
                </c:pt>
                <c:pt idx="64">
                  <c:v>0.52067169999999996</c:v>
                </c:pt>
                <c:pt idx="65">
                  <c:v>0.56777719999999998</c:v>
                </c:pt>
                <c:pt idx="66">
                  <c:v>0.61368820000000002</c:v>
                </c:pt>
                <c:pt idx="67">
                  <c:v>0.65766290000000005</c:v>
                </c:pt>
                <c:pt idx="68">
                  <c:v>0.6990864</c:v>
                </c:pt>
                <c:pt idx="69">
                  <c:v>0.73749819999999999</c:v>
                </c:pt>
                <c:pt idx="70">
                  <c:v>0.77260169999999995</c:v>
                </c:pt>
                <c:pt idx="71">
                  <c:v>0.80425690000000005</c:v>
                </c:pt>
                <c:pt idx="72">
                  <c:v>0.83246100000000001</c:v>
                </c:pt>
                <c:pt idx="73">
                  <c:v>0.85732220000000003</c:v>
                </c:pt>
                <c:pt idx="74">
                  <c:v>0.87903039999999999</c:v>
                </c:pt>
                <c:pt idx="75">
                  <c:v>0.89782930000000005</c:v>
                </c:pt>
                <c:pt idx="76">
                  <c:v>0.91399269999999999</c:v>
                </c:pt>
                <c:pt idx="77">
                  <c:v>0.92780459999999998</c:v>
                </c:pt>
                <c:pt idx="78">
                  <c:v>0.93954519999999997</c:v>
                </c:pt>
                <c:pt idx="79">
                  <c:v>0.94948049999999995</c:v>
                </c:pt>
                <c:pt idx="80">
                  <c:v>0.95785620000000005</c:v>
                </c:pt>
                <c:pt idx="81">
                  <c:v>0.96489469999999999</c:v>
                </c:pt>
                <c:pt idx="82">
                  <c:v>0.97079340000000003</c:v>
                </c:pt>
                <c:pt idx="83">
                  <c:v>0.97572599999999998</c:v>
                </c:pt>
                <c:pt idx="84">
                  <c:v>0.97984280000000001</c:v>
                </c:pt>
                <c:pt idx="85">
                  <c:v>0.98327339999999996</c:v>
                </c:pt>
                <c:pt idx="86">
                  <c:v>0.98612840000000002</c:v>
                </c:pt>
                <c:pt idx="87">
                  <c:v>0.98850179999999999</c:v>
                </c:pt>
                <c:pt idx="88">
                  <c:v>0.99047300000000005</c:v>
                </c:pt>
                <c:pt idx="89">
                  <c:v>0.99210900000000002</c:v>
                </c:pt>
                <c:pt idx="90">
                  <c:v>0.99346590000000001</c:v>
                </c:pt>
                <c:pt idx="91">
                  <c:v>0.99459070000000005</c:v>
                </c:pt>
                <c:pt idx="92">
                  <c:v>0.99552280000000004</c:v>
                </c:pt>
                <c:pt idx="93">
                  <c:v>0.99629489999999998</c:v>
                </c:pt>
                <c:pt idx="94">
                  <c:v>0.99693419999999999</c:v>
                </c:pt>
                <c:pt idx="95">
                  <c:v>0.99746349999999995</c:v>
                </c:pt>
                <c:pt idx="96">
                  <c:v>0.99790160000000006</c:v>
                </c:pt>
                <c:pt idx="97">
                  <c:v>0.99826420000000005</c:v>
                </c:pt>
                <c:pt idx="98">
                  <c:v>0.99856420000000001</c:v>
                </c:pt>
                <c:pt idx="99">
                  <c:v>0.99881240000000004</c:v>
                </c:pt>
                <c:pt idx="100">
                  <c:v>0.9990177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F086-4159-BC08-37745C7198BB}"/>
            </c:ext>
          </c:extLst>
        </c:ser>
        <c:ser>
          <c:idx val="5"/>
          <c:order val="5"/>
          <c:tx>
            <c:strRef>
              <c:f>Figure1!$AR$1</c:f>
              <c:strCache>
                <c:ptCount val="1"/>
                <c:pt idx="0">
                  <c:v>Do you discomfort feeling during or after your meal?  </c:v>
                </c:pt>
              </c:strCache>
            </c:strRef>
          </c:tx>
          <c:spPr>
            <a:ln w="19050" cap="rnd">
              <a:solidFill>
                <a:srgbClr val="FFC00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R$2:$AR$102</c:f>
              <c:numCache>
                <c:formatCode>General</c:formatCode>
                <c:ptCount val="101"/>
                <c:pt idx="0">
                  <c:v>1.412346E-4</c:v>
                </c:pt>
                <c:pt idx="1">
                  <c:v>1.6075719999999999E-4</c:v>
                </c:pt>
                <c:pt idx="2">
                  <c:v>1.8311290000000001E-4</c:v>
                </c:pt>
                <c:pt idx="3">
                  <c:v>2.087127E-4</c:v>
                </c:pt>
                <c:pt idx="4">
                  <c:v>2.3802719999999999E-4</c:v>
                </c:pt>
                <c:pt idx="5">
                  <c:v>2.715951E-4</c:v>
                </c:pt>
                <c:pt idx="6">
                  <c:v>3.1003319999999999E-4</c:v>
                </c:pt>
                <c:pt idx="7">
                  <c:v>3.5404769999999999E-4</c:v>
                </c:pt>
                <c:pt idx="8">
                  <c:v>4.04447E-4</c:v>
                </c:pt>
                <c:pt idx="9">
                  <c:v>4.621564E-4</c:v>
                </c:pt>
                <c:pt idx="10">
                  <c:v>5.2823520000000001E-4</c:v>
                </c:pt>
                <c:pt idx="11">
                  <c:v>6.038959E-4</c:v>
                </c:pt>
                <c:pt idx="12">
                  <c:v>6.9052600000000001E-4</c:v>
                </c:pt>
                <c:pt idx="13">
                  <c:v>7.8971360000000003E-4</c:v>
                </c:pt>
                <c:pt idx="14">
                  <c:v>9.0327599999999995E-4</c:v>
                </c:pt>
                <c:pt idx="15">
                  <c:v>1.0332923E-3</c:v>
                </c:pt>
                <c:pt idx="16">
                  <c:v>1.1821414E-3</c:v>
                </c:pt>
                <c:pt idx="17">
                  <c:v>1.3525442000000001E-3</c:v>
                </c:pt>
                <c:pt idx="18">
                  <c:v>1.5476126000000001E-3</c:v>
                </c:pt>
                <c:pt idx="19">
                  <c:v>1.7709053E-3</c:v>
                </c:pt>
                <c:pt idx="20">
                  <c:v>2.0264904999999999E-3</c:v>
                </c:pt>
                <c:pt idx="21">
                  <c:v>2.3190177999999999E-3</c:v>
                </c:pt>
                <c:pt idx="22">
                  <c:v>2.6538003000000001E-3</c:v>
                </c:pt>
                <c:pt idx="23">
                  <c:v>3.0369067E-3</c:v>
                </c:pt>
                <c:pt idx="24">
                  <c:v>3.4752669000000002E-3</c:v>
                </c:pt>
                <c:pt idx="25">
                  <c:v>3.9767897999999999E-3</c:v>
                </c:pt>
                <c:pt idx="26">
                  <c:v>4.5504984000000002E-3</c:v>
                </c:pt>
                <c:pt idx="27">
                  <c:v>5.2066800999999996E-3</c:v>
                </c:pt>
                <c:pt idx="28">
                  <c:v>5.9570569000000004E-3</c:v>
                </c:pt>
                <c:pt idx="29">
                  <c:v>6.8149756000000002E-3</c:v>
                </c:pt>
                <c:pt idx="30">
                  <c:v>7.7956198000000004E-3</c:v>
                </c:pt>
                <c:pt idx="31">
                  <c:v>8.9162467999999995E-3</c:v>
                </c:pt>
                <c:pt idx="32">
                  <c:v>1.0196448300000001E-2</c:v>
                </c:pt>
                <c:pt idx="33">
                  <c:v>1.1658438300000001E-2</c:v>
                </c:pt>
                <c:pt idx="34">
                  <c:v>1.33273673E-2</c:v>
                </c:pt>
                <c:pt idx="35">
                  <c:v>1.52316625E-2</c:v>
                </c:pt>
                <c:pt idx="36">
                  <c:v>1.7403392600000001E-2</c:v>
                </c:pt>
                <c:pt idx="37">
                  <c:v>1.9878653600000001E-2</c:v>
                </c:pt>
                <c:pt idx="38">
                  <c:v>2.2697970599999999E-2</c:v>
                </c:pt>
                <c:pt idx="39">
                  <c:v>2.5906706799999998E-2</c:v>
                </c:pt>
                <c:pt idx="40">
                  <c:v>2.9555466999999998E-2</c:v>
                </c:pt>
                <c:pt idx="41">
                  <c:v>3.3700480099999999E-2</c:v>
                </c:pt>
                <c:pt idx="42">
                  <c:v>3.8403937999999999E-2</c:v>
                </c:pt>
                <c:pt idx="43">
                  <c:v>4.3734260300000001E-2</c:v>
                </c:pt>
                <c:pt idx="44">
                  <c:v>4.97662507E-2</c:v>
                </c:pt>
                <c:pt idx="45">
                  <c:v>5.6581095900000003E-2</c:v>
                </c:pt>
                <c:pt idx="46">
                  <c:v>6.4266156099999999E-2</c:v>
                </c:pt>
                <c:pt idx="47">
                  <c:v>7.2914478699999993E-2</c:v>
                </c:pt>
                <c:pt idx="48">
                  <c:v>8.2623966500000007E-2</c:v>
                </c:pt>
                <c:pt idx="49">
                  <c:v>9.3496120000000002E-2</c:v>
                </c:pt>
                <c:pt idx="50">
                  <c:v>0.105634276</c:v>
                </c:pt>
                <c:pt idx="51">
                  <c:v>0.1191412698</c:v>
                </c:pt>
                <c:pt idx="52">
                  <c:v>0.13411646250000001</c:v>
                </c:pt>
                <c:pt idx="53">
                  <c:v>0.1506521082</c:v>
                </c:pt>
                <c:pt idx="54">
                  <c:v>0.16882907450000001</c:v>
                </c:pt>
                <c:pt idx="55">
                  <c:v>0.1887119974</c:v>
                </c:pt>
                <c:pt idx="56">
                  <c:v>0.2103440235</c:v>
                </c:pt>
                <c:pt idx="57">
                  <c:v>0.23374138589999999</c:v>
                </c:pt>
                <c:pt idx="58">
                  <c:v>0.25888815050000002</c:v>
                </c:pt>
                <c:pt idx="59">
                  <c:v>0.28573155509999998</c:v>
                </c:pt>
                <c:pt idx="60">
                  <c:v>0.31417841759999998</c:v>
                </c:pt>
                <c:pt idx="61">
                  <c:v>0.34409310650000002</c:v>
                </c:pt>
                <c:pt idx="62">
                  <c:v>0.37529751550000001</c:v>
                </c:pt>
                <c:pt idx="63">
                  <c:v>0.40757336830000002</c:v>
                </c:pt>
                <c:pt idx="64">
                  <c:v>0.4406669922</c:v>
                </c:pt>
                <c:pt idx="65">
                  <c:v>0.47429646339999998</c:v>
                </c:pt>
                <c:pt idx="66">
                  <c:v>0.50816076669999999</c:v>
                </c:pt>
                <c:pt idx="67">
                  <c:v>0.54195037540000002</c:v>
                </c:pt>
                <c:pt idx="68">
                  <c:v>0.5753584799</c:v>
                </c:pt>
                <c:pt idx="69">
                  <c:v>0.60809200750000003</c:v>
                </c:pt>
                <c:pt idx="70">
                  <c:v>0.63988160620000001</c:v>
                </c:pt>
                <c:pt idx="71">
                  <c:v>0.67048989479999999</c:v>
                </c:pt>
                <c:pt idx="72">
                  <c:v>0.69971749510000003</c:v>
                </c:pt>
                <c:pt idx="73">
                  <c:v>0.7274066132</c:v>
                </c:pt>
                <c:pt idx="74">
                  <c:v>0.75344219209999996</c:v>
                </c:pt>
                <c:pt idx="75">
                  <c:v>0.77775087200000004</c:v>
                </c:pt>
                <c:pt idx="76">
                  <c:v>0.80029814860000004</c:v>
                </c:pt>
                <c:pt idx="77">
                  <c:v>0.82108420469999999</c:v>
                </c:pt>
                <c:pt idx="78">
                  <c:v>0.84013890700000005</c:v>
                </c:pt>
                <c:pt idx="79">
                  <c:v>0.85751642240000003</c:v>
                </c:pt>
                <c:pt idx="80">
                  <c:v>0.87328983770000002</c:v>
                </c:pt>
                <c:pt idx="81">
                  <c:v>0.88754607539999997</c:v>
                </c:pt>
                <c:pt idx="82">
                  <c:v>0.90038130689999996</c:v>
                </c:pt>
                <c:pt idx="83">
                  <c:v>0.91189697869999997</c:v>
                </c:pt>
                <c:pt idx="84">
                  <c:v>0.92219649829999994</c:v>
                </c:pt>
                <c:pt idx="85">
                  <c:v>0.93138257310000006</c:v>
                </c:pt>
                <c:pt idx="86">
                  <c:v>0.93955515850000004</c:v>
                </c:pt>
                <c:pt idx="87">
                  <c:v>0.94680994829999998</c:v>
                </c:pt>
                <c:pt idx="88">
                  <c:v>0.95323733239999997</c:v>
                </c:pt>
                <c:pt idx="89">
                  <c:v>0.95892174070000002</c:v>
                </c:pt>
                <c:pt idx="90">
                  <c:v>0.96394129839999998</c:v>
                </c:pt>
                <c:pt idx="91">
                  <c:v>0.96836772469999999</c:v>
                </c:pt>
                <c:pt idx="92">
                  <c:v>0.97226641359999999</c:v>
                </c:pt>
                <c:pt idx="93">
                  <c:v>0.97569664730000005</c:v>
                </c:pt>
                <c:pt idx="94">
                  <c:v>0.97871190159999999</c:v>
                </c:pt>
                <c:pt idx="95">
                  <c:v>0.9813602078</c:v>
                </c:pt>
                <c:pt idx="96">
                  <c:v>0.98368454859999999</c:v>
                </c:pt>
                <c:pt idx="97">
                  <c:v>0.98572326590000003</c:v>
                </c:pt>
                <c:pt idx="98">
                  <c:v>0.98751046730000003</c:v>
                </c:pt>
                <c:pt idx="99">
                  <c:v>0.98907642110000005</c:v>
                </c:pt>
                <c:pt idx="100">
                  <c:v>0.9904479327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F086-4159-BC08-37745C7198BB}"/>
            </c:ext>
          </c:extLst>
        </c:ser>
        <c:ser>
          <c:idx val="6"/>
          <c:order val="6"/>
          <c:tx>
            <c:strRef>
              <c:f>Figure1!$AS$1</c:f>
              <c:strCache>
                <c:ptCount val="1"/>
                <c:pt idx="0">
                  <c:v>Do you feel like food remains in your throat?  </c:v>
                </c:pt>
              </c:strCache>
            </c:strRef>
          </c:tx>
          <c:spPr>
            <a:ln w="19050" cap="rnd">
              <a:solidFill>
                <a:srgbClr val="92D050"/>
              </a:solidFill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S$2:$AS$102</c:f>
              <c:numCache>
                <c:formatCode>0.00E+00</c:formatCode>
                <c:ptCount val="101"/>
                <c:pt idx="0">
                  <c:v>8.8097529999999997E-6</c:v>
                </c:pt>
                <c:pt idx="1">
                  <c:v>8.8109079999999992E-6</c:v>
                </c:pt>
                <c:pt idx="2">
                  <c:v>8.8124739999999996E-6</c:v>
                </c:pt>
                <c:pt idx="3">
                  <c:v>8.8146000000000003E-6</c:v>
                </c:pt>
                <c:pt idx="4">
                  <c:v>8.8174850000000005E-6</c:v>
                </c:pt>
                <c:pt idx="5">
                  <c:v>8.8214009999999993E-6</c:v>
                </c:pt>
                <c:pt idx="6">
                  <c:v>8.8267150000000008E-6</c:v>
                </c:pt>
                <c:pt idx="7">
                  <c:v>8.8339270000000008E-6</c:v>
                </c:pt>
                <c:pt idx="8">
                  <c:v>8.8437139999999997E-6</c:v>
                </c:pt>
                <c:pt idx="9">
                  <c:v>8.8569960000000008E-6</c:v>
                </c:pt>
                <c:pt idx="10">
                  <c:v>8.8750220000000008E-6</c:v>
                </c:pt>
                <c:pt idx="11">
                  <c:v>8.8994850000000007E-6</c:v>
                </c:pt>
                <c:pt idx="12">
                  <c:v>8.9326850000000007E-6</c:v>
                </c:pt>
                <c:pt idx="13">
                  <c:v>8.9777409999999993E-6</c:v>
                </c:pt>
                <c:pt idx="14">
                  <c:v>9.0388870000000003E-6</c:v>
                </c:pt>
                <c:pt idx="15">
                  <c:v>9.1218699999999995E-6</c:v>
                </c:pt>
                <c:pt idx="16">
                  <c:v>9.2344889999999993E-6</c:v>
                </c:pt>
                <c:pt idx="17">
                  <c:v>9.3873250000000008E-6</c:v>
                </c:pt>
                <c:pt idx="18">
                  <c:v>9.5947430000000008E-6</c:v>
                </c:pt>
                <c:pt idx="19">
                  <c:v>9.8762340000000001E-6</c:v>
                </c:pt>
                <c:pt idx="20">
                  <c:v>1.025825E-5</c:v>
                </c:pt>
                <c:pt idx="21">
                  <c:v>1.07767E-5</c:v>
                </c:pt>
                <c:pt idx="22">
                  <c:v>1.148029E-5</c:v>
                </c:pt>
                <c:pt idx="23">
                  <c:v>1.243514E-5</c:v>
                </c:pt>
                <c:pt idx="24">
                  <c:v>1.3730999999999999E-5</c:v>
                </c:pt>
                <c:pt idx="25">
                  <c:v>1.548962E-5</c:v>
                </c:pt>
                <c:pt idx="26">
                  <c:v>1.7876279999999999E-5</c:v>
                </c:pt>
                <c:pt idx="27">
                  <c:v>2.1115260000000002E-5</c:v>
                </c:pt>
                <c:pt idx="28">
                  <c:v>2.55109E-5</c:v>
                </c:pt>
                <c:pt idx="29">
                  <c:v>3.147627E-5</c:v>
                </c:pt>
                <c:pt idx="30">
                  <c:v>3.9571879999999998E-5</c:v>
                </c:pt>
                <c:pt idx="31">
                  <c:v>5.0558410000000001E-5</c:v>
                </c:pt>
                <c:pt idx="32">
                  <c:v>6.5468079999999996E-5</c:v>
                </c:pt>
                <c:pt idx="33">
                  <c:v>8.5701620000000001E-5</c:v>
                </c:pt>
                <c:pt idx="34">
                  <c:v>1.131597E-4</c:v>
                </c:pt>
                <c:pt idx="35">
                  <c:v>1.5042119999999999E-4</c:v>
                </c:pt>
                <c:pt idx="36">
                  <c:v>2.009852E-4</c:v>
                </c:pt>
                <c:pt idx="37">
                  <c:v>2.6959850000000002E-4</c:v>
                </c:pt>
                <c:pt idx="38">
                  <c:v>3.6270010000000001E-4</c:v>
                </c:pt>
                <c:pt idx="39">
                  <c:v>4.8902259999999997E-4</c:v>
                </c:pt>
                <c:pt idx="40">
                  <c:v>6.6040650000000005E-4</c:v>
                </c:pt>
                <c:pt idx="41">
                  <c:v>8.9290150000000004E-4</c:v>
                </c:pt>
                <c:pt idx="42">
                  <c:v>1.2082519999999999E-3</c:v>
                </c:pt>
                <c:pt idx="43">
                  <c:v>1.6359040000000001E-3</c:v>
                </c:pt>
                <c:pt idx="44">
                  <c:v>2.2156939999999998E-3</c:v>
                </c:pt>
                <c:pt idx="45">
                  <c:v>3.0014629999999998E-3</c:v>
                </c:pt>
                <c:pt idx="46">
                  <c:v>4.0658710000000004E-3</c:v>
                </c:pt>
                <c:pt idx="47">
                  <c:v>5.5067709999999997E-3</c:v>
                </c:pt>
                <c:pt idx="48">
                  <c:v>7.4555940000000003E-3</c:v>
                </c:pt>
                <c:pt idx="49">
                  <c:v>1.00882E-2</c:v>
                </c:pt>
                <c:pt idx="50">
                  <c:v>1.363871E-2</c:v>
                </c:pt>
                <c:pt idx="51">
                  <c:v>1.841665E-2</c:v>
                </c:pt>
                <c:pt idx="52">
                  <c:v>2.4827330000000002E-2</c:v>
                </c:pt>
                <c:pt idx="53">
                  <c:v>3.3394670000000001E-2</c:v>
                </c:pt>
                <c:pt idx="54">
                  <c:v>4.478364E-2</c:v>
                </c:pt>
                <c:pt idx="55">
                  <c:v>5.9817370000000002E-2</c:v>
                </c:pt>
                <c:pt idx="56">
                  <c:v>7.9478900000000005E-2</c:v>
                </c:pt>
                <c:pt idx="57">
                  <c:v>0.104883</c:v>
                </c:pt>
                <c:pt idx="58">
                  <c:v>0.13719770000000001</c:v>
                </c:pt>
                <c:pt idx="59">
                  <c:v>0.17749519999999999</c:v>
                </c:pt>
                <c:pt idx="60">
                  <c:v>0.226522</c:v>
                </c:pt>
                <c:pt idx="61">
                  <c:v>0.28440870000000001</c:v>
                </c:pt>
                <c:pt idx="62">
                  <c:v>0.35038750000000002</c:v>
                </c:pt>
                <c:pt idx="63">
                  <c:v>0.42263279999999998</c:v>
                </c:pt>
                <c:pt idx="64">
                  <c:v>0.49834709999999999</c:v>
                </c:pt>
                <c:pt idx="65">
                  <c:v>0.57413749999999997</c:v>
                </c:pt>
                <c:pt idx="66">
                  <c:v>0.64659759999999999</c:v>
                </c:pt>
                <c:pt idx="67">
                  <c:v>0.71289409999999998</c:v>
                </c:pt>
                <c:pt idx="68">
                  <c:v>0.77115549999999999</c:v>
                </c:pt>
                <c:pt idx="69">
                  <c:v>0.82056980000000002</c:v>
                </c:pt>
                <c:pt idx="70">
                  <c:v>0.86123419999999995</c:v>
                </c:pt>
                <c:pt idx="71">
                  <c:v>0.89387459999999996</c:v>
                </c:pt>
                <c:pt idx="72">
                  <c:v>0.9195546</c:v>
                </c:pt>
                <c:pt idx="73">
                  <c:v>0.93944150000000004</c:v>
                </c:pt>
                <c:pt idx="74">
                  <c:v>0.95465469999999997</c:v>
                </c:pt>
                <c:pt idx="75">
                  <c:v>0.96618360000000003</c:v>
                </c:pt>
                <c:pt idx="76">
                  <c:v>0.97485860000000002</c:v>
                </c:pt>
                <c:pt idx="77">
                  <c:v>0.98135110000000003</c:v>
                </c:pt>
                <c:pt idx="78">
                  <c:v>0.98619069999999998</c:v>
                </c:pt>
                <c:pt idx="79">
                  <c:v>0.98978750000000004</c:v>
                </c:pt>
                <c:pt idx="80">
                  <c:v>0.99245459999999996</c:v>
                </c:pt>
                <c:pt idx="81">
                  <c:v>0.99442909999999995</c:v>
                </c:pt>
                <c:pt idx="82">
                  <c:v>0.99588900000000002</c:v>
                </c:pt>
                <c:pt idx="83">
                  <c:v>0.99696750000000001</c:v>
                </c:pt>
                <c:pt idx="84">
                  <c:v>0.99776370000000003</c:v>
                </c:pt>
                <c:pt idx="85">
                  <c:v>0.99835119999999999</c:v>
                </c:pt>
                <c:pt idx="86">
                  <c:v>0.99878460000000002</c:v>
                </c:pt>
                <c:pt idx="87">
                  <c:v>0.99910410000000005</c:v>
                </c:pt>
                <c:pt idx="88">
                  <c:v>0.99933970000000005</c:v>
                </c:pt>
                <c:pt idx="89">
                  <c:v>0.9995134</c:v>
                </c:pt>
                <c:pt idx="90">
                  <c:v>0.99964140000000001</c:v>
                </c:pt>
                <c:pt idx="91">
                  <c:v>0.9997357</c:v>
                </c:pt>
                <c:pt idx="92">
                  <c:v>0.99980530000000001</c:v>
                </c:pt>
                <c:pt idx="93">
                  <c:v>0.99985650000000004</c:v>
                </c:pt>
                <c:pt idx="94">
                  <c:v>0.99989430000000001</c:v>
                </c:pt>
                <c:pt idx="95">
                  <c:v>0.99992210000000004</c:v>
                </c:pt>
                <c:pt idx="96">
                  <c:v>0.99994260000000001</c:v>
                </c:pt>
                <c:pt idx="97">
                  <c:v>0.99995769999999995</c:v>
                </c:pt>
                <c:pt idx="98">
                  <c:v>0.99996879999999999</c:v>
                </c:pt>
                <c:pt idx="99">
                  <c:v>0.999977</c:v>
                </c:pt>
                <c:pt idx="100">
                  <c:v>0.9999831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F086-4159-BC08-37745C7198BB}"/>
            </c:ext>
          </c:extLst>
        </c:ser>
        <c:ser>
          <c:idx val="7"/>
          <c:order val="7"/>
          <c:tx>
            <c:strRef>
              <c:f>Figure1!$AT$1</c:f>
              <c:strCache>
                <c:ptCount val="1"/>
                <c:pt idx="0">
                  <c:v>Have you been growing late for eating?  </c:v>
                </c:pt>
              </c:strCache>
            </c:strRef>
          </c:tx>
          <c:spPr>
            <a:ln w="19050" cap="rnd">
              <a:solidFill>
                <a:srgbClr val="92D050"/>
              </a:solidFill>
              <a:prstDash val="lgDash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T$2:$AT$102</c:f>
              <c:numCache>
                <c:formatCode>General</c:formatCode>
                <c:ptCount val="101"/>
                <c:pt idx="0">
                  <c:v>4.7774489999999996E-3</c:v>
                </c:pt>
                <c:pt idx="1">
                  <c:v>5.253148E-3</c:v>
                </c:pt>
                <c:pt idx="2">
                  <c:v>5.7759400000000002E-3</c:v>
                </c:pt>
                <c:pt idx="3">
                  <c:v>6.350428E-3</c:v>
                </c:pt>
                <c:pt idx="4">
                  <c:v>6.9816549999999998E-3</c:v>
                </c:pt>
                <c:pt idx="5">
                  <c:v>7.6751420000000002E-3</c:v>
                </c:pt>
                <c:pt idx="6">
                  <c:v>8.4369289999999993E-3</c:v>
                </c:pt>
                <c:pt idx="7">
                  <c:v>9.2736199999999998E-3</c:v>
                </c:pt>
                <c:pt idx="8">
                  <c:v>1.0192434E-2</c:v>
                </c:pt>
                <c:pt idx="9">
                  <c:v>1.1201253E-2</c:v>
                </c:pt>
                <c:pt idx="10">
                  <c:v>1.2308682E-2</c:v>
                </c:pt>
                <c:pt idx="11">
                  <c:v>1.3524101E-2</c:v>
                </c:pt>
                <c:pt idx="12">
                  <c:v>1.4857732E-2</c:v>
                </c:pt>
                <c:pt idx="13">
                  <c:v>1.63207E-2</c:v>
                </c:pt>
                <c:pt idx="14">
                  <c:v>1.7925098E-2</c:v>
                </c:pt>
                <c:pt idx="15">
                  <c:v>1.968406E-2</c:v>
                </c:pt>
                <c:pt idx="16">
                  <c:v>2.1611829999999999E-2</c:v>
                </c:pt>
                <c:pt idx="17">
                  <c:v>2.3723827999999999E-2</c:v>
                </c:pt>
                <c:pt idx="18">
                  <c:v>2.6036726999999999E-2</c:v>
                </c:pt>
                <c:pt idx="19">
                  <c:v>2.856852E-2</c:v>
                </c:pt>
                <c:pt idx="20">
                  <c:v>3.1338580999999997E-2</c:v>
                </c:pt>
                <c:pt idx="21">
                  <c:v>3.4367730999999999E-2</c:v>
                </c:pt>
                <c:pt idx="22">
                  <c:v>3.7678287999999997E-2</c:v>
                </c:pt>
                <c:pt idx="23">
                  <c:v>4.1294104999999998E-2</c:v>
                </c:pt>
                <c:pt idx="24">
                  <c:v>4.5240603999999997E-2</c:v>
                </c:pt>
                <c:pt idx="25">
                  <c:v>4.9544781000000003E-2</c:v>
                </c:pt>
                <c:pt idx="26">
                  <c:v>5.4235195E-2</c:v>
                </c:pt>
                <c:pt idx="27">
                  <c:v>5.9341929000000002E-2</c:v>
                </c:pt>
                <c:pt idx="28">
                  <c:v>6.4896513000000003E-2</c:v>
                </c:pt>
                <c:pt idx="29">
                  <c:v>7.0931817999999994E-2</c:v>
                </c:pt>
                <c:pt idx="30">
                  <c:v>7.7481893999999996E-2</c:v>
                </c:pt>
                <c:pt idx="31">
                  <c:v>8.4581760000000006E-2</c:v>
                </c:pt>
                <c:pt idx="32">
                  <c:v>9.2267136999999999E-2</c:v>
                </c:pt>
                <c:pt idx="33">
                  <c:v>0.10057411099999999</c:v>
                </c:pt>
                <c:pt idx="34">
                  <c:v>0.109538727</c:v>
                </c:pt>
                <c:pt idx="35">
                  <c:v>0.11919650499999999</c:v>
                </c:pt>
                <c:pt idx="36">
                  <c:v>0.12958187400000001</c:v>
                </c:pt>
                <c:pt idx="37">
                  <c:v>0.14072753199999999</c:v>
                </c:pt>
                <c:pt idx="38">
                  <c:v>0.15266371300000001</c:v>
                </c:pt>
                <c:pt idx="39">
                  <c:v>0.16541739899999999</c:v>
                </c:pt>
                <c:pt idx="40">
                  <c:v>0.17901144999999999</c:v>
                </c:pt>
                <c:pt idx="41">
                  <c:v>0.19346369499999999</c:v>
                </c:pt>
                <c:pt idx="42">
                  <c:v>0.208785999</c:v>
                </c:pt>
                <c:pt idx="43">
                  <c:v>0.22498331399999999</c:v>
                </c:pt>
                <c:pt idx="44">
                  <c:v>0.242052779</c:v>
                </c:pt>
                <c:pt idx="45">
                  <c:v>0.259982871</c:v>
                </c:pt>
                <c:pt idx="46">
                  <c:v>0.27875266900000001</c:v>
                </c:pt>
                <c:pt idx="47">
                  <c:v>0.29833127700000001</c:v>
                </c:pt>
                <c:pt idx="48">
                  <c:v>0.31867742700000001</c:v>
                </c:pt>
                <c:pt idx="49">
                  <c:v>0.33973932099999998</c:v>
                </c:pt>
                <c:pt idx="50">
                  <c:v>0.361454738</c:v>
                </c:pt>
                <c:pt idx="51">
                  <c:v>0.38375143499999997</c:v>
                </c:pt>
                <c:pt idx="52">
                  <c:v>0.40654784399999999</c:v>
                </c:pt>
                <c:pt idx="53">
                  <c:v>0.42975407199999999</c:v>
                </c:pt>
                <c:pt idx="54">
                  <c:v>0.45327319199999999</c:v>
                </c:pt>
                <c:pt idx="55">
                  <c:v>0.47700277600000002</c:v>
                </c:pt>
                <c:pt idx="56">
                  <c:v>0.50083663300000003</c:v>
                </c:pt>
                <c:pt idx="57">
                  <c:v>0.52466668800000005</c:v>
                </c:pt>
                <c:pt idx="58">
                  <c:v>0.54838493799999999</c:v>
                </c:pt>
                <c:pt idx="59">
                  <c:v>0.57188539299999996</c:v>
                </c:pt>
                <c:pt idx="60">
                  <c:v>0.59506595799999995</c:v>
                </c:pt>
                <c:pt idx="61">
                  <c:v>0.61783015100000005</c:v>
                </c:pt>
                <c:pt idx="62">
                  <c:v>0.64008862600000005</c:v>
                </c:pt>
                <c:pt idx="63">
                  <c:v>0.66176043900000003</c:v>
                </c:pt>
                <c:pt idx="64">
                  <c:v>0.68277402899999995</c:v>
                </c:pt>
                <c:pt idx="65">
                  <c:v>0.703067899</c:v>
                </c:pt>
                <c:pt idx="66">
                  <c:v>0.72259099000000004</c:v>
                </c:pt>
                <c:pt idx="67">
                  <c:v>0.74130276799999995</c:v>
                </c:pt>
                <c:pt idx="68">
                  <c:v>0.75917305199999996</c:v>
                </c:pt>
                <c:pt idx="69">
                  <c:v>0.77618160199999997</c:v>
                </c:pt>
                <c:pt idx="70">
                  <c:v>0.79231752899999996</c:v>
                </c:pt>
                <c:pt idx="71">
                  <c:v>0.80757854699999998</c:v>
                </c:pt>
                <c:pt idx="72">
                  <c:v>0.82197012400000002</c:v>
                </c:pt>
                <c:pt idx="73">
                  <c:v>0.835504574</c:v>
                </c:pt>
                <c:pt idx="74">
                  <c:v>0.84820010999999995</c:v>
                </c:pt>
                <c:pt idx="75">
                  <c:v>0.86007990999999995</c:v>
                </c:pt>
                <c:pt idx="76">
                  <c:v>0.87117121099999995</c:v>
                </c:pt>
                <c:pt idx="77">
                  <c:v>0.881504446</c:v>
                </c:pt>
                <c:pt idx="78">
                  <c:v>0.891112456</c:v>
                </c:pt>
                <c:pt idx="79">
                  <c:v>0.90002976800000001</c:v>
                </c:pt>
                <c:pt idx="80">
                  <c:v>0.90829195600000001</c:v>
                </c:pt>
                <c:pt idx="81">
                  <c:v>0.91593508099999998</c:v>
                </c:pt>
                <c:pt idx="82">
                  <c:v>0.92299521799999995</c:v>
                </c:pt>
                <c:pt idx="83">
                  <c:v>0.92950804799999998</c:v>
                </c:pt>
                <c:pt idx="84">
                  <c:v>0.93550853099999998</c:v>
                </c:pt>
                <c:pt idx="85">
                  <c:v>0.94103063899999995</c:v>
                </c:pt>
                <c:pt idx="86">
                  <c:v>0.94610715400000001</c:v>
                </c:pt>
                <c:pt idx="87">
                  <c:v>0.95076950800000004</c:v>
                </c:pt>
                <c:pt idx="88">
                  <c:v>0.95504767800000001</c:v>
                </c:pt>
                <c:pt idx="89">
                  <c:v>0.95897011600000004</c:v>
                </c:pt>
                <c:pt idx="90">
                  <c:v>0.96256370700000005</c:v>
                </c:pt>
                <c:pt idx="91">
                  <c:v>0.96585376199999995</c:v>
                </c:pt>
                <c:pt idx="92">
                  <c:v>0.96886402599999999</c:v>
                </c:pt>
                <c:pt idx="93">
                  <c:v>0.97161671000000005</c:v>
                </c:pt>
                <c:pt idx="94">
                  <c:v>0.97413253</c:v>
                </c:pt>
                <c:pt idx="95">
                  <c:v>0.97643076500000003</c:v>
                </c:pt>
                <c:pt idx="96">
                  <c:v>0.97852930900000001</c:v>
                </c:pt>
                <c:pt idx="97">
                  <c:v>0.98044474699999995</c:v>
                </c:pt>
                <c:pt idx="98">
                  <c:v>0.98219241499999999</c:v>
                </c:pt>
                <c:pt idx="99">
                  <c:v>0.98378647500000005</c:v>
                </c:pt>
                <c:pt idx="100">
                  <c:v>0.985239985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F086-4159-BC08-37745C7198BB}"/>
            </c:ext>
          </c:extLst>
        </c:ser>
        <c:ser>
          <c:idx val="8"/>
          <c:order val="8"/>
          <c:tx>
            <c:strRef>
              <c:f>Figure1!$AU$1</c:f>
              <c:strCache>
                <c:ptCount val="1"/>
                <c:pt idx="0">
                  <c:v>Have you been feeling hard to eat hard food?  </c:v>
                </c:pt>
              </c:strCache>
            </c:strRef>
          </c:tx>
          <c:spPr>
            <a:ln w="19050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U$2:$AU$102</c:f>
              <c:numCache>
                <c:formatCode>General</c:formatCode>
                <c:ptCount val="101"/>
                <c:pt idx="0">
                  <c:v>9.4320609999999996E-4</c:v>
                </c:pt>
                <c:pt idx="1">
                  <c:v>1.0417511000000001E-3</c:v>
                </c:pt>
                <c:pt idx="2">
                  <c:v>1.1548258E-3</c:v>
                </c:pt>
                <c:pt idx="3">
                  <c:v>1.2845682999999999E-3</c:v>
                </c:pt>
                <c:pt idx="4">
                  <c:v>1.4334303E-3</c:v>
                </c:pt>
                <c:pt idx="5">
                  <c:v>1.6042223000000001E-3</c:v>
                </c:pt>
                <c:pt idx="6">
                  <c:v>1.8001657000000001E-3</c:v>
                </c:pt>
                <c:pt idx="7">
                  <c:v>2.0249522000000001E-3</c:v>
                </c:pt>
                <c:pt idx="8">
                  <c:v>2.2828115000000002E-3</c:v>
                </c:pt>
                <c:pt idx="9">
                  <c:v>2.5785884999999999E-3</c:v>
                </c:pt>
                <c:pt idx="10">
                  <c:v>2.9178312000000001E-3</c:v>
                </c:pt>
                <c:pt idx="11">
                  <c:v>3.3068907000000001E-3</c:v>
                </c:pt>
                <c:pt idx="12">
                  <c:v>3.7530342999999998E-3</c:v>
                </c:pt>
                <c:pt idx="13">
                  <c:v>4.2645746000000003E-3</c:v>
                </c:pt>
                <c:pt idx="14">
                  <c:v>4.8510146000000001E-3</c:v>
                </c:pt>
                <c:pt idx="15">
                  <c:v>5.5232121E-3</c:v>
                </c:pt>
                <c:pt idx="16">
                  <c:v>6.2935646E-3</c:v>
                </c:pt>
                <c:pt idx="17">
                  <c:v>7.1762170000000004E-3</c:v>
                </c:pt>
                <c:pt idx="18">
                  <c:v>8.1872931999999992E-3</c:v>
                </c:pt>
                <c:pt idx="19">
                  <c:v>9.3451550000000008E-3</c:v>
                </c:pt>
                <c:pt idx="20">
                  <c:v>1.0670688100000001E-2</c:v>
                </c:pt>
                <c:pt idx="21">
                  <c:v>1.21876173E-2</c:v>
                </c:pt>
                <c:pt idx="22">
                  <c:v>1.3922851E-2</c:v>
                </c:pt>
                <c:pt idx="23">
                  <c:v>1.5906854099999999E-2</c:v>
                </c:pt>
                <c:pt idx="24">
                  <c:v>1.8174047700000001E-2</c:v>
                </c:pt>
                <c:pt idx="25">
                  <c:v>2.0763230800000001E-2</c:v>
                </c:pt>
                <c:pt idx="26">
                  <c:v>2.3718017599999999E-2</c:v>
                </c:pt>
                <c:pt idx="27">
                  <c:v>2.7087281000000001E-2</c:v>
                </c:pt>
                <c:pt idx="28">
                  <c:v>3.0925585799999999E-2</c:v>
                </c:pt>
                <c:pt idx="29">
                  <c:v>3.5293593300000002E-2</c:v>
                </c:pt>
                <c:pt idx="30">
                  <c:v>4.02584099E-2</c:v>
                </c:pt>
                <c:pt idx="31">
                  <c:v>4.5893844099999997E-2</c:v>
                </c:pt>
                <c:pt idx="32">
                  <c:v>5.2280529200000002E-2</c:v>
                </c:pt>
                <c:pt idx="33">
                  <c:v>5.9505856900000001E-2</c:v>
                </c:pt>
                <c:pt idx="34">
                  <c:v>6.76636558E-2</c:v>
                </c:pt>
                <c:pt idx="35">
                  <c:v>7.6853542299999994E-2</c:v>
                </c:pt>
                <c:pt idx="36">
                  <c:v>8.7179857799999996E-2</c:v>
                </c:pt>
                <c:pt idx="37">
                  <c:v>9.8750105199999993E-2</c:v>
                </c:pt>
                <c:pt idx="38">
                  <c:v>0.1116727984</c:v>
                </c:pt>
                <c:pt idx="39">
                  <c:v>0.12605464729999999</c:v>
                </c:pt>
                <c:pt idx="40">
                  <c:v>0.1419970287</c:v>
                </c:pt>
                <c:pt idx="41">
                  <c:v>0.15959172899999999</c:v>
                </c:pt>
                <c:pt idx="42">
                  <c:v>0.17891600830000001</c:v>
                </c:pt>
                <c:pt idx="43">
                  <c:v>0.20002711000000001</c:v>
                </c:pt>
                <c:pt idx="44">
                  <c:v>0.2229564376</c:v>
                </c:pt>
                <c:pt idx="45">
                  <c:v>0.24770372490000001</c:v>
                </c:pt>
                <c:pt idx="46">
                  <c:v>0.2742316273</c:v>
                </c:pt>
                <c:pt idx="47">
                  <c:v>0.30246124410000003</c:v>
                </c:pt>
                <c:pt idx="48">
                  <c:v>0.33226912089999999</c:v>
                </c:pt>
                <c:pt idx="49">
                  <c:v>0.36348626169999998</c:v>
                </c:pt>
                <c:pt idx="50">
                  <c:v>0.39589957609999998</c:v>
                </c:pt>
                <c:pt idx="51">
                  <c:v>0.42925601229999999</c:v>
                </c:pt>
                <c:pt idx="52">
                  <c:v>0.46326937140000002</c:v>
                </c:pt>
                <c:pt idx="53">
                  <c:v>0.49762951230000002</c:v>
                </c:pt>
                <c:pt idx="54">
                  <c:v>0.53201337299999996</c:v>
                </c:pt>
                <c:pt idx="55">
                  <c:v>0.56609700070000002</c:v>
                </c:pt>
                <c:pt idx="56">
                  <c:v>0.59956765199999995</c:v>
                </c:pt>
                <c:pt idx="57">
                  <c:v>0.63213501549999995</c:v>
                </c:pt>
                <c:pt idx="58">
                  <c:v>0.66354072389999996</c:v>
                </c:pt>
                <c:pt idx="59">
                  <c:v>0.69356554169999995</c:v>
                </c:pt>
                <c:pt idx="60">
                  <c:v>0.72203389559999998</c:v>
                </c:pt>
                <c:pt idx="61">
                  <c:v>0.74881570289999999</c:v>
                </c:pt>
                <c:pt idx="62">
                  <c:v>0.77382571529999999</c:v>
                </c:pt>
                <c:pt idx="63">
                  <c:v>0.79702078239999996</c:v>
                </c:pt>
                <c:pt idx="64">
                  <c:v>0.81839555580000001</c:v>
                </c:pt>
                <c:pt idx="65">
                  <c:v>0.83797718249999997</c:v>
                </c:pt>
                <c:pt idx="66">
                  <c:v>0.8558195072</c:v>
                </c:pt>
                <c:pt idx="67">
                  <c:v>0.87199722589999995</c:v>
                </c:pt>
                <c:pt idx="68">
                  <c:v>0.88660033069999999</c:v>
                </c:pt>
                <c:pt idx="69">
                  <c:v>0.89972908279999997</c:v>
                </c:pt>
                <c:pt idx="70">
                  <c:v>0.91148965209999999</c:v>
                </c:pt>
                <c:pt idx="71">
                  <c:v>0.92199048130000005</c:v>
                </c:pt>
                <c:pt idx="72">
                  <c:v>0.93133936969999997</c:v>
                </c:pt>
                <c:pt idx="73">
                  <c:v>0.93964122959999996</c:v>
                </c:pt>
                <c:pt idx="74">
                  <c:v>0.94699644289999996</c:v>
                </c:pt>
                <c:pt idx="75">
                  <c:v>0.95349973089999995</c:v>
                </c:pt>
                <c:pt idx="76">
                  <c:v>0.95923945020000001</c:v>
                </c:pt>
                <c:pt idx="77">
                  <c:v>0.96429722809999996</c:v>
                </c:pt>
                <c:pt idx="78">
                  <c:v>0.96874786400000001</c:v>
                </c:pt>
                <c:pt idx="79">
                  <c:v>0.9726594274</c:v>
                </c:pt>
                <c:pt idx="80">
                  <c:v>0.97609349889999997</c:v>
                </c:pt>
                <c:pt idx="81">
                  <c:v>0.97910550740000002</c:v>
                </c:pt>
                <c:pt idx="82">
                  <c:v>0.98174512849999995</c:v>
                </c:pt>
                <c:pt idx="83">
                  <c:v>0.98405671530000005</c:v>
                </c:pt>
                <c:pt idx="84">
                  <c:v>0.98607974089999995</c:v>
                </c:pt>
                <c:pt idx="85">
                  <c:v>0.98784923759999999</c:v>
                </c:pt>
                <c:pt idx="86">
                  <c:v>0.98939622130000004</c:v>
                </c:pt>
                <c:pt idx="87">
                  <c:v>0.99074809470000003</c:v>
                </c:pt>
                <c:pt idx="88">
                  <c:v>0.99192902439999997</c:v>
                </c:pt>
                <c:pt idx="89">
                  <c:v>0.99296028940000003</c:v>
                </c:pt>
                <c:pt idx="90">
                  <c:v>0.99386060089999995</c:v>
                </c:pt>
                <c:pt idx="91">
                  <c:v>0.99464639210000005</c:v>
                </c:pt>
                <c:pt idx="92">
                  <c:v>0.99533208120000005</c:v>
                </c:pt>
                <c:pt idx="93">
                  <c:v>0.99593030680000005</c:v>
                </c:pt>
                <c:pt idx="94">
                  <c:v>0.99645213899999996</c:v>
                </c:pt>
                <c:pt idx="95">
                  <c:v>0.99690726770000004</c:v>
                </c:pt>
                <c:pt idx="96">
                  <c:v>0.99730416929999999</c:v>
                </c:pt>
                <c:pt idx="97">
                  <c:v>0.99765025519999995</c:v>
                </c:pt>
                <c:pt idx="98">
                  <c:v>0.99795200250000005</c:v>
                </c:pt>
                <c:pt idx="99">
                  <c:v>0.99821506959999995</c:v>
                </c:pt>
                <c:pt idx="100">
                  <c:v>0.9984443981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F086-4159-BC08-37745C7198BB}"/>
            </c:ext>
          </c:extLst>
        </c:ser>
        <c:ser>
          <c:idx val="9"/>
          <c:order val="9"/>
          <c:tx>
            <c:strRef>
              <c:f>Figure1!$AV$1</c:f>
              <c:strCache>
                <c:ptCount val="1"/>
                <c:pt idx="0">
                  <c:v>Have you been spilling food from your mouth? </c:v>
                </c:pt>
              </c:strCache>
            </c:strRef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V$2:$AV$102</c:f>
              <c:numCache>
                <c:formatCode>General</c:formatCode>
                <c:ptCount val="101"/>
                <c:pt idx="0">
                  <c:v>3.4019760000000003E-2</c:v>
                </c:pt>
                <c:pt idx="1">
                  <c:v>3.4019929999999997E-2</c:v>
                </c:pt>
                <c:pt idx="2">
                  <c:v>3.4020130000000003E-2</c:v>
                </c:pt>
                <c:pt idx="3">
                  <c:v>3.4020389999999998E-2</c:v>
                </c:pt>
                <c:pt idx="4">
                  <c:v>3.4020700000000001E-2</c:v>
                </c:pt>
                <c:pt idx="5">
                  <c:v>3.4021080000000002E-2</c:v>
                </c:pt>
                <c:pt idx="6">
                  <c:v>3.4021559999999999E-2</c:v>
                </c:pt>
                <c:pt idx="7">
                  <c:v>3.4022150000000001E-2</c:v>
                </c:pt>
                <c:pt idx="8">
                  <c:v>3.4022879999999998E-2</c:v>
                </c:pt>
                <c:pt idx="9">
                  <c:v>3.4023780000000003E-2</c:v>
                </c:pt>
                <c:pt idx="10">
                  <c:v>3.4024899999999997E-2</c:v>
                </c:pt>
                <c:pt idx="11">
                  <c:v>3.4026279999999999E-2</c:v>
                </c:pt>
                <c:pt idx="12">
                  <c:v>3.4027979999999999E-2</c:v>
                </c:pt>
                <c:pt idx="13">
                  <c:v>3.4030089999999999E-2</c:v>
                </c:pt>
                <c:pt idx="14">
                  <c:v>3.4032699999999999E-2</c:v>
                </c:pt>
                <c:pt idx="15">
                  <c:v>3.4035919999999997E-2</c:v>
                </c:pt>
                <c:pt idx="16">
                  <c:v>3.403991E-2</c:v>
                </c:pt>
                <c:pt idx="17">
                  <c:v>3.404484E-2</c:v>
                </c:pt>
                <c:pt idx="18">
                  <c:v>3.4050940000000002E-2</c:v>
                </c:pt>
                <c:pt idx="19">
                  <c:v>3.405847E-2</c:v>
                </c:pt>
                <c:pt idx="20">
                  <c:v>3.4067800000000002E-2</c:v>
                </c:pt>
                <c:pt idx="21">
                  <c:v>3.4079320000000003E-2</c:v>
                </c:pt>
                <c:pt idx="22">
                  <c:v>3.4093569999999997E-2</c:v>
                </c:pt>
                <c:pt idx="23">
                  <c:v>3.411119E-2</c:v>
                </c:pt>
                <c:pt idx="24">
                  <c:v>3.413298E-2</c:v>
                </c:pt>
                <c:pt idx="25">
                  <c:v>3.4159920000000003E-2</c:v>
                </c:pt>
                <c:pt idx="26">
                  <c:v>3.4193229999999998E-2</c:v>
                </c:pt>
                <c:pt idx="27">
                  <c:v>3.423441E-2</c:v>
                </c:pt>
                <c:pt idx="28">
                  <c:v>3.4285339999999997E-2</c:v>
                </c:pt>
                <c:pt idx="29">
                  <c:v>3.4348299999999998E-2</c:v>
                </c:pt>
                <c:pt idx="30">
                  <c:v>3.4426129999999999E-2</c:v>
                </c:pt>
                <c:pt idx="31">
                  <c:v>3.4522369999999997E-2</c:v>
                </c:pt>
                <c:pt idx="32">
                  <c:v>3.464134E-2</c:v>
                </c:pt>
                <c:pt idx="33">
                  <c:v>3.4788409999999999E-2</c:v>
                </c:pt>
                <c:pt idx="34">
                  <c:v>3.49702E-2</c:v>
                </c:pt>
                <c:pt idx="35">
                  <c:v>3.5194900000000001E-2</c:v>
                </c:pt>
                <c:pt idx="36">
                  <c:v>3.54726E-2</c:v>
                </c:pt>
                <c:pt idx="37">
                  <c:v>3.5815760000000002E-2</c:v>
                </c:pt>
                <c:pt idx="38">
                  <c:v>3.6239750000000001E-2</c:v>
                </c:pt>
                <c:pt idx="39">
                  <c:v>3.6763520000000001E-2</c:v>
                </c:pt>
                <c:pt idx="40">
                  <c:v>3.7410390000000002E-2</c:v>
                </c:pt>
                <c:pt idx="41">
                  <c:v>3.8209060000000003E-2</c:v>
                </c:pt>
                <c:pt idx="42">
                  <c:v>3.9194809999999997E-2</c:v>
                </c:pt>
                <c:pt idx="43">
                  <c:v>4.0410920000000003E-2</c:v>
                </c:pt>
                <c:pt idx="44">
                  <c:v>4.191044E-2</c:v>
                </c:pt>
                <c:pt idx="45">
                  <c:v>4.3758169999999999E-2</c:v>
                </c:pt>
                <c:pt idx="46">
                  <c:v>4.6033110000000002E-2</c:v>
                </c:pt>
                <c:pt idx="47">
                  <c:v>4.8831220000000002E-2</c:v>
                </c:pt>
                <c:pt idx="48">
                  <c:v>5.2268549999999997E-2</c:v>
                </c:pt>
                <c:pt idx="49">
                  <c:v>5.648471E-2</c:v>
                </c:pt>
                <c:pt idx="50">
                  <c:v>6.1646529999999998E-2</c:v>
                </c:pt>
                <c:pt idx="51">
                  <c:v>6.7951709999999999E-2</c:v>
                </c:pt>
                <c:pt idx="52">
                  <c:v>7.5632039999999998E-2</c:v>
                </c:pt>
                <c:pt idx="53">
                  <c:v>8.4955749999999997E-2</c:v>
                </c:pt>
                <c:pt idx="54">
                  <c:v>9.6227919999999995E-2</c:v>
                </c:pt>
                <c:pt idx="55">
                  <c:v>0.10978802999999999</c:v>
                </c:pt>
                <c:pt idx="56">
                  <c:v>0.12600311</c:v>
                </c:pt>
                <c:pt idx="57">
                  <c:v>0.14525472</c:v>
                </c:pt>
                <c:pt idx="58">
                  <c:v>0.16791827000000001</c:v>
                </c:pt>
                <c:pt idx="59">
                  <c:v>0.19433329999999999</c:v>
                </c:pt>
                <c:pt idx="60">
                  <c:v>0.22476479999999999</c:v>
                </c:pt>
                <c:pt idx="61">
                  <c:v>0.25935725999999998</c:v>
                </c:pt>
                <c:pt idx="62">
                  <c:v>0.29808626999999999</c:v>
                </c:pt>
                <c:pt idx="63">
                  <c:v>0.34071528000000001</c:v>
                </c:pt>
                <c:pt idx="64">
                  <c:v>0.38676758</c:v>
                </c:pt>
                <c:pt idx="65">
                  <c:v>0.43552365999999998</c:v>
                </c:pt>
                <c:pt idx="66">
                  <c:v>0.48605120000000002</c:v>
                </c:pt>
                <c:pt idx="67">
                  <c:v>0.53726845000000001</c:v>
                </c:pt>
                <c:pt idx="68">
                  <c:v>0.58803329999999998</c:v>
                </c:pt>
                <c:pt idx="69">
                  <c:v>0.63724338000000003</c:v>
                </c:pt>
                <c:pt idx="70">
                  <c:v>0.68392883000000004</c:v>
                </c:pt>
                <c:pt idx="71">
                  <c:v>0.72732196999999998</c:v>
                </c:pt>
                <c:pt idx="72">
                  <c:v>0.76689445999999994</c:v>
                </c:pt>
                <c:pt idx="73">
                  <c:v>0.80236112000000004</c:v>
                </c:pt>
                <c:pt idx="74">
                  <c:v>0.83365637999999997</c:v>
                </c:pt>
                <c:pt idx="75">
                  <c:v>0.86089335</c:v>
                </c:pt>
                <c:pt idx="76">
                  <c:v>0.88431576000000001</c:v>
                </c:pt>
                <c:pt idx="77">
                  <c:v>0.90425104000000001</c:v>
                </c:pt>
                <c:pt idx="78">
                  <c:v>0.92106986000000002</c:v>
                </c:pt>
                <c:pt idx="79">
                  <c:v>0.93515451000000005</c:v>
                </c:pt>
                <c:pt idx="80">
                  <c:v>0.94687635000000003</c:v>
                </c:pt>
                <c:pt idx="81">
                  <c:v>0.95658138000000004</c:v>
                </c:pt>
                <c:pt idx="82">
                  <c:v>0.96458221</c:v>
                </c:pt>
                <c:pt idx="83">
                  <c:v>0.97115481000000003</c:v>
                </c:pt>
                <c:pt idx="84">
                  <c:v>0.97653846</c:v>
                </c:pt>
                <c:pt idx="85">
                  <c:v>0.98093775000000005</c:v>
                </c:pt>
                <c:pt idx="86">
                  <c:v>0.98452565999999997</c:v>
                </c:pt>
                <c:pt idx="87">
                  <c:v>0.98744721000000002</c:v>
                </c:pt>
                <c:pt idx="88">
                  <c:v>0.98982307999999997</c:v>
                </c:pt>
                <c:pt idx="89">
                  <c:v>0.99175316000000002</c:v>
                </c:pt>
                <c:pt idx="90">
                  <c:v>0.99331974999999995</c:v>
                </c:pt>
                <c:pt idx="91">
                  <c:v>0.99459043000000003</c:v>
                </c:pt>
                <c:pt idx="92">
                  <c:v>0.99562050999999996</c:v>
                </c:pt>
                <c:pt idx="93">
                  <c:v>0.99645516000000001</c:v>
                </c:pt>
                <c:pt idx="94">
                  <c:v>0.99713123000000004</c:v>
                </c:pt>
                <c:pt idx="95">
                  <c:v>0.99767866000000005</c:v>
                </c:pt>
                <c:pt idx="96">
                  <c:v>0.99812184000000004</c:v>
                </c:pt>
                <c:pt idx="97">
                  <c:v>0.99848053999999997</c:v>
                </c:pt>
                <c:pt idx="98">
                  <c:v>0.99877081999999995</c:v>
                </c:pt>
                <c:pt idx="99">
                  <c:v>0.9990057</c:v>
                </c:pt>
                <c:pt idx="100">
                  <c:v>0.999195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F086-4159-BC08-37745C7198BB}"/>
            </c:ext>
          </c:extLst>
        </c:ser>
        <c:ser>
          <c:idx val="10"/>
          <c:order val="10"/>
          <c:tx>
            <c:strRef>
              <c:f>Figure1!$AW$1</c:f>
              <c:strCache>
                <c:ptCount val="1"/>
                <c:pt idx="0">
                  <c:v>Does food remains in my mouth?  </c:v>
                </c:pt>
              </c:strCache>
            </c:strRef>
          </c:tx>
          <c:spPr>
            <a:ln w="19050" cap="rnd">
              <a:solidFill>
                <a:srgbClr val="0070C0"/>
              </a:solidFill>
              <a:prstDash val="lgDash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W$2:$AW$102</c:f>
              <c:numCache>
                <c:formatCode>0.00E+00</c:formatCode>
                <c:ptCount val="101"/>
                <c:pt idx="0">
                  <c:v>1.618759E-5</c:v>
                </c:pt>
                <c:pt idx="1">
                  <c:v>1.744839E-5</c:v>
                </c:pt>
                <c:pt idx="2">
                  <c:v>1.899432E-5</c:v>
                </c:pt>
                <c:pt idx="3">
                  <c:v>2.0889850000000001E-5</c:v>
                </c:pt>
                <c:pt idx="4">
                  <c:v>2.3214049999999998E-5</c:v>
                </c:pt>
                <c:pt idx="5">
                  <c:v>2.6063849999999999E-5</c:v>
                </c:pt>
                <c:pt idx="6">
                  <c:v>2.9558119999999999E-5</c:v>
                </c:pt>
                <c:pt idx="7">
                  <c:v>3.3842569999999998E-5</c:v>
                </c:pt>
                <c:pt idx="8">
                  <c:v>3.909591E-5</c:v>
                </c:pt>
                <c:pt idx="9">
                  <c:v>4.5537210000000002E-5</c:v>
                </c:pt>
                <c:pt idx="10">
                  <c:v>5.3435099999999999E-5</c:v>
                </c:pt>
                <c:pt idx="11">
                  <c:v>6.3118929999999998E-5</c:v>
                </c:pt>
                <c:pt idx="12">
                  <c:v>7.4992499999999997E-5</c:v>
                </c:pt>
                <c:pt idx="13">
                  <c:v>8.9550890000000003E-5</c:v>
                </c:pt>
                <c:pt idx="14">
                  <c:v>1.074011E-4</c:v>
                </c:pt>
                <c:pt idx="15">
                  <c:v>1.292872E-4</c:v>
                </c:pt>
                <c:pt idx="16">
                  <c:v>1.5612159999999999E-4</c:v>
                </c:pt>
                <c:pt idx="17">
                  <c:v>1.890226E-4</c:v>
                </c:pt>
                <c:pt idx="18">
                  <c:v>2.293613E-4</c:v>
                </c:pt>
                <c:pt idx="19">
                  <c:v>2.7881809999999999E-4</c:v>
                </c:pt>
                <c:pt idx="20">
                  <c:v>3.3945280000000002E-4</c:v>
                </c:pt>
                <c:pt idx="21">
                  <c:v>4.1379010000000001E-4</c:v>
                </c:pt>
                <c:pt idx="22">
                  <c:v>5.0492359999999999E-4</c:v>
                </c:pt>
                <c:pt idx="23">
                  <c:v>6.1664429999999995E-4</c:v>
                </c:pt>
                <c:pt idx="24">
                  <c:v>7.5359660000000003E-4</c:v>
                </c:pt>
                <c:pt idx="25">
                  <c:v>9.2146939999999998E-4</c:v>
                </c:pt>
                <c:pt idx="26">
                  <c:v>1.1272299999999999E-3</c:v>
                </c:pt>
                <c:pt idx="27">
                  <c:v>1.379407E-3</c:v>
                </c:pt>
                <c:pt idx="28">
                  <c:v>1.6884409999999999E-3</c:v>
                </c:pt>
                <c:pt idx="29">
                  <c:v>2.067101E-3</c:v>
                </c:pt>
                <c:pt idx="30">
                  <c:v>2.5310039999999999E-3</c:v>
                </c:pt>
                <c:pt idx="31">
                  <c:v>3.0992300000000001E-3</c:v>
                </c:pt>
                <c:pt idx="32">
                  <c:v>3.795077E-3</c:v>
                </c:pt>
                <c:pt idx="33">
                  <c:v>4.6469659999999998E-3</c:v>
                </c:pt>
                <c:pt idx="34">
                  <c:v>5.6895230000000001E-3</c:v>
                </c:pt>
                <c:pt idx="35">
                  <c:v>6.9648770000000004E-3</c:v>
                </c:pt>
                <c:pt idx="36">
                  <c:v>8.5241940000000006E-3</c:v>
                </c:pt>
                <c:pt idx="37">
                  <c:v>1.042948E-2</c:v>
                </c:pt>
                <c:pt idx="38">
                  <c:v>1.275568E-2</c:v>
                </c:pt>
                <c:pt idx="39">
                  <c:v>1.5593060000000001E-2</c:v>
                </c:pt>
                <c:pt idx="40">
                  <c:v>1.9049940000000001E-2</c:v>
                </c:pt>
                <c:pt idx="41">
                  <c:v>2.325559E-2</c:v>
                </c:pt>
                <c:pt idx="42">
                  <c:v>2.8363389999999999E-2</c:v>
                </c:pt>
                <c:pt idx="43">
                  <c:v>3.4553880000000002E-2</c:v>
                </c:pt>
                <c:pt idx="44">
                  <c:v>4.2037529999999997E-2</c:v>
                </c:pt>
                <c:pt idx="45">
                  <c:v>5.1056749999999998E-2</c:v>
                </c:pt>
                <c:pt idx="46">
                  <c:v>6.188652E-2</c:v>
                </c:pt>
                <c:pt idx="47">
                  <c:v>7.4832750000000003E-2</c:v>
                </c:pt>
                <c:pt idx="48">
                  <c:v>9.0227199999999994E-2</c:v>
                </c:pt>
                <c:pt idx="49">
                  <c:v>0.1084179</c:v>
                </c:pt>
                <c:pt idx="50">
                  <c:v>0.12975329999999999</c:v>
                </c:pt>
                <c:pt idx="51">
                  <c:v>0.1545599</c:v>
                </c:pt>
                <c:pt idx="52">
                  <c:v>0.18311160000000001</c:v>
                </c:pt>
                <c:pt idx="53">
                  <c:v>0.2155929</c:v>
                </c:pt>
                <c:pt idx="54">
                  <c:v>0.25205830000000001</c:v>
                </c:pt>
                <c:pt idx="55">
                  <c:v>0.29239280000000001</c:v>
                </c:pt>
                <c:pt idx="56">
                  <c:v>0.33627990000000002</c:v>
                </c:pt>
                <c:pt idx="57">
                  <c:v>0.38318740000000001</c:v>
                </c:pt>
                <c:pt idx="58">
                  <c:v>0.43237560000000003</c:v>
                </c:pt>
                <c:pt idx="59">
                  <c:v>0.48293449999999999</c:v>
                </c:pt>
                <c:pt idx="60">
                  <c:v>0.53384529999999997</c:v>
                </c:pt>
                <c:pt idx="61">
                  <c:v>0.58406080000000005</c:v>
                </c:pt>
                <c:pt idx="62">
                  <c:v>0.63258990000000004</c:v>
                </c:pt>
                <c:pt idx="63">
                  <c:v>0.67857299999999998</c:v>
                </c:pt>
                <c:pt idx="64">
                  <c:v>0.72133639999999999</c:v>
                </c:pt>
                <c:pt idx="65">
                  <c:v>0.76041910000000001</c:v>
                </c:pt>
                <c:pt idx="66">
                  <c:v>0.79557389999999995</c:v>
                </c:pt>
                <c:pt idx="67">
                  <c:v>0.82674559999999997</c:v>
                </c:pt>
                <c:pt idx="68">
                  <c:v>0.85403609999999996</c:v>
                </c:pt>
                <c:pt idx="69">
                  <c:v>0.87766409999999995</c:v>
                </c:pt>
                <c:pt idx="70">
                  <c:v>0.89792439999999996</c:v>
                </c:pt>
                <c:pt idx="71">
                  <c:v>0.91515369999999996</c:v>
                </c:pt>
                <c:pt idx="72">
                  <c:v>0.92970260000000005</c:v>
                </c:pt>
                <c:pt idx="73">
                  <c:v>0.94191510000000001</c:v>
                </c:pt>
                <c:pt idx="74">
                  <c:v>0.95211520000000005</c:v>
                </c:pt>
                <c:pt idx="75">
                  <c:v>0.96059910000000004</c:v>
                </c:pt>
                <c:pt idx="76">
                  <c:v>0.96763089999999996</c:v>
                </c:pt>
                <c:pt idx="77">
                  <c:v>0.97344249999999999</c:v>
                </c:pt>
                <c:pt idx="78">
                  <c:v>0.9782341</c:v>
                </c:pt>
                <c:pt idx="79">
                  <c:v>0.98217699999999997</c:v>
                </c:pt>
                <c:pt idx="80">
                  <c:v>0.98541630000000002</c:v>
                </c:pt>
                <c:pt idx="81">
                  <c:v>0.98807409999999996</c:v>
                </c:pt>
                <c:pt idx="82">
                  <c:v>0.99025220000000003</c:v>
                </c:pt>
                <c:pt idx="83">
                  <c:v>0.99203580000000002</c:v>
                </c:pt>
                <c:pt idx="84">
                  <c:v>0.99349509999999996</c:v>
                </c:pt>
                <c:pt idx="85">
                  <c:v>0.99468849999999998</c:v>
                </c:pt>
                <c:pt idx="86">
                  <c:v>0.99566390000000005</c:v>
                </c:pt>
                <c:pt idx="87">
                  <c:v>0.99646080000000004</c:v>
                </c:pt>
                <c:pt idx="88">
                  <c:v>0.99711170000000005</c:v>
                </c:pt>
                <c:pt idx="89">
                  <c:v>0.99764319999999995</c:v>
                </c:pt>
                <c:pt idx="90">
                  <c:v>0.99807699999999999</c:v>
                </c:pt>
                <c:pt idx="91">
                  <c:v>0.99843110000000002</c:v>
                </c:pt>
                <c:pt idx="92">
                  <c:v>0.9987201</c:v>
                </c:pt>
                <c:pt idx="93">
                  <c:v>0.99895590000000001</c:v>
                </c:pt>
                <c:pt idx="94">
                  <c:v>0.99914829999999999</c:v>
                </c:pt>
                <c:pt idx="95">
                  <c:v>0.99930529999999995</c:v>
                </c:pt>
                <c:pt idx="96">
                  <c:v>0.99943340000000003</c:v>
                </c:pt>
                <c:pt idx="97">
                  <c:v>0.99953780000000003</c:v>
                </c:pt>
                <c:pt idx="98">
                  <c:v>0.99962300000000004</c:v>
                </c:pt>
                <c:pt idx="99">
                  <c:v>0.99969249999999998</c:v>
                </c:pt>
                <c:pt idx="100">
                  <c:v>0.99974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F086-4159-BC08-37745C7198BB}"/>
            </c:ext>
          </c:extLst>
        </c:ser>
        <c:ser>
          <c:idx val="11"/>
          <c:order val="11"/>
          <c:tx>
            <c:strRef>
              <c:f>Figure1!$AX$1</c:f>
              <c:strCache>
                <c:ptCount val="1"/>
                <c:pt idx="0">
                  <c:v>Have you experience reverse flow form stomach? </c:v>
                </c:pt>
              </c:strCache>
            </c:strRef>
          </c:tx>
          <c:spPr>
            <a:ln w="19050" cap="rnd">
              <a:solidFill>
                <a:srgbClr val="0070C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X$2:$AX$102</c:f>
              <c:numCache>
                <c:formatCode>General</c:formatCode>
                <c:ptCount val="101"/>
                <c:pt idx="0">
                  <c:v>6.162513E-2</c:v>
                </c:pt>
                <c:pt idx="1">
                  <c:v>6.162513E-2</c:v>
                </c:pt>
                <c:pt idx="2">
                  <c:v>6.162513E-2</c:v>
                </c:pt>
                <c:pt idx="3">
                  <c:v>6.162513E-2</c:v>
                </c:pt>
                <c:pt idx="4">
                  <c:v>6.162513E-2</c:v>
                </c:pt>
                <c:pt idx="5">
                  <c:v>6.162513E-2</c:v>
                </c:pt>
                <c:pt idx="6">
                  <c:v>6.162513E-2</c:v>
                </c:pt>
                <c:pt idx="7">
                  <c:v>6.162513E-2</c:v>
                </c:pt>
                <c:pt idx="8">
                  <c:v>6.162513E-2</c:v>
                </c:pt>
                <c:pt idx="9">
                  <c:v>6.162513E-2</c:v>
                </c:pt>
                <c:pt idx="10">
                  <c:v>6.162513E-2</c:v>
                </c:pt>
                <c:pt idx="11">
                  <c:v>6.162513E-2</c:v>
                </c:pt>
                <c:pt idx="12">
                  <c:v>6.162513E-2</c:v>
                </c:pt>
                <c:pt idx="13">
                  <c:v>6.162513E-2</c:v>
                </c:pt>
                <c:pt idx="14">
                  <c:v>6.162513E-2</c:v>
                </c:pt>
                <c:pt idx="15">
                  <c:v>6.162513E-2</c:v>
                </c:pt>
                <c:pt idx="16">
                  <c:v>6.162513E-2</c:v>
                </c:pt>
                <c:pt idx="17">
                  <c:v>6.162513E-2</c:v>
                </c:pt>
                <c:pt idx="18">
                  <c:v>6.162513E-2</c:v>
                </c:pt>
                <c:pt idx="19">
                  <c:v>6.162513E-2</c:v>
                </c:pt>
                <c:pt idx="20">
                  <c:v>6.162513E-2</c:v>
                </c:pt>
                <c:pt idx="21">
                  <c:v>6.162513E-2</c:v>
                </c:pt>
                <c:pt idx="22">
                  <c:v>6.162513E-2</c:v>
                </c:pt>
                <c:pt idx="23">
                  <c:v>6.162513E-2</c:v>
                </c:pt>
                <c:pt idx="24">
                  <c:v>6.162513E-2</c:v>
                </c:pt>
                <c:pt idx="25">
                  <c:v>6.162513E-2</c:v>
                </c:pt>
                <c:pt idx="26">
                  <c:v>6.162513E-2</c:v>
                </c:pt>
                <c:pt idx="27">
                  <c:v>6.162513E-2</c:v>
                </c:pt>
                <c:pt idx="28">
                  <c:v>6.162513E-2</c:v>
                </c:pt>
                <c:pt idx="29">
                  <c:v>6.162513E-2</c:v>
                </c:pt>
                <c:pt idx="30">
                  <c:v>6.162513E-2</c:v>
                </c:pt>
                <c:pt idx="31">
                  <c:v>6.162513E-2</c:v>
                </c:pt>
                <c:pt idx="32">
                  <c:v>6.162513E-2</c:v>
                </c:pt>
                <c:pt idx="33">
                  <c:v>6.162513E-2</c:v>
                </c:pt>
                <c:pt idx="34">
                  <c:v>6.162513E-2</c:v>
                </c:pt>
                <c:pt idx="35">
                  <c:v>6.162513E-2</c:v>
                </c:pt>
                <c:pt idx="36">
                  <c:v>6.162513E-2</c:v>
                </c:pt>
                <c:pt idx="37">
                  <c:v>6.162513E-2</c:v>
                </c:pt>
                <c:pt idx="38">
                  <c:v>6.162513E-2</c:v>
                </c:pt>
                <c:pt idx="39">
                  <c:v>6.162513E-2</c:v>
                </c:pt>
                <c:pt idx="40">
                  <c:v>6.162513E-2</c:v>
                </c:pt>
                <c:pt idx="41">
                  <c:v>6.162513E-2</c:v>
                </c:pt>
                <c:pt idx="42">
                  <c:v>6.162513E-2</c:v>
                </c:pt>
                <c:pt idx="43">
                  <c:v>6.162513E-2</c:v>
                </c:pt>
                <c:pt idx="44">
                  <c:v>6.162513E-2</c:v>
                </c:pt>
                <c:pt idx="45">
                  <c:v>6.162513E-2</c:v>
                </c:pt>
                <c:pt idx="46">
                  <c:v>6.162513E-2</c:v>
                </c:pt>
                <c:pt idx="47">
                  <c:v>6.162513E-2</c:v>
                </c:pt>
                <c:pt idx="48">
                  <c:v>6.162513E-2</c:v>
                </c:pt>
                <c:pt idx="49">
                  <c:v>6.162513E-2</c:v>
                </c:pt>
                <c:pt idx="50">
                  <c:v>6.162513E-2</c:v>
                </c:pt>
                <c:pt idx="51">
                  <c:v>6.162513E-2</c:v>
                </c:pt>
                <c:pt idx="52">
                  <c:v>6.162513E-2</c:v>
                </c:pt>
                <c:pt idx="53">
                  <c:v>6.162513E-2</c:v>
                </c:pt>
                <c:pt idx="54">
                  <c:v>6.162513E-2</c:v>
                </c:pt>
                <c:pt idx="55">
                  <c:v>6.162513E-2</c:v>
                </c:pt>
                <c:pt idx="56">
                  <c:v>6.162513E-2</c:v>
                </c:pt>
                <c:pt idx="57">
                  <c:v>6.162513E-2</c:v>
                </c:pt>
                <c:pt idx="58">
                  <c:v>6.162513E-2</c:v>
                </c:pt>
                <c:pt idx="59">
                  <c:v>6.1625140000000002E-2</c:v>
                </c:pt>
                <c:pt idx="60">
                  <c:v>6.1625140000000002E-2</c:v>
                </c:pt>
                <c:pt idx="61">
                  <c:v>6.162517E-2</c:v>
                </c:pt>
                <c:pt idx="62">
                  <c:v>6.1625340000000001E-2</c:v>
                </c:pt>
                <c:pt idx="63">
                  <c:v>6.162625E-2</c:v>
                </c:pt>
                <c:pt idx="64">
                  <c:v>6.1631289999999998E-2</c:v>
                </c:pt>
                <c:pt idx="65">
                  <c:v>6.1659169999999999E-2</c:v>
                </c:pt>
                <c:pt idx="66">
                  <c:v>6.1813359999999998E-2</c:v>
                </c:pt>
                <c:pt idx="67">
                  <c:v>6.2665369999999998E-2</c:v>
                </c:pt>
                <c:pt idx="68">
                  <c:v>6.7350380000000001E-2</c:v>
                </c:pt>
                <c:pt idx="69">
                  <c:v>9.2442070000000001E-2</c:v>
                </c:pt>
                <c:pt idx="70">
                  <c:v>0.21000605</c:v>
                </c:pt>
                <c:pt idx="71">
                  <c:v>0.53977483999999998</c:v>
                </c:pt>
                <c:pt idx="72">
                  <c:v>0.86091739</c:v>
                </c:pt>
                <c:pt idx="73">
                  <c:v>0.9713811</c:v>
                </c:pt>
                <c:pt idx="74">
                  <c:v>0.99469357000000003</c:v>
                </c:pt>
                <c:pt idx="75">
                  <c:v>0.99903622000000003</c:v>
                </c:pt>
                <c:pt idx="76">
                  <c:v>0.99982561999999997</c:v>
                </c:pt>
                <c:pt idx="77">
                  <c:v>0.99996847</c:v>
                </c:pt>
                <c:pt idx="78">
                  <c:v>0.9999943</c:v>
                </c:pt>
                <c:pt idx="79">
                  <c:v>0.99999897000000004</c:v>
                </c:pt>
                <c:pt idx="80">
                  <c:v>0.99999981000000004</c:v>
                </c:pt>
                <c:pt idx="81">
                  <c:v>0.99999996999999996</c:v>
                </c:pt>
                <c:pt idx="82">
                  <c:v>0.99999998999999995</c:v>
                </c:pt>
                <c:pt idx="83">
                  <c:v>1</c:v>
                </c:pt>
                <c:pt idx="84">
                  <c:v>1</c:v>
                </c:pt>
                <c:pt idx="85">
                  <c:v>1</c:v>
                </c:pt>
                <c:pt idx="86">
                  <c:v>1</c:v>
                </c:pt>
                <c:pt idx="87">
                  <c:v>1</c:v>
                </c:pt>
                <c:pt idx="88">
                  <c:v>1</c:v>
                </c:pt>
                <c:pt idx="89">
                  <c:v>1</c:v>
                </c:pt>
                <c:pt idx="90">
                  <c:v>1</c:v>
                </c:pt>
                <c:pt idx="91">
                  <c:v>1</c:v>
                </c:pt>
                <c:pt idx="92">
                  <c:v>1</c:v>
                </c:pt>
                <c:pt idx="93">
                  <c:v>1</c:v>
                </c:pt>
                <c:pt idx="94">
                  <c:v>1</c:v>
                </c:pt>
                <c:pt idx="95">
                  <c:v>1</c:v>
                </c:pt>
                <c:pt idx="96">
                  <c:v>1</c:v>
                </c:pt>
                <c:pt idx="97">
                  <c:v>1</c:v>
                </c:pt>
                <c:pt idx="98">
                  <c:v>1</c:v>
                </c:pt>
                <c:pt idx="99">
                  <c:v>1</c:v>
                </c:pt>
                <c:pt idx="100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F086-4159-BC08-37745C7198BB}"/>
            </c:ext>
          </c:extLst>
        </c:ser>
        <c:ser>
          <c:idx val="12"/>
          <c:order val="12"/>
          <c:tx>
            <c:strRef>
              <c:f>Figure1!$AY$1</c:f>
              <c:strCache>
                <c:ptCount val="1"/>
                <c:pt idx="0">
                  <c:v>Have you feel food left in your chest or feel clogged up? 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Y$2:$AY$102</c:f>
              <c:numCache>
                <c:formatCode>0.00E+00</c:formatCode>
                <c:ptCount val="101"/>
                <c:pt idx="0">
                  <c:v>7.5896330000000004E-6</c:v>
                </c:pt>
                <c:pt idx="1">
                  <c:v>7.5969220000000002E-6</c:v>
                </c:pt>
                <c:pt idx="2">
                  <c:v>7.6064999999999999E-6</c:v>
                </c:pt>
                <c:pt idx="3">
                  <c:v>7.6190859999999996E-6</c:v>
                </c:pt>
                <c:pt idx="4">
                  <c:v>7.6356259999999997E-6</c:v>
                </c:pt>
                <c:pt idx="5">
                  <c:v>7.6573599999999995E-6</c:v>
                </c:pt>
                <c:pt idx="6">
                  <c:v>7.6859220000000006E-6</c:v>
                </c:pt>
                <c:pt idx="7">
                  <c:v>7.7234540000000007E-6</c:v>
                </c:pt>
                <c:pt idx="8">
                  <c:v>7.7727760000000005E-6</c:v>
                </c:pt>
                <c:pt idx="9">
                  <c:v>7.8375889999999992E-6</c:v>
                </c:pt>
                <c:pt idx="10">
                  <c:v>7.9227609999999997E-6</c:v>
                </c:pt>
                <c:pt idx="11">
                  <c:v>8.0346850000000001E-6</c:v>
                </c:pt>
                <c:pt idx="12">
                  <c:v>8.181764E-6</c:v>
                </c:pt>
                <c:pt idx="13">
                  <c:v>8.3750399999999997E-6</c:v>
                </c:pt>
                <c:pt idx="14">
                  <c:v>8.6290240000000005E-6</c:v>
                </c:pt>
                <c:pt idx="15">
                  <c:v>8.9627850000000006E-6</c:v>
                </c:pt>
                <c:pt idx="16">
                  <c:v>9.4013790000000004E-6</c:v>
                </c:pt>
                <c:pt idx="17">
                  <c:v>9.9777350000000001E-6</c:v>
                </c:pt>
                <c:pt idx="18">
                  <c:v>1.073512E-5</c:v>
                </c:pt>
                <c:pt idx="19">
                  <c:v>1.1730409999999999E-5</c:v>
                </c:pt>
                <c:pt idx="20">
                  <c:v>1.30383E-5</c:v>
                </c:pt>
                <c:pt idx="21">
                  <c:v>1.475701E-5</c:v>
                </c:pt>
                <c:pt idx="22">
                  <c:v>1.7015539999999999E-5</c:v>
                </c:pt>
                <c:pt idx="23">
                  <c:v>1.9983470000000001E-5</c:v>
                </c:pt>
                <c:pt idx="24">
                  <c:v>2.3883599999999999E-5</c:v>
                </c:pt>
                <c:pt idx="25">
                  <c:v>2.900871E-5</c:v>
                </c:pt>
                <c:pt idx="26">
                  <c:v>3.5743530000000003E-5</c:v>
                </c:pt>
                <c:pt idx="27">
                  <c:v>4.4593630000000002E-5</c:v>
                </c:pt>
                <c:pt idx="28">
                  <c:v>5.6223300000000001E-5</c:v>
                </c:pt>
                <c:pt idx="29">
                  <c:v>7.1505440000000004E-5</c:v>
                </c:pt>
                <c:pt idx="30">
                  <c:v>9.1586990000000002E-5</c:v>
                </c:pt>
                <c:pt idx="31">
                  <c:v>1.179749E-4</c:v>
                </c:pt>
                <c:pt idx="32">
                  <c:v>1.526492E-4</c:v>
                </c:pt>
                <c:pt idx="33">
                  <c:v>1.982109E-4</c:v>
                </c:pt>
                <c:pt idx="34">
                  <c:v>2.580773E-4</c:v>
                </c:pt>
                <c:pt idx="35">
                  <c:v>3.367369E-4</c:v>
                </c:pt>
                <c:pt idx="36">
                  <c:v>4.4008449999999999E-4</c:v>
                </c:pt>
                <c:pt idx="37">
                  <c:v>5.7586119999999995E-4</c:v>
                </c:pt>
                <c:pt idx="38">
                  <c:v>7.5422919999999999E-4</c:v>
                </c:pt>
                <c:pt idx="39">
                  <c:v>9.8852579999999992E-4</c:v>
                </c:pt>
                <c:pt idx="40">
                  <c:v>1.2962480000000001E-3</c:v>
                </c:pt>
                <c:pt idx="41">
                  <c:v>1.7003369999999999E-3</c:v>
                </c:pt>
                <c:pt idx="42">
                  <c:v>2.230854E-3</c:v>
                </c:pt>
                <c:pt idx="43">
                  <c:v>2.9271499999999999E-3</c:v>
                </c:pt>
                <c:pt idx="44">
                  <c:v>3.840675E-3</c:v>
                </c:pt>
                <c:pt idx="45">
                  <c:v>5.0385960000000002E-3</c:v>
                </c:pt>
                <c:pt idx="46">
                  <c:v>6.6084109999999998E-3</c:v>
                </c:pt>
                <c:pt idx="47">
                  <c:v>8.6637880000000004E-3</c:v>
                </c:pt>
                <c:pt idx="48">
                  <c:v>1.135186E-2</c:v>
                </c:pt>
                <c:pt idx="49">
                  <c:v>1.4862169999999999E-2</c:v>
                </c:pt>
                <c:pt idx="50">
                  <c:v>1.9437340000000001E-2</c:v>
                </c:pt>
                <c:pt idx="51">
                  <c:v>2.5385350000000001E-2</c:v>
                </c:pt>
                <c:pt idx="52">
                  <c:v>3.3092780000000002E-2</c:v>
                </c:pt>
                <c:pt idx="53">
                  <c:v>4.303767E-2</c:v>
                </c:pt>
                <c:pt idx="54">
                  <c:v>5.5799340000000003E-2</c:v>
                </c:pt>
                <c:pt idx="55">
                  <c:v>7.2060840000000001E-2</c:v>
                </c:pt>
                <c:pt idx="56">
                  <c:v>9.2597260000000001E-2</c:v>
                </c:pt>
                <c:pt idx="57">
                  <c:v>0.1182411</c:v>
                </c:pt>
                <c:pt idx="58">
                  <c:v>0.1498148</c:v>
                </c:pt>
                <c:pt idx="59">
                  <c:v>0.1880222</c:v>
                </c:pt>
                <c:pt idx="60">
                  <c:v>0.23330029999999999</c:v>
                </c:pt>
                <c:pt idx="61">
                  <c:v>0.28564659999999997</c:v>
                </c:pt>
                <c:pt idx="62">
                  <c:v>0.34446139999999997</c:v>
                </c:pt>
                <c:pt idx="63">
                  <c:v>0.40846199999999999</c:v>
                </c:pt>
                <c:pt idx="64">
                  <c:v>0.4757247</c:v>
                </c:pt>
                <c:pt idx="65">
                  <c:v>0.54387989999999997</c:v>
                </c:pt>
                <c:pt idx="66">
                  <c:v>0.61043060000000005</c:v>
                </c:pt>
                <c:pt idx="67">
                  <c:v>0.67310740000000002</c:v>
                </c:pt>
                <c:pt idx="68">
                  <c:v>0.73015799999999997</c:v>
                </c:pt>
                <c:pt idx="69">
                  <c:v>0.78049880000000005</c:v>
                </c:pt>
                <c:pt idx="70">
                  <c:v>0.82371559999999999</c:v>
                </c:pt>
                <c:pt idx="71">
                  <c:v>0.85995049999999995</c:v>
                </c:pt>
                <c:pt idx="72">
                  <c:v>0.88973429999999998</c:v>
                </c:pt>
                <c:pt idx="73">
                  <c:v>0.91381889999999999</c:v>
                </c:pt>
                <c:pt idx="74">
                  <c:v>0.93303879999999995</c:v>
                </c:pt>
                <c:pt idx="75">
                  <c:v>0.94821520000000004</c:v>
                </c:pt>
                <c:pt idx="76">
                  <c:v>0.96009909999999998</c:v>
                </c:pt>
                <c:pt idx="77">
                  <c:v>0.96934390000000004</c:v>
                </c:pt>
                <c:pt idx="78">
                  <c:v>0.97649920000000001</c:v>
                </c:pt>
                <c:pt idx="79">
                  <c:v>0.98201539999999998</c:v>
                </c:pt>
                <c:pt idx="80">
                  <c:v>0.98625510000000005</c:v>
                </c:pt>
                <c:pt idx="81">
                  <c:v>0.98950590000000005</c:v>
                </c:pt>
                <c:pt idx="82">
                  <c:v>0.99199420000000005</c:v>
                </c:pt>
                <c:pt idx="83">
                  <c:v>0.99389609999999995</c:v>
                </c:pt>
                <c:pt idx="84">
                  <c:v>0.99534829999999996</c:v>
                </c:pt>
                <c:pt idx="85">
                  <c:v>0.99645620000000001</c:v>
                </c:pt>
                <c:pt idx="86">
                  <c:v>0.99730099999999999</c:v>
                </c:pt>
                <c:pt idx="87">
                  <c:v>0.99794479999999997</c:v>
                </c:pt>
                <c:pt idx="88">
                  <c:v>0.99843519999999997</c:v>
                </c:pt>
                <c:pt idx="89">
                  <c:v>0.99880880000000005</c:v>
                </c:pt>
                <c:pt idx="90">
                  <c:v>0.99909329999999996</c:v>
                </c:pt>
                <c:pt idx="91">
                  <c:v>0.99930989999999997</c:v>
                </c:pt>
                <c:pt idx="92">
                  <c:v>0.99947470000000005</c:v>
                </c:pt>
                <c:pt idx="93">
                  <c:v>0.99960020000000005</c:v>
                </c:pt>
                <c:pt idx="94">
                  <c:v>0.99969580000000002</c:v>
                </c:pt>
                <c:pt idx="95">
                  <c:v>0.99976849999999995</c:v>
                </c:pt>
                <c:pt idx="96">
                  <c:v>0.99982380000000004</c:v>
                </c:pt>
                <c:pt idx="97">
                  <c:v>0.99986589999999997</c:v>
                </c:pt>
                <c:pt idx="98">
                  <c:v>0.99989799999999995</c:v>
                </c:pt>
                <c:pt idx="99">
                  <c:v>0.99992230000000004</c:v>
                </c:pt>
                <c:pt idx="100">
                  <c:v>0.9999409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F086-4159-BC08-37745C7198BB}"/>
            </c:ext>
          </c:extLst>
        </c:ser>
        <c:ser>
          <c:idx val="13"/>
          <c:order val="13"/>
          <c:tx>
            <c:strRef>
              <c:f>Figure1!$AZ$1</c:f>
              <c:strCache>
                <c:ptCount val="1"/>
                <c:pt idx="0">
                  <c:v>Can you not sleep or wake up at night by coughing?  </c:v>
                </c:pt>
              </c:strCache>
            </c:strRef>
          </c:tx>
          <c:spPr>
            <a:ln w="19050" cap="rnd">
              <a:solidFill>
                <a:srgbClr val="7030A0"/>
              </a:solidFill>
              <a:prstDash val="lgDash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AZ$2:$AZ$102</c:f>
              <c:numCache>
                <c:formatCode>General</c:formatCode>
                <c:ptCount val="101"/>
                <c:pt idx="0">
                  <c:v>9.4609730000000003E-2</c:v>
                </c:pt>
                <c:pt idx="1">
                  <c:v>9.4609730000000003E-2</c:v>
                </c:pt>
                <c:pt idx="2">
                  <c:v>9.4609730000000003E-2</c:v>
                </c:pt>
                <c:pt idx="3">
                  <c:v>9.4609730000000003E-2</c:v>
                </c:pt>
                <c:pt idx="4">
                  <c:v>9.4609730000000003E-2</c:v>
                </c:pt>
                <c:pt idx="5">
                  <c:v>9.4609730000000003E-2</c:v>
                </c:pt>
                <c:pt idx="6">
                  <c:v>9.4609730000000003E-2</c:v>
                </c:pt>
                <c:pt idx="7">
                  <c:v>9.4609730000000003E-2</c:v>
                </c:pt>
                <c:pt idx="8">
                  <c:v>9.4609730000000003E-2</c:v>
                </c:pt>
                <c:pt idx="9">
                  <c:v>9.4609730000000003E-2</c:v>
                </c:pt>
                <c:pt idx="10">
                  <c:v>9.4609730000000003E-2</c:v>
                </c:pt>
                <c:pt idx="11">
                  <c:v>9.4609730000000003E-2</c:v>
                </c:pt>
                <c:pt idx="12">
                  <c:v>9.4609730000000003E-2</c:v>
                </c:pt>
                <c:pt idx="13">
                  <c:v>9.4609730000000003E-2</c:v>
                </c:pt>
                <c:pt idx="14">
                  <c:v>9.4609730000000003E-2</c:v>
                </c:pt>
                <c:pt idx="15">
                  <c:v>9.4609730000000003E-2</c:v>
                </c:pt>
                <c:pt idx="16">
                  <c:v>9.4609730000000003E-2</c:v>
                </c:pt>
                <c:pt idx="17">
                  <c:v>9.4609730000000003E-2</c:v>
                </c:pt>
                <c:pt idx="18">
                  <c:v>9.4609730000000003E-2</c:v>
                </c:pt>
                <c:pt idx="19">
                  <c:v>9.4609730000000003E-2</c:v>
                </c:pt>
                <c:pt idx="20">
                  <c:v>9.4609730000000003E-2</c:v>
                </c:pt>
                <c:pt idx="21">
                  <c:v>9.4609730000000003E-2</c:v>
                </c:pt>
                <c:pt idx="22">
                  <c:v>9.4609730000000003E-2</c:v>
                </c:pt>
                <c:pt idx="23">
                  <c:v>9.4609730000000003E-2</c:v>
                </c:pt>
                <c:pt idx="24">
                  <c:v>9.4609730000000003E-2</c:v>
                </c:pt>
                <c:pt idx="25">
                  <c:v>9.4609730000000003E-2</c:v>
                </c:pt>
                <c:pt idx="26">
                  <c:v>9.4609730000000003E-2</c:v>
                </c:pt>
                <c:pt idx="27">
                  <c:v>9.4609730000000003E-2</c:v>
                </c:pt>
                <c:pt idx="28">
                  <c:v>9.4609730000000003E-2</c:v>
                </c:pt>
                <c:pt idx="29">
                  <c:v>9.4609730000000003E-2</c:v>
                </c:pt>
                <c:pt idx="30">
                  <c:v>9.4609730000000003E-2</c:v>
                </c:pt>
                <c:pt idx="31">
                  <c:v>9.4609730000000003E-2</c:v>
                </c:pt>
                <c:pt idx="32">
                  <c:v>9.4609730000000003E-2</c:v>
                </c:pt>
                <c:pt idx="33">
                  <c:v>9.4609730000000003E-2</c:v>
                </c:pt>
                <c:pt idx="34">
                  <c:v>9.4609730000000003E-2</c:v>
                </c:pt>
                <c:pt idx="35">
                  <c:v>9.4609730000000003E-2</c:v>
                </c:pt>
                <c:pt idx="36">
                  <c:v>9.4609730000000003E-2</c:v>
                </c:pt>
                <c:pt idx="37">
                  <c:v>9.4609730000000003E-2</c:v>
                </c:pt>
                <c:pt idx="38">
                  <c:v>9.4609730000000003E-2</c:v>
                </c:pt>
                <c:pt idx="39">
                  <c:v>9.4609730000000003E-2</c:v>
                </c:pt>
                <c:pt idx="40">
                  <c:v>9.4609730000000003E-2</c:v>
                </c:pt>
                <c:pt idx="41">
                  <c:v>9.4609730000000003E-2</c:v>
                </c:pt>
                <c:pt idx="42">
                  <c:v>9.4609730000000003E-2</c:v>
                </c:pt>
                <c:pt idx="43">
                  <c:v>9.4609730000000003E-2</c:v>
                </c:pt>
                <c:pt idx="44">
                  <c:v>9.4609730000000003E-2</c:v>
                </c:pt>
                <c:pt idx="45">
                  <c:v>9.4609730000000003E-2</c:v>
                </c:pt>
                <c:pt idx="46">
                  <c:v>9.4609730000000003E-2</c:v>
                </c:pt>
                <c:pt idx="47">
                  <c:v>9.4609730000000003E-2</c:v>
                </c:pt>
                <c:pt idx="48">
                  <c:v>9.4609730000000003E-2</c:v>
                </c:pt>
                <c:pt idx="49">
                  <c:v>9.4609730000000003E-2</c:v>
                </c:pt>
                <c:pt idx="50">
                  <c:v>9.4609730000000003E-2</c:v>
                </c:pt>
                <c:pt idx="51">
                  <c:v>9.4609730000000003E-2</c:v>
                </c:pt>
                <c:pt idx="52">
                  <c:v>9.4609730000000003E-2</c:v>
                </c:pt>
                <c:pt idx="53">
                  <c:v>9.4609730000000003E-2</c:v>
                </c:pt>
                <c:pt idx="54">
                  <c:v>9.4609730000000003E-2</c:v>
                </c:pt>
                <c:pt idx="55">
                  <c:v>9.4609730000000003E-2</c:v>
                </c:pt>
                <c:pt idx="56">
                  <c:v>9.4609730000000003E-2</c:v>
                </c:pt>
                <c:pt idx="57">
                  <c:v>9.4609730000000003E-2</c:v>
                </c:pt>
                <c:pt idx="58">
                  <c:v>9.4609730000000003E-2</c:v>
                </c:pt>
                <c:pt idx="59">
                  <c:v>9.4609730000000003E-2</c:v>
                </c:pt>
                <c:pt idx="60">
                  <c:v>9.4609730000000003E-2</c:v>
                </c:pt>
                <c:pt idx="61">
                  <c:v>9.4609730000000003E-2</c:v>
                </c:pt>
                <c:pt idx="62">
                  <c:v>9.4609730000000003E-2</c:v>
                </c:pt>
                <c:pt idx="63">
                  <c:v>9.4609730000000003E-2</c:v>
                </c:pt>
                <c:pt idx="64">
                  <c:v>9.4609730000000003E-2</c:v>
                </c:pt>
                <c:pt idx="65">
                  <c:v>9.4609780000000004E-2</c:v>
                </c:pt>
                <c:pt idx="66">
                  <c:v>9.4610280000000005E-2</c:v>
                </c:pt>
                <c:pt idx="67">
                  <c:v>9.4615840000000007E-2</c:v>
                </c:pt>
                <c:pt idx="68">
                  <c:v>9.467747E-2</c:v>
                </c:pt>
                <c:pt idx="69">
                  <c:v>9.5359630000000001E-2</c:v>
                </c:pt>
                <c:pt idx="70">
                  <c:v>0.10284873999999999</c:v>
                </c:pt>
                <c:pt idx="71">
                  <c:v>0.17821806000000001</c:v>
                </c:pt>
                <c:pt idx="72">
                  <c:v>0.57436189999999998</c:v>
                </c:pt>
                <c:pt idx="73">
                  <c:v>0.93286966999999998</c:v>
                </c:pt>
                <c:pt idx="74">
                  <c:v>0.99350223000000004</c:v>
                </c:pt>
                <c:pt idx="75">
                  <c:v>0.99940963000000005</c:v>
                </c:pt>
                <c:pt idx="76">
                  <c:v>0.99994667999999998</c:v>
                </c:pt>
                <c:pt idx="77">
                  <c:v>0.99999519000000003</c:v>
                </c:pt>
                <c:pt idx="78">
                  <c:v>0.99999956999999995</c:v>
                </c:pt>
                <c:pt idx="79">
                  <c:v>0.99999996000000002</c:v>
                </c:pt>
                <c:pt idx="80">
                  <c:v>1</c:v>
                </c:pt>
                <c:pt idx="81">
                  <c:v>1</c:v>
                </c:pt>
                <c:pt idx="82">
                  <c:v>1</c:v>
                </c:pt>
                <c:pt idx="83">
                  <c:v>1</c:v>
                </c:pt>
                <c:pt idx="84">
                  <c:v>1</c:v>
                </c:pt>
                <c:pt idx="85">
                  <c:v>1</c:v>
                </c:pt>
                <c:pt idx="86">
                  <c:v>1</c:v>
                </c:pt>
                <c:pt idx="87">
                  <c:v>1</c:v>
                </c:pt>
                <c:pt idx="88">
                  <c:v>1</c:v>
                </c:pt>
                <c:pt idx="89">
                  <c:v>1</c:v>
                </c:pt>
                <c:pt idx="90">
                  <c:v>1</c:v>
                </c:pt>
                <c:pt idx="91">
                  <c:v>1</c:v>
                </c:pt>
                <c:pt idx="92">
                  <c:v>1</c:v>
                </c:pt>
                <c:pt idx="93">
                  <c:v>1</c:v>
                </c:pt>
                <c:pt idx="94">
                  <c:v>1</c:v>
                </c:pt>
                <c:pt idx="95">
                  <c:v>1</c:v>
                </c:pt>
                <c:pt idx="96">
                  <c:v>1</c:v>
                </c:pt>
                <c:pt idx="97">
                  <c:v>1</c:v>
                </c:pt>
                <c:pt idx="98">
                  <c:v>1</c:v>
                </c:pt>
                <c:pt idx="99">
                  <c:v>1</c:v>
                </c:pt>
                <c:pt idx="100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F086-4159-BC08-37745C7198BB}"/>
            </c:ext>
          </c:extLst>
        </c:ser>
        <c:ser>
          <c:idx val="14"/>
          <c:order val="14"/>
          <c:tx>
            <c:strRef>
              <c:f>Figure1!$BA$1</c:f>
              <c:strCache>
                <c:ptCount val="1"/>
                <c:pt idx="0">
                  <c:v>Has your voice faded? </c:v>
                </c:pt>
              </c:strCache>
            </c:strRef>
          </c:tx>
          <c:spPr>
            <a:ln w="19050" cap="rnd">
              <a:solidFill>
                <a:srgbClr val="7030A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A$2:$BA$102</c:f>
              <c:numCache>
                <c:formatCode>General</c:formatCode>
                <c:ptCount val="101"/>
                <c:pt idx="0">
                  <c:v>1.9078819999999999E-4</c:v>
                </c:pt>
                <c:pt idx="1">
                  <c:v>2.2108070000000001E-4</c:v>
                </c:pt>
                <c:pt idx="2">
                  <c:v>2.561819E-4</c:v>
                </c:pt>
                <c:pt idx="3">
                  <c:v>2.9685459999999998E-4</c:v>
                </c:pt>
                <c:pt idx="4">
                  <c:v>3.4398250000000001E-4</c:v>
                </c:pt>
                <c:pt idx="5">
                  <c:v>3.9858949999999998E-4</c:v>
                </c:pt>
                <c:pt idx="6">
                  <c:v>4.6186140000000002E-4</c:v>
                </c:pt>
                <c:pt idx="7">
                  <c:v>5.351717E-4</c:v>
                </c:pt>
                <c:pt idx="8">
                  <c:v>6.2011140000000004E-4</c:v>
                </c:pt>
                <c:pt idx="9">
                  <c:v>7.185227E-4</c:v>
                </c:pt>
                <c:pt idx="10">
                  <c:v>8.3253880000000002E-4</c:v>
                </c:pt>
                <c:pt idx="11">
                  <c:v>9.646298E-4</c:v>
                </c:pt>
                <c:pt idx="12">
                  <c:v>1.1176551E-3</c:v>
                </c:pt>
                <c:pt idx="13">
                  <c:v>1.2949244E-3</c:v>
                </c:pt>
                <c:pt idx="14">
                  <c:v>1.5002679000000001E-3</c:v>
                </c:pt>
                <c:pt idx="15">
                  <c:v>1.7381174000000001E-3</c:v>
                </c:pt>
                <c:pt idx="16">
                  <c:v>2.0135991000000001E-3</c:v>
                </c:pt>
                <c:pt idx="17">
                  <c:v>2.3326411999999999E-3</c:v>
                </c:pt>
                <c:pt idx="18">
                  <c:v>2.7020967E-3</c:v>
                </c:pt>
                <c:pt idx="19">
                  <c:v>3.1298849000000002E-3</c:v>
                </c:pt>
                <c:pt idx="20">
                  <c:v>3.6251533E-3</c:v>
                </c:pt>
                <c:pt idx="21">
                  <c:v>4.1984622999999997E-3</c:v>
                </c:pt>
                <c:pt idx="22">
                  <c:v>4.8619963E-3</c:v>
                </c:pt>
                <c:pt idx="23">
                  <c:v>5.6298038999999999E-3</c:v>
                </c:pt>
                <c:pt idx="24">
                  <c:v>6.5180697999999999E-3</c:v>
                </c:pt>
                <c:pt idx="25">
                  <c:v>7.5454221999999996E-3</c:v>
                </c:pt>
                <c:pt idx="26">
                  <c:v>8.7332784000000007E-3</c:v>
                </c:pt>
                <c:pt idx="27">
                  <c:v>1.01062316E-2</c:v>
                </c:pt>
                <c:pt idx="28">
                  <c:v>1.1692480099999999E-2</c:v>
                </c:pt>
                <c:pt idx="29">
                  <c:v>1.35243007E-2</c:v>
                </c:pt>
                <c:pt idx="30">
                  <c:v>1.5638565199999999E-2</c:v>
                </c:pt>
                <c:pt idx="31">
                  <c:v>1.80772976E-2</c:v>
                </c:pt>
                <c:pt idx="32">
                  <c:v>2.0888264399999999E-2</c:v>
                </c:pt>
                <c:pt idx="33">
                  <c:v>2.4125589100000001E-2</c:v>
                </c:pt>
                <c:pt idx="34">
                  <c:v>2.78503724E-2</c:v>
                </c:pt>
                <c:pt idx="35">
                  <c:v>3.2131295599999998E-2</c:v>
                </c:pt>
                <c:pt idx="36">
                  <c:v>3.7045171100000003E-2</c:v>
                </c:pt>
                <c:pt idx="37">
                  <c:v>4.2677395200000003E-2</c:v>
                </c:pt>
                <c:pt idx="38">
                  <c:v>4.9122242000000003E-2</c:v>
                </c:pt>
                <c:pt idx="39">
                  <c:v>5.6482922400000003E-2</c:v>
                </c:pt>
                <c:pt idx="40">
                  <c:v>6.4871311299999998E-2</c:v>
                </c:pt>
                <c:pt idx="41">
                  <c:v>7.4407232500000003E-2</c:v>
                </c:pt>
                <c:pt idx="42">
                  <c:v>8.5217169999999995E-2</c:v>
                </c:pt>
                <c:pt idx="43">
                  <c:v>9.7432267599999997E-2</c:v>
                </c:pt>
                <c:pt idx="44">
                  <c:v>0.11118547469999999</c:v>
                </c:pt>
                <c:pt idx="45">
                  <c:v>0.12660771409999999</c:v>
                </c:pt>
                <c:pt idx="46">
                  <c:v>0.14382298139999999</c:v>
                </c:pt>
                <c:pt idx="47">
                  <c:v>0.16294235639999999</c:v>
                </c:pt>
                <c:pt idx="48">
                  <c:v>0.1840570047</c:v>
                </c:pt>
                <c:pt idx="49">
                  <c:v>0.20723038490000001</c:v>
                </c:pt>
                <c:pt idx="50">
                  <c:v>0.23249004440000001</c:v>
                </c:pt>
                <c:pt idx="51">
                  <c:v>0.25981956439999998</c:v>
                </c:pt>
                <c:pt idx="52">
                  <c:v>0.28915138470000001</c:v>
                </c:pt>
                <c:pt idx="53">
                  <c:v>0.32036135710000002</c:v>
                </c:pt>
                <c:pt idx="54">
                  <c:v>0.35326590489999998</c:v>
                </c:pt>
                <c:pt idx="55">
                  <c:v>0.38762256569999998</c:v>
                </c:pt>
                <c:pt idx="56">
                  <c:v>0.42313444880000001</c:v>
                </c:pt>
                <c:pt idx="57">
                  <c:v>0.4594587503</c:v>
                </c:pt>
                <c:pt idx="58">
                  <c:v>0.49621899250000001</c:v>
                </c:pt>
                <c:pt idx="59">
                  <c:v>0.53302015719999996</c:v>
                </c:pt>
                <c:pt idx="60">
                  <c:v>0.56946546890000005</c:v>
                </c:pt>
                <c:pt idx="61">
                  <c:v>0.60517333650000005</c:v>
                </c:pt>
                <c:pt idx="62">
                  <c:v>0.63979293729999998</c:v>
                </c:pt>
                <c:pt idx="63">
                  <c:v>0.67301713370000005</c:v>
                </c:pt>
                <c:pt idx="64">
                  <c:v>0.70459179640000003</c:v>
                </c:pt>
                <c:pt idx="65">
                  <c:v>0.73432109749999996</c:v>
                </c:pt>
                <c:pt idx="66">
                  <c:v>0.76206882389999997</c:v>
                </c:pt>
                <c:pt idx="67">
                  <c:v>0.78775617419999999</c:v>
                </c:pt>
                <c:pt idx="68">
                  <c:v>0.81135677589999999</c:v>
                </c:pt>
                <c:pt idx="69">
                  <c:v>0.83288979330000001</c:v>
                </c:pt>
                <c:pt idx="70">
                  <c:v>0.85241198920000005</c:v>
                </c:pt>
                <c:pt idx="71">
                  <c:v>0.87000949900000002</c:v>
                </c:pt>
                <c:pt idx="72">
                  <c:v>0.88578991659999995</c:v>
                </c:pt>
                <c:pt idx="73">
                  <c:v>0.89987511050000002</c:v>
                </c:pt>
                <c:pt idx="74">
                  <c:v>0.91239501730000006</c:v>
                </c:pt>
                <c:pt idx="75">
                  <c:v>0.92348251719999996</c:v>
                </c:pt>
                <c:pt idx="76">
                  <c:v>0.93326938749999999</c:v>
                </c:pt>
                <c:pt idx="77">
                  <c:v>0.94188325790000005</c:v>
                </c:pt>
                <c:pt idx="78">
                  <c:v>0.94944544500000005</c:v>
                </c:pt>
                <c:pt idx="79">
                  <c:v>0.95606953019999996</c:v>
                </c:pt>
                <c:pt idx="80">
                  <c:v>0.96186053729999998</c:v>
                </c:pt>
                <c:pt idx="81">
                  <c:v>0.966914579</c:v>
                </c:pt>
                <c:pt idx="82">
                  <c:v>0.97131885600000001</c:v>
                </c:pt>
                <c:pt idx="83">
                  <c:v>0.97515190949999997</c:v>
                </c:pt>
                <c:pt idx="84">
                  <c:v>0.97848404700000002</c:v>
                </c:pt>
                <c:pt idx="85">
                  <c:v>0.9813778769</c:v>
                </c:pt>
                <c:pt idx="86">
                  <c:v>0.98388890399999995</c:v>
                </c:pt>
                <c:pt idx="87">
                  <c:v>0.98606614879999999</c:v>
                </c:pt>
                <c:pt idx="88">
                  <c:v>0.98795276470000004</c:v>
                </c:pt>
                <c:pt idx="89">
                  <c:v>0.98958663420000004</c:v>
                </c:pt>
                <c:pt idx="90">
                  <c:v>0.99100093349999996</c:v>
                </c:pt>
                <c:pt idx="91">
                  <c:v>0.99222465790000003</c:v>
                </c:pt>
                <c:pt idx="92">
                  <c:v>0.99328310389999996</c:v>
                </c:pt>
                <c:pt idx="93">
                  <c:v>0.99419830760000005</c:v>
                </c:pt>
                <c:pt idx="94">
                  <c:v>0.99498944030000003</c:v>
                </c:pt>
                <c:pt idx="95">
                  <c:v>0.99567316169999998</c:v>
                </c:pt>
                <c:pt idx="96">
                  <c:v>0.99626393550000003</c:v>
                </c:pt>
                <c:pt idx="97">
                  <c:v>0.99677430810000001</c:v>
                </c:pt>
                <c:pt idx="98">
                  <c:v>0.99721515510000003</c:v>
                </c:pt>
                <c:pt idx="99">
                  <c:v>0.99759589800000004</c:v>
                </c:pt>
                <c:pt idx="100">
                  <c:v>0.9979246941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F086-4159-BC08-37745C7198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24432"/>
        <c:axId val="205583856"/>
      </c:scatterChart>
      <c:valAx>
        <c:axId val="8224432"/>
        <c:scaling>
          <c:orientation val="minMax"/>
          <c:max val="4"/>
          <c:min val="-4"/>
        </c:scaling>
        <c:delete val="0"/>
        <c:axPos val="b"/>
        <c:numFmt formatCode="#,##0_ 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5583856"/>
        <c:crosses val="autoZero"/>
        <c:crossBetween val="midCat"/>
      </c:valAx>
      <c:valAx>
        <c:axId val="205583856"/>
        <c:scaling>
          <c:orientation val="minMax"/>
          <c:max val="1"/>
        </c:scaling>
        <c:delete val="0"/>
        <c:axPos val="l"/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224432"/>
        <c:crosses val="autoZero"/>
        <c:crossBetween val="midCat"/>
        <c:majorUnit val="0.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52579941145277143"/>
          <c:y val="3.3380260730693986E-2"/>
          <c:w val="0.32999723890035132"/>
          <c:h val="0.55907768571613103"/>
        </c:manualLayout>
      </c:layout>
      <c:scatterChart>
        <c:scatterStyle val="lineMarker"/>
        <c:varyColors val="0"/>
        <c:ser>
          <c:idx val="0"/>
          <c:order val="0"/>
          <c:tx>
            <c:strRef>
              <c:f>Figure1!$BC$1</c:f>
              <c:strCache>
                <c:ptCount val="1"/>
                <c:pt idx="0">
                  <c:v>Have you ever been diagnosed with pneumonia? 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C$2:$BC$102</c:f>
              <c:numCache>
                <c:formatCode>0.00E+00</c:formatCode>
                <c:ptCount val="101"/>
                <c:pt idx="0">
                  <c:v>2.6756980000000001E-11</c:v>
                </c:pt>
                <c:pt idx="1">
                  <c:v>2.7243449999999999E-11</c:v>
                </c:pt>
                <c:pt idx="2">
                  <c:v>2.7738750000000002E-11</c:v>
                </c:pt>
                <c:pt idx="3">
                  <c:v>2.824306E-11</c:v>
                </c:pt>
                <c:pt idx="4">
                  <c:v>2.8756539999999999E-11</c:v>
                </c:pt>
                <c:pt idx="5">
                  <c:v>2.9279350000000001E-11</c:v>
                </c:pt>
                <c:pt idx="6">
                  <c:v>2.981167E-11</c:v>
                </c:pt>
                <c:pt idx="7">
                  <c:v>3.0353670000000003E-11</c:v>
                </c:pt>
                <c:pt idx="8">
                  <c:v>3.0905519999999999E-11</c:v>
                </c:pt>
                <c:pt idx="9">
                  <c:v>3.1467400000000001E-11</c:v>
                </c:pt>
                <c:pt idx="10">
                  <c:v>3.2039490000000003E-11</c:v>
                </c:pt>
                <c:pt idx="11">
                  <c:v>3.2621989999999998E-11</c:v>
                </c:pt>
                <c:pt idx="12">
                  <c:v>3.3215079999999999E-11</c:v>
                </c:pt>
                <c:pt idx="13">
                  <c:v>3.3818950000000001E-11</c:v>
                </c:pt>
                <c:pt idx="14">
                  <c:v>3.4433790000000001E-11</c:v>
                </c:pt>
                <c:pt idx="15">
                  <c:v>3.5059819999999999E-11</c:v>
                </c:pt>
                <c:pt idx="16">
                  <c:v>3.5697220000000001E-11</c:v>
                </c:pt>
                <c:pt idx="17">
                  <c:v>3.6346219999999998E-11</c:v>
                </c:pt>
                <c:pt idx="18">
                  <c:v>3.7007010000000003E-11</c:v>
                </c:pt>
                <c:pt idx="19">
                  <c:v>3.767981E-11</c:v>
                </c:pt>
                <c:pt idx="20">
                  <c:v>3.8364849999999999E-11</c:v>
                </c:pt>
                <c:pt idx="21">
                  <c:v>3.9062339999999999E-11</c:v>
                </c:pt>
                <c:pt idx="22">
                  <c:v>3.9772509999999997E-11</c:v>
                </c:pt>
                <c:pt idx="23">
                  <c:v>4.0495590000000003E-11</c:v>
                </c:pt>
                <c:pt idx="24">
                  <c:v>4.123182E-11</c:v>
                </c:pt>
                <c:pt idx="25">
                  <c:v>4.1981429999999998E-11</c:v>
                </c:pt>
                <c:pt idx="26">
                  <c:v>4.2744660000000001E-11</c:v>
                </c:pt>
                <c:pt idx="27">
                  <c:v>4.3521780000000002E-11</c:v>
                </c:pt>
                <c:pt idx="28">
                  <c:v>4.4313019999999999E-11</c:v>
                </c:pt>
                <c:pt idx="29">
                  <c:v>4.5118639999999998E-11</c:v>
                </c:pt>
                <c:pt idx="30">
                  <c:v>4.5938910000000003E-11</c:v>
                </c:pt>
                <c:pt idx="31">
                  <c:v>4.6774089999999999E-11</c:v>
                </c:pt>
                <c:pt idx="32">
                  <c:v>4.7624460000000002E-11</c:v>
                </c:pt>
                <c:pt idx="33">
                  <c:v>4.8490279999999999E-11</c:v>
                </c:pt>
                <c:pt idx="34">
                  <c:v>4.9371840000000002E-11</c:v>
                </c:pt>
                <c:pt idx="35">
                  <c:v>5.0269429999999999E-11</c:v>
                </c:pt>
                <c:pt idx="36">
                  <c:v>5.118334E-11</c:v>
                </c:pt>
                <c:pt idx="37">
                  <c:v>5.211386E-11</c:v>
                </c:pt>
                <c:pt idx="38">
                  <c:v>5.3061300000000003E-11</c:v>
                </c:pt>
                <c:pt idx="39">
                  <c:v>5.4025960000000001E-11</c:v>
                </c:pt>
                <c:pt idx="40">
                  <c:v>5.5008159999999997E-11</c:v>
                </c:pt>
                <c:pt idx="41">
                  <c:v>5.6008210000000003E-11</c:v>
                </c:pt>
                <c:pt idx="42">
                  <c:v>5.7026440000000002E-11</c:v>
                </c:pt>
                <c:pt idx="43">
                  <c:v>5.8063189999999997E-11</c:v>
                </c:pt>
                <c:pt idx="44">
                  <c:v>5.9118780000000005E-11</c:v>
                </c:pt>
                <c:pt idx="45">
                  <c:v>6.0193560000000001E-11</c:v>
                </c:pt>
                <c:pt idx="46">
                  <c:v>6.1287870000000001E-11</c:v>
                </c:pt>
                <c:pt idx="47">
                  <c:v>6.2402090000000004E-11</c:v>
                </c:pt>
                <c:pt idx="48">
                  <c:v>6.3536550000000006E-11</c:v>
                </c:pt>
                <c:pt idx="49">
                  <c:v>6.4691640000000002E-11</c:v>
                </c:pt>
                <c:pt idx="50">
                  <c:v>6.5867729999999996E-11</c:v>
                </c:pt>
                <c:pt idx="51">
                  <c:v>6.7065200000000002E-11</c:v>
                </c:pt>
                <c:pt idx="52">
                  <c:v>6.8284429999999994E-11</c:v>
                </c:pt>
                <c:pt idx="53">
                  <c:v>6.9525830000000001E-11</c:v>
                </c:pt>
                <c:pt idx="54">
                  <c:v>7.0789799999999996E-11</c:v>
                </c:pt>
                <c:pt idx="55">
                  <c:v>7.2076740000000003E-11</c:v>
                </c:pt>
                <c:pt idx="56">
                  <c:v>7.3387079999999999E-11</c:v>
                </c:pt>
                <c:pt idx="57">
                  <c:v>7.4721240000000006E-11</c:v>
                </c:pt>
                <c:pt idx="58">
                  <c:v>7.6079650000000002E-11</c:v>
                </c:pt>
                <c:pt idx="59">
                  <c:v>7.746276E-11</c:v>
                </c:pt>
                <c:pt idx="60">
                  <c:v>7.8871009999999996E-11</c:v>
                </c:pt>
                <c:pt idx="61">
                  <c:v>8.0304850000000005E-11</c:v>
                </c:pt>
                <c:pt idx="62">
                  <c:v>8.1764769999999998E-11</c:v>
                </c:pt>
                <c:pt idx="63">
                  <c:v>8.3251220000000003E-11</c:v>
                </c:pt>
                <c:pt idx="64">
                  <c:v>8.4764690000000006E-11</c:v>
                </c:pt>
                <c:pt idx="65">
                  <c:v>8.6305679999999998E-11</c:v>
                </c:pt>
                <c:pt idx="66">
                  <c:v>8.7874669999999997E-11</c:v>
                </c:pt>
                <c:pt idx="67">
                  <c:v>8.947219E-11</c:v>
                </c:pt>
                <c:pt idx="68">
                  <c:v>9.1098750000000003E-11</c:v>
                </c:pt>
                <c:pt idx="69">
                  <c:v>9.2754880000000002E-11</c:v>
                </c:pt>
                <c:pt idx="70">
                  <c:v>9.4441109999999994E-11</c:v>
                </c:pt>
                <c:pt idx="71">
                  <c:v>9.6158000000000003E-11</c:v>
                </c:pt>
                <c:pt idx="72">
                  <c:v>9.7906090000000006E-11</c:v>
                </c:pt>
                <c:pt idx="73">
                  <c:v>9.9685960000000001E-11</c:v>
                </c:pt>
                <c:pt idx="74">
                  <c:v>1.0149820000000001E-10</c:v>
                </c:pt>
                <c:pt idx="75">
                  <c:v>1.033434E-10</c:v>
                </c:pt>
                <c:pt idx="76">
                  <c:v>1.052221E-10</c:v>
                </c:pt>
                <c:pt idx="77">
                  <c:v>1.0713489999999999E-10</c:v>
                </c:pt>
                <c:pt idx="78">
                  <c:v>1.090825E-10</c:v>
                </c:pt>
                <c:pt idx="79">
                  <c:v>1.110656E-10</c:v>
                </c:pt>
                <c:pt idx="80">
                  <c:v>1.130847E-10</c:v>
                </c:pt>
                <c:pt idx="81">
                  <c:v>1.151404E-10</c:v>
                </c:pt>
                <c:pt idx="82">
                  <c:v>1.172336E-10</c:v>
                </c:pt>
                <c:pt idx="83">
                  <c:v>1.1936479999999999E-10</c:v>
                </c:pt>
                <c:pt idx="84">
                  <c:v>1.2153469999999999E-10</c:v>
                </c:pt>
                <c:pt idx="85">
                  <c:v>1.2374409999999999E-10</c:v>
                </c:pt>
                <c:pt idx="86">
                  <c:v>1.2599370000000001E-10</c:v>
                </c:pt>
                <c:pt idx="87">
                  <c:v>1.2828410000000001E-10</c:v>
                </c:pt>
                <c:pt idx="88">
                  <c:v>1.3061619999999999E-10</c:v>
                </c:pt>
                <c:pt idx="89">
                  <c:v>1.3299060000000001E-10</c:v>
                </c:pt>
                <c:pt idx="90">
                  <c:v>1.354083E-10</c:v>
                </c:pt>
                <c:pt idx="91">
                  <c:v>1.378698E-10</c:v>
                </c:pt>
                <c:pt idx="92">
                  <c:v>1.4037610000000001E-10</c:v>
                </c:pt>
                <c:pt idx="93">
                  <c:v>1.42928E-10</c:v>
                </c:pt>
                <c:pt idx="94">
                  <c:v>1.455263E-10</c:v>
                </c:pt>
                <c:pt idx="95">
                  <c:v>1.4817169999999999E-10</c:v>
                </c:pt>
                <c:pt idx="96">
                  <c:v>1.5086529999999999E-10</c:v>
                </c:pt>
                <c:pt idx="97">
                  <c:v>1.536078E-10</c:v>
                </c:pt>
                <c:pt idx="98">
                  <c:v>1.5640020000000001E-10</c:v>
                </c:pt>
                <c:pt idx="99">
                  <c:v>1.5924340000000001E-10</c:v>
                </c:pt>
                <c:pt idx="100">
                  <c:v>1.6213819999999999E-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C67-42F9-9DC7-2B4002AA8067}"/>
            </c:ext>
          </c:extLst>
        </c:ser>
        <c:ser>
          <c:idx val="1"/>
          <c:order val="1"/>
          <c:tx>
            <c:strRef>
              <c:f>Figure1!$BD$1</c:f>
              <c:strCache>
                <c:ptCount val="1"/>
                <c:pt idx="0">
                  <c:v>Have you been losing weight?  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lgDash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D$2:$BD$102</c:f>
              <c:numCache>
                <c:formatCode>0.00E+00</c:formatCode>
                <c:ptCount val="101"/>
                <c:pt idx="0">
                  <c:v>1.1483980000000001E-22</c:v>
                </c:pt>
                <c:pt idx="1">
                  <c:v>2.9705899999999999E-22</c:v>
                </c:pt>
                <c:pt idx="2">
                  <c:v>7.6840979999999996E-22</c:v>
                </c:pt>
                <c:pt idx="3">
                  <c:v>1.987664E-21</c:v>
                </c:pt>
                <c:pt idx="4">
                  <c:v>5.1415399999999997E-21</c:v>
                </c:pt>
                <c:pt idx="5">
                  <c:v>1.3299749999999999E-20</c:v>
                </c:pt>
                <c:pt idx="6">
                  <c:v>3.4402770000000001E-20</c:v>
                </c:pt>
                <c:pt idx="7">
                  <c:v>8.8990490000000001E-20</c:v>
                </c:pt>
                <c:pt idx="8">
                  <c:v>2.301939E-19</c:v>
                </c:pt>
                <c:pt idx="9">
                  <c:v>5.9544810000000002E-19</c:v>
                </c:pt>
                <c:pt idx="10">
                  <c:v>1.5402600000000001E-18</c:v>
                </c:pt>
                <c:pt idx="11">
                  <c:v>3.9842280000000002E-18</c:v>
                </c:pt>
                <c:pt idx="12">
                  <c:v>1.0306099999999999E-17</c:v>
                </c:pt>
                <c:pt idx="13">
                  <c:v>2.6659039999999999E-17</c:v>
                </c:pt>
                <c:pt idx="14">
                  <c:v>6.8959580000000004E-17</c:v>
                </c:pt>
                <c:pt idx="15">
                  <c:v>1.7837940000000001E-16</c:v>
                </c:pt>
                <c:pt idx="16">
                  <c:v>4.614184E-16</c:v>
                </c:pt>
                <c:pt idx="17">
                  <c:v>1.193562E-15</c:v>
                </c:pt>
                <c:pt idx="18">
                  <c:v>3.0874159999999999E-15</c:v>
                </c:pt>
                <c:pt idx="19">
                  <c:v>7.9862950000000005E-15</c:v>
                </c:pt>
                <c:pt idx="20">
                  <c:v>2.065834E-14</c:v>
                </c:pt>
                <c:pt idx="21">
                  <c:v>5.3437429999999999E-14</c:v>
                </c:pt>
                <c:pt idx="22">
                  <c:v>1.3822790000000001E-13</c:v>
                </c:pt>
                <c:pt idx="23">
                  <c:v>3.5755740000000001E-13</c:v>
                </c:pt>
                <c:pt idx="24">
                  <c:v>9.2490220000000009E-13</c:v>
                </c:pt>
                <c:pt idx="25">
                  <c:v>2.3924659999999999E-12</c:v>
                </c:pt>
                <c:pt idx="26">
                  <c:v>6.1886470000000002E-12</c:v>
                </c:pt>
                <c:pt idx="27">
                  <c:v>1.6008309999999998E-11</c:v>
                </c:pt>
                <c:pt idx="28">
                  <c:v>4.1409019999999999E-11</c:v>
                </c:pt>
                <c:pt idx="29">
                  <c:v>1.071135E-10</c:v>
                </c:pt>
                <c:pt idx="30">
                  <c:v>2.7707200000000002E-10</c:v>
                </c:pt>
                <c:pt idx="31">
                  <c:v>7.1670439999999997E-10</c:v>
                </c:pt>
                <c:pt idx="32">
                  <c:v>1.853898E-9</c:v>
                </c:pt>
                <c:pt idx="33">
                  <c:v>4.7954479999999998E-9</c:v>
                </c:pt>
                <c:pt idx="34">
                  <c:v>1.2404190000000001E-8</c:v>
                </c:pt>
                <c:pt idx="35">
                  <c:v>3.2084889999999997E-8</c:v>
                </c:pt>
                <c:pt idx="36">
                  <c:v>8.2989300000000006E-8</c:v>
                </c:pt>
                <c:pt idx="37">
                  <c:v>2.146477E-7</c:v>
                </c:pt>
                <c:pt idx="38">
                  <c:v>5.5513959999999996E-7</c:v>
                </c:pt>
                <c:pt idx="39">
                  <c:v>1.435599E-6</c:v>
                </c:pt>
                <c:pt idx="40">
                  <c:v>3.711861E-6</c:v>
                </c:pt>
                <c:pt idx="41">
                  <c:v>9.5947529999999998E-6</c:v>
                </c:pt>
                <c:pt idx="42">
                  <c:v>2.47907E-5</c:v>
                </c:pt>
                <c:pt idx="43">
                  <c:v>6.4009319999999999E-5</c:v>
                </c:pt>
                <c:pt idx="44">
                  <c:v>1.65088E-4</c:v>
                </c:pt>
                <c:pt idx="45">
                  <c:v>4.250255E-4</c:v>
                </c:pt>
                <c:pt idx="46">
                  <c:v>1.0911370000000001E-3</c:v>
                </c:pt>
                <c:pt idx="47">
                  <c:v>2.7885319999999998E-3</c:v>
                </c:pt>
                <c:pt idx="48">
                  <c:v>7.0754579999999997E-3</c:v>
                </c:pt>
                <c:pt idx="49">
                  <c:v>1.7751650000000001E-2</c:v>
                </c:pt>
                <c:pt idx="50">
                  <c:v>4.376642E-2</c:v>
                </c:pt>
                <c:pt idx="51">
                  <c:v>0.1050836</c:v>
                </c:pt>
                <c:pt idx="52">
                  <c:v>0.24264260000000001</c:v>
                </c:pt>
                <c:pt idx="53">
                  <c:v>0.53012559999999997</c:v>
                </c:pt>
                <c:pt idx="54">
                  <c:v>1.0750839999999999</c:v>
                </c:pt>
                <c:pt idx="55">
                  <c:v>1.9831460000000001</c:v>
                </c:pt>
                <c:pt idx="56">
                  <c:v>3.2646060000000001</c:v>
                </c:pt>
                <c:pt idx="57">
                  <c:v>4.7206440000000001</c:v>
                </c:pt>
                <c:pt idx="58">
                  <c:v>5.9334309999999997</c:v>
                </c:pt>
                <c:pt idx="59">
                  <c:v>6.4661150000000003</c:v>
                </c:pt>
                <c:pt idx="60">
                  <c:v>6.1566830000000001</c:v>
                </c:pt>
                <c:pt idx="61">
                  <c:v>5.2116129999999998</c:v>
                </c:pt>
                <c:pt idx="62">
                  <c:v>4.0142959999999999</c:v>
                </c:pt>
                <c:pt idx="63">
                  <c:v>2.8816670000000002</c:v>
                </c:pt>
                <c:pt idx="64">
                  <c:v>1.968345</c:v>
                </c:pt>
                <c:pt idx="65">
                  <c:v>1.3000879999999999</c:v>
                </c:pt>
                <c:pt idx="66">
                  <c:v>0.83997929999999998</c:v>
                </c:pt>
                <c:pt idx="67">
                  <c:v>0.53505709999999995</c:v>
                </c:pt>
                <c:pt idx="68">
                  <c:v>0.33776420000000001</c:v>
                </c:pt>
                <c:pt idx="69">
                  <c:v>0.21201030000000001</c:v>
                </c:pt>
                <c:pt idx="70">
                  <c:v>0.13260240000000001</c:v>
                </c:pt>
                <c:pt idx="71">
                  <c:v>8.2751710000000006E-2</c:v>
                </c:pt>
                <c:pt idx="72">
                  <c:v>5.1570169999999999E-2</c:v>
                </c:pt>
                <c:pt idx="73">
                  <c:v>3.2110239999999998E-2</c:v>
                </c:pt>
                <c:pt idx="74">
                  <c:v>1.9982710000000001E-2</c:v>
                </c:pt>
                <c:pt idx="75">
                  <c:v>1.2431380000000001E-2</c:v>
                </c:pt>
                <c:pt idx="76">
                  <c:v>7.7320269999999998E-3</c:v>
                </c:pt>
                <c:pt idx="77">
                  <c:v>4.8085159999999997E-3</c:v>
                </c:pt>
                <c:pt idx="78">
                  <c:v>2.990155E-3</c:v>
                </c:pt>
                <c:pt idx="79">
                  <c:v>1.8593209999999999E-3</c:v>
                </c:pt>
                <c:pt idx="80">
                  <c:v>1.1561169999999999E-3</c:v>
                </c:pt>
                <c:pt idx="81">
                  <c:v>7.1885370000000001E-4</c:v>
                </c:pt>
                <c:pt idx="82">
                  <c:v>4.469656E-4</c:v>
                </c:pt>
                <c:pt idx="83">
                  <c:v>2.7791010000000001E-4</c:v>
                </c:pt>
                <c:pt idx="84">
                  <c:v>1.7279559999999999E-4</c:v>
                </c:pt>
                <c:pt idx="85">
                  <c:v>1.074384E-4</c:v>
                </c:pt>
                <c:pt idx="86">
                  <c:v>6.6801440000000003E-5</c:v>
                </c:pt>
                <c:pt idx="87">
                  <c:v>4.1534749999999997E-5</c:v>
                </c:pt>
                <c:pt idx="88">
                  <c:v>2.58248E-5</c:v>
                </c:pt>
                <c:pt idx="89">
                  <c:v>1.605692E-5</c:v>
                </c:pt>
                <c:pt idx="90">
                  <c:v>9.9836039999999997E-6</c:v>
                </c:pt>
                <c:pt idx="91">
                  <c:v>6.2074379999999998E-6</c:v>
                </c:pt>
                <c:pt idx="92">
                  <c:v>3.8595559999999999E-6</c:v>
                </c:pt>
                <c:pt idx="93">
                  <c:v>2.3997300000000001E-6</c:v>
                </c:pt>
                <c:pt idx="94">
                  <c:v>1.4920639999999999E-6</c:v>
                </c:pt>
                <c:pt idx="95">
                  <c:v>9.2771010000000003E-7</c:v>
                </c:pt>
                <c:pt idx="96">
                  <c:v>5.768159E-7</c:v>
                </c:pt>
                <c:pt idx="97">
                  <c:v>3.5864279999999998E-7</c:v>
                </c:pt>
                <c:pt idx="98">
                  <c:v>2.229909E-7</c:v>
                </c:pt>
                <c:pt idx="99">
                  <c:v>1.386475E-7</c:v>
                </c:pt>
                <c:pt idx="100">
                  <c:v>8.6205889999999996E-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C67-42F9-9DC7-2B4002AA8067}"/>
            </c:ext>
          </c:extLst>
        </c:ser>
        <c:ser>
          <c:idx val="2"/>
          <c:order val="2"/>
          <c:tx>
            <c:strRef>
              <c:f>Figure1!$BE$1</c:f>
              <c:strCache>
                <c:ptCount val="1"/>
                <c:pt idx="0">
                  <c:v>Do you feel that bolus of food are hard to swallow? 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E$2:$BE$102</c:f>
              <c:numCache>
                <c:formatCode>0.00E+00</c:formatCode>
                <c:ptCount val="101"/>
                <c:pt idx="0">
                  <c:v>8.0764580000000006E-18</c:v>
                </c:pt>
                <c:pt idx="1">
                  <c:v>1.679627E-17</c:v>
                </c:pt>
                <c:pt idx="2">
                  <c:v>3.4930499999999998E-17</c:v>
                </c:pt>
                <c:pt idx="3">
                  <c:v>7.2643479999999998E-17</c:v>
                </c:pt>
                <c:pt idx="4">
                  <c:v>1.510736E-16</c:v>
                </c:pt>
                <c:pt idx="5">
                  <c:v>3.141814E-16</c:v>
                </c:pt>
                <c:pt idx="6">
                  <c:v>6.5338970000000001E-16</c:v>
                </c:pt>
                <c:pt idx="7">
                  <c:v>1.358827E-15</c:v>
                </c:pt>
                <c:pt idx="8">
                  <c:v>2.8258950000000001E-15</c:v>
                </c:pt>
                <c:pt idx="9">
                  <c:v>5.8768949999999998E-15</c:v>
                </c:pt>
                <c:pt idx="10">
                  <c:v>1.222193E-14</c:v>
                </c:pt>
                <c:pt idx="11">
                  <c:v>2.5417429999999999E-14</c:v>
                </c:pt>
                <c:pt idx="12">
                  <c:v>5.2859559999999999E-14</c:v>
                </c:pt>
                <c:pt idx="13">
                  <c:v>1.099298E-13</c:v>
                </c:pt>
                <c:pt idx="14">
                  <c:v>2.2861630000000002E-13</c:v>
                </c:pt>
                <c:pt idx="15">
                  <c:v>4.754436E-13</c:v>
                </c:pt>
                <c:pt idx="16">
                  <c:v>9.8875960000000009E-13</c:v>
                </c:pt>
                <c:pt idx="17">
                  <c:v>2.0562800000000002E-12</c:v>
                </c:pt>
                <c:pt idx="18">
                  <c:v>4.2763560000000003E-12</c:v>
                </c:pt>
                <c:pt idx="19">
                  <c:v>8.8933479999999999E-12</c:v>
                </c:pt>
                <c:pt idx="20">
                  <c:v>1.849509E-11</c:v>
                </c:pt>
                <c:pt idx="21">
                  <c:v>3.8463370000000002E-11</c:v>
                </c:pt>
                <c:pt idx="22">
                  <c:v>7.9990360000000001E-11</c:v>
                </c:pt>
                <c:pt idx="23">
                  <c:v>1.663517E-10</c:v>
                </c:pt>
                <c:pt idx="24">
                  <c:v>3.4595220000000001E-10</c:v>
                </c:pt>
                <c:pt idx="25">
                  <c:v>7.1945469999999998E-10</c:v>
                </c:pt>
                <c:pt idx="26">
                  <c:v>1.4961969999999999E-9</c:v>
                </c:pt>
                <c:pt idx="27">
                  <c:v>3.1115100000000001E-9</c:v>
                </c:pt>
                <c:pt idx="28">
                  <c:v>6.4706720000000002E-9</c:v>
                </c:pt>
                <c:pt idx="29">
                  <c:v>1.3456169999999999E-8</c:v>
                </c:pt>
                <c:pt idx="30">
                  <c:v>2.798241E-8</c:v>
                </c:pt>
                <c:pt idx="31">
                  <c:v>5.8188349999999997E-8</c:v>
                </c:pt>
                <c:pt idx="32">
                  <c:v>1.209954E-7</c:v>
                </c:pt>
                <c:pt idx="33">
                  <c:v>2.515797E-7</c:v>
                </c:pt>
                <c:pt idx="34">
                  <c:v>5.2305179999999998E-7</c:v>
                </c:pt>
                <c:pt idx="35">
                  <c:v>1.087326E-6</c:v>
                </c:pt>
                <c:pt idx="36">
                  <c:v>2.2599370000000001E-6</c:v>
                </c:pt>
                <c:pt idx="37">
                  <c:v>4.6959180000000003E-6</c:v>
                </c:pt>
                <c:pt idx="38">
                  <c:v>9.7539970000000003E-6</c:v>
                </c:pt>
                <c:pt idx="39">
                  <c:v>2.0249370000000001E-5</c:v>
                </c:pt>
                <c:pt idx="40">
                  <c:v>4.2005390000000002E-5</c:v>
                </c:pt>
                <c:pt idx="41">
                  <c:v>8.7039689999999999E-5</c:v>
                </c:pt>
                <c:pt idx="42">
                  <c:v>1.8006949999999999E-4</c:v>
                </c:pt>
                <c:pt idx="43">
                  <c:v>3.7168740000000002E-4</c:v>
                </c:pt>
                <c:pt idx="44">
                  <c:v>7.647404E-4</c:v>
                </c:pt>
                <c:pt idx="45">
                  <c:v>1.5662740000000001E-3</c:v>
                </c:pt>
                <c:pt idx="46">
                  <c:v>3.187423E-3</c:v>
                </c:pt>
                <c:pt idx="47">
                  <c:v>6.4291280000000001E-3</c:v>
                </c:pt>
                <c:pt idx="48">
                  <c:v>1.281126E-2</c:v>
                </c:pt>
                <c:pt idx="49">
                  <c:v>2.5117489999999999E-2</c:v>
                </c:pt>
                <c:pt idx="50">
                  <c:v>4.8213840000000001E-2</c:v>
                </c:pt>
                <c:pt idx="51">
                  <c:v>9.0115120000000007E-2</c:v>
                </c:pt>
                <c:pt idx="52">
                  <c:v>0.16309170000000001</c:v>
                </c:pt>
                <c:pt idx="53">
                  <c:v>0.28436739999999999</c:v>
                </c:pt>
                <c:pt idx="54">
                  <c:v>0.47578730000000002</c:v>
                </c:pt>
                <c:pt idx="55">
                  <c:v>0.7618066</c:v>
                </c:pt>
                <c:pt idx="56">
                  <c:v>1.1651309999999999</c:v>
                </c:pt>
                <c:pt idx="57">
                  <c:v>1.6991909999999999</c:v>
                </c:pt>
                <c:pt idx="58">
                  <c:v>2.3568859999999998</c:v>
                </c:pt>
                <c:pt idx="59">
                  <c:v>3.0971839999999999</c:v>
                </c:pt>
                <c:pt idx="60">
                  <c:v>3.8359990000000002</c:v>
                </c:pt>
                <c:pt idx="61">
                  <c:v>4.4529009999999998</c:v>
                </c:pt>
                <c:pt idx="62">
                  <c:v>4.822584</c:v>
                </c:pt>
                <c:pt idx="63">
                  <c:v>4.8634269999999997</c:v>
                </c:pt>
                <c:pt idx="64">
                  <c:v>4.5748470000000001</c:v>
                </c:pt>
                <c:pt idx="65">
                  <c:v>4.035946</c:v>
                </c:pt>
                <c:pt idx="66">
                  <c:v>3.3668770000000001</c:v>
                </c:pt>
                <c:pt idx="67">
                  <c:v>2.6815790000000002</c:v>
                </c:pt>
                <c:pt idx="68">
                  <c:v>2.0587</c:v>
                </c:pt>
                <c:pt idx="69">
                  <c:v>1.5366280000000001</c:v>
                </c:pt>
                <c:pt idx="70">
                  <c:v>1.1231249999999999</c:v>
                </c:pt>
                <c:pt idx="71">
                  <c:v>0.80840369999999995</c:v>
                </c:pt>
                <c:pt idx="72">
                  <c:v>0.57548900000000003</c:v>
                </c:pt>
                <c:pt idx="73">
                  <c:v>0.40647630000000001</c:v>
                </c:pt>
                <c:pt idx="74">
                  <c:v>0.28551219999999999</c:v>
                </c:pt>
                <c:pt idx="75">
                  <c:v>0.19976630000000001</c:v>
                </c:pt>
                <c:pt idx="76">
                  <c:v>0.1393915</c:v>
                </c:pt>
                <c:pt idx="77">
                  <c:v>9.7078750000000005E-2</c:v>
                </c:pt>
                <c:pt idx="78">
                  <c:v>6.7520700000000003E-2</c:v>
                </c:pt>
                <c:pt idx="79">
                  <c:v>4.6919089999999997E-2</c:v>
                </c:pt>
                <c:pt idx="80">
                  <c:v>3.2582489999999999E-2</c:v>
                </c:pt>
                <c:pt idx="81">
                  <c:v>2.2616520000000001E-2</c:v>
                </c:pt>
                <c:pt idx="82">
                  <c:v>1.5693990000000001E-2</c:v>
                </c:pt>
                <c:pt idx="83">
                  <c:v>1.0888E-2</c:v>
                </c:pt>
                <c:pt idx="84">
                  <c:v>7.5526279999999996E-3</c:v>
                </c:pt>
                <c:pt idx="85">
                  <c:v>5.2384579999999997E-3</c:v>
                </c:pt>
                <c:pt idx="86">
                  <c:v>3.6331029999999999E-3</c:v>
                </c:pt>
                <c:pt idx="87">
                  <c:v>2.5195930000000001E-3</c:v>
                </c:pt>
                <c:pt idx="88">
                  <c:v>1.747303E-3</c:v>
                </c:pt>
                <c:pt idx="89">
                  <c:v>1.211702E-3</c:v>
                </c:pt>
                <c:pt idx="90">
                  <c:v>8.4026459999999995E-4</c:v>
                </c:pt>
                <c:pt idx="91">
                  <c:v>5.8268169999999995E-4</c:v>
                </c:pt>
                <c:pt idx="92">
                  <c:v>4.0405760000000003E-4</c:v>
                </c:pt>
                <c:pt idx="93">
                  <c:v>2.8019010000000002E-4</c:v>
                </c:pt>
                <c:pt idx="94">
                  <c:v>1.942945E-4</c:v>
                </c:pt>
                <c:pt idx="95">
                  <c:v>1.3473089999999999E-4</c:v>
                </c:pt>
                <c:pt idx="96">
                  <c:v>9.3427139999999995E-5</c:v>
                </c:pt>
                <c:pt idx="97">
                  <c:v>6.4785579999999997E-5</c:v>
                </c:pt>
                <c:pt idx="98">
                  <c:v>4.49245E-5</c:v>
                </c:pt>
                <c:pt idx="99">
                  <c:v>3.1152139999999999E-5</c:v>
                </c:pt>
                <c:pt idx="100">
                  <c:v>2.1601919999999999E-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C67-42F9-9DC7-2B4002AA8067}"/>
            </c:ext>
          </c:extLst>
        </c:ser>
        <c:ser>
          <c:idx val="3"/>
          <c:order val="3"/>
          <c:tx>
            <c:strRef>
              <c:f>Figure1!$BF$1</c:f>
              <c:strCache>
                <c:ptCount val="1"/>
                <c:pt idx="0">
                  <c:v>Do you choke during your meal? 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F$2:$BF$102</c:f>
              <c:numCache>
                <c:formatCode>0.00E+00</c:formatCode>
                <c:ptCount val="101"/>
                <c:pt idx="0">
                  <c:v>5.8176969999999996E-23</c:v>
                </c:pt>
                <c:pt idx="1">
                  <c:v>1.508879E-22</c:v>
                </c:pt>
                <c:pt idx="2">
                  <c:v>3.913433E-22</c:v>
                </c:pt>
                <c:pt idx="3">
                  <c:v>1.014989E-21</c:v>
                </c:pt>
                <c:pt idx="4">
                  <c:v>2.632477E-21</c:v>
                </c:pt>
                <c:pt idx="5">
                  <c:v>6.8275990000000001E-21</c:v>
                </c:pt>
                <c:pt idx="6">
                  <c:v>1.7708079999999999E-20</c:v>
                </c:pt>
                <c:pt idx="7">
                  <c:v>4.5927710000000001E-20</c:v>
                </c:pt>
                <c:pt idx="8">
                  <c:v>1.1911819999999999E-19</c:v>
                </c:pt>
                <c:pt idx="9">
                  <c:v>3.0894530000000002E-19</c:v>
                </c:pt>
                <c:pt idx="10">
                  <c:v>8.0128120000000001E-19</c:v>
                </c:pt>
                <c:pt idx="11">
                  <c:v>2.0782050000000001E-18</c:v>
                </c:pt>
                <c:pt idx="12">
                  <c:v>5.390036E-18</c:v>
                </c:pt>
                <c:pt idx="13">
                  <c:v>1.397961E-17</c:v>
                </c:pt>
                <c:pt idx="14">
                  <c:v>3.625755E-17</c:v>
                </c:pt>
                <c:pt idx="15">
                  <c:v>9.4037659999999998E-17</c:v>
                </c:pt>
                <c:pt idx="16">
                  <c:v>2.438963E-16</c:v>
                </c:pt>
                <c:pt idx="17">
                  <c:v>6.3257000000000004E-16</c:v>
                </c:pt>
                <c:pt idx="18">
                  <c:v>1.6406350000000001E-15</c:v>
                </c:pt>
                <c:pt idx="19">
                  <c:v>4.2551549999999996E-15</c:v>
                </c:pt>
                <c:pt idx="20">
                  <c:v>1.1036179999999999E-14</c:v>
                </c:pt>
                <c:pt idx="21">
                  <c:v>2.8623459999999998E-14</c:v>
                </c:pt>
                <c:pt idx="22">
                  <c:v>7.4237850000000003E-14</c:v>
                </c:pt>
                <c:pt idx="23">
                  <c:v>1.925434E-13</c:v>
                </c:pt>
                <c:pt idx="24">
                  <c:v>4.9938100000000001E-13</c:v>
                </c:pt>
                <c:pt idx="25">
                  <c:v>1.2951949999999999E-12</c:v>
                </c:pt>
                <c:pt idx="26">
                  <c:v>3.3592190000000001E-12</c:v>
                </c:pt>
                <c:pt idx="27">
                  <c:v>8.7124679999999996E-12</c:v>
                </c:pt>
                <c:pt idx="28">
                  <c:v>2.2596640000000001E-11</c:v>
                </c:pt>
                <c:pt idx="29">
                  <c:v>5.8606519999999999E-11</c:v>
                </c:pt>
                <c:pt idx="30">
                  <c:v>1.5200129999999999E-10</c:v>
                </c:pt>
                <c:pt idx="31">
                  <c:v>3.9422810000000001E-10</c:v>
                </c:pt>
                <c:pt idx="32">
                  <c:v>1.0224590000000001E-9</c:v>
                </c:pt>
                <c:pt idx="33">
                  <c:v>2.6518020000000001E-9</c:v>
                </c:pt>
                <c:pt idx="34">
                  <c:v>6.8775090000000003E-9</c:v>
                </c:pt>
                <c:pt idx="35">
                  <c:v>1.783665E-8</c:v>
                </c:pt>
                <c:pt idx="36">
                  <c:v>4.6257520000000002E-8</c:v>
                </c:pt>
                <c:pt idx="37">
                  <c:v>1.199583E-7</c:v>
                </c:pt>
                <c:pt idx="38">
                  <c:v>3.1106049999999999E-7</c:v>
                </c:pt>
                <c:pt idx="39">
                  <c:v>8.0650099999999995E-7</c:v>
                </c:pt>
                <c:pt idx="40">
                  <c:v>2.090632E-6</c:v>
                </c:pt>
                <c:pt idx="41">
                  <c:v>5.4176340000000001E-6</c:v>
                </c:pt>
                <c:pt idx="42">
                  <c:v>1.403187E-5</c:v>
                </c:pt>
                <c:pt idx="43">
                  <c:v>3.6312700000000002E-5</c:v>
                </c:pt>
                <c:pt idx="44">
                  <c:v>9.3846670000000002E-5</c:v>
                </c:pt>
                <c:pt idx="45">
                  <c:v>2.420178E-4</c:v>
                </c:pt>
                <c:pt idx="46">
                  <c:v>6.2200000000000005E-4</c:v>
                </c:pt>
                <c:pt idx="47">
                  <c:v>1.589942E-3</c:v>
                </c:pt>
                <c:pt idx="48">
                  <c:v>4.0297989999999997E-3</c:v>
                </c:pt>
                <c:pt idx="49">
                  <c:v>1.008064E-2</c:v>
                </c:pt>
                <c:pt idx="50">
                  <c:v>2.472266E-2</c:v>
                </c:pt>
                <c:pt idx="51">
                  <c:v>5.8906390000000003E-2</c:v>
                </c:pt>
                <c:pt idx="52">
                  <c:v>0.13483210000000001</c:v>
                </c:pt>
                <c:pt idx="53">
                  <c:v>0.29284650000000001</c:v>
                </c:pt>
                <c:pt idx="54">
                  <c:v>0.59676669999999998</c:v>
                </c:pt>
                <c:pt idx="55">
                  <c:v>1.1315679999999999</c:v>
                </c:pt>
                <c:pt idx="56">
                  <c:v>1.986254</c:v>
                </c:pt>
                <c:pt idx="57">
                  <c:v>3.2141760000000001</c:v>
                </c:pt>
                <c:pt idx="58">
                  <c:v>4.76511</c:v>
                </c:pt>
                <c:pt idx="59">
                  <c:v>6.4080000000000004</c:v>
                </c:pt>
                <c:pt idx="60">
                  <c:v>7.7233299999999998</c:v>
                </c:pt>
                <c:pt idx="61">
                  <c:v>8.2660409999999995</c:v>
                </c:pt>
                <c:pt idx="62">
                  <c:v>7.8475619999999999</c:v>
                </c:pt>
                <c:pt idx="63">
                  <c:v>6.6720810000000004</c:v>
                </c:pt>
                <c:pt idx="64">
                  <c:v>5.1719549999999996</c:v>
                </c:pt>
                <c:pt idx="65">
                  <c:v>3.7335989999999999</c:v>
                </c:pt>
                <c:pt idx="66">
                  <c:v>2.5604770000000001</c:v>
                </c:pt>
                <c:pt idx="67">
                  <c:v>1.6952609999999999</c:v>
                </c:pt>
                <c:pt idx="68">
                  <c:v>1.0965609999999999</c:v>
                </c:pt>
                <c:pt idx="69">
                  <c:v>0.69868280000000005</c:v>
                </c:pt>
                <c:pt idx="70">
                  <c:v>0.4409131</c:v>
                </c:pt>
                <c:pt idx="71">
                  <c:v>0.2765611</c:v>
                </c:pt>
                <c:pt idx="72">
                  <c:v>0.17281279999999999</c:v>
                </c:pt>
                <c:pt idx="73">
                  <c:v>0.1077277</c:v>
                </c:pt>
                <c:pt idx="74">
                  <c:v>6.7055630000000005E-2</c:v>
                </c:pt>
                <c:pt idx="75">
                  <c:v>4.1700569999999999E-2</c:v>
                </c:pt>
                <c:pt idx="76">
                  <c:v>2.5917869999999999E-2</c:v>
                </c:pt>
                <c:pt idx="77">
                  <c:v>1.6102809999999999E-2</c:v>
                </c:pt>
                <c:pt idx="78">
                  <c:v>1.0002479999999999E-2</c:v>
                </c:pt>
                <c:pt idx="79">
                  <c:v>6.2123250000000003E-3</c:v>
                </c:pt>
                <c:pt idx="80">
                  <c:v>3.8580099999999998E-3</c:v>
                </c:pt>
                <c:pt idx="81">
                  <c:v>2.3957940000000001E-3</c:v>
                </c:pt>
                <c:pt idx="82">
                  <c:v>1.4877200000000001E-3</c:v>
                </c:pt>
                <c:pt idx="83">
                  <c:v>9.2381310000000003E-4</c:v>
                </c:pt>
                <c:pt idx="84">
                  <c:v>5.7364269999999999E-4</c:v>
                </c:pt>
                <c:pt idx="85">
                  <c:v>3.5620120000000001E-4</c:v>
                </c:pt>
                <c:pt idx="86">
                  <c:v>2.2118069999999999E-4</c:v>
                </c:pt>
                <c:pt idx="87">
                  <c:v>1.373402E-4</c:v>
                </c:pt>
                <c:pt idx="88">
                  <c:v>8.5280029999999999E-5</c:v>
                </c:pt>
                <c:pt idx="89">
                  <c:v>5.2953720000000002E-5</c:v>
                </c:pt>
                <c:pt idx="90">
                  <c:v>3.288102E-5</c:v>
                </c:pt>
                <c:pt idx="91">
                  <c:v>2.0417100000000001E-5</c:v>
                </c:pt>
                <c:pt idx="92">
                  <c:v>1.267776E-5</c:v>
                </c:pt>
                <c:pt idx="93">
                  <c:v>7.8721050000000008E-6</c:v>
                </c:pt>
                <c:pt idx="94">
                  <c:v>4.8880910000000002E-6</c:v>
                </c:pt>
                <c:pt idx="95">
                  <c:v>3.0352019999999998E-6</c:v>
                </c:pt>
                <c:pt idx="96">
                  <c:v>1.884673E-6</c:v>
                </c:pt>
                <c:pt idx="97">
                  <c:v>1.1702649999999999E-6</c:v>
                </c:pt>
                <c:pt idx="98">
                  <c:v>7.266623E-7</c:v>
                </c:pt>
                <c:pt idx="99">
                  <c:v>4.5121230000000001E-7</c:v>
                </c:pt>
                <c:pt idx="100">
                  <c:v>2.8017489999999999E-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C67-42F9-9DC7-2B4002AA8067}"/>
            </c:ext>
          </c:extLst>
        </c:ser>
        <c:ser>
          <c:idx val="4"/>
          <c:order val="4"/>
          <c:tx>
            <c:strRef>
              <c:f>Figure1!$BG$1</c:f>
              <c:strCache>
                <c:ptCount val="1"/>
                <c:pt idx="0">
                  <c:v>Do you choke when drinking tea?  </c:v>
                </c:pt>
              </c:strCache>
            </c:strRef>
          </c:tx>
          <c:spPr>
            <a:ln w="19050" cap="rnd">
              <a:solidFill>
                <a:srgbClr val="FFC000"/>
              </a:solidFill>
              <a:prstDash val="lgDash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G$2:$BG$102</c:f>
              <c:numCache>
                <c:formatCode>0.00E+00</c:formatCode>
                <c:ptCount val="101"/>
                <c:pt idx="0">
                  <c:v>1.472834E-5</c:v>
                </c:pt>
                <c:pt idx="1">
                  <c:v>1.9645769999999999E-5</c:v>
                </c:pt>
                <c:pt idx="2">
                  <c:v>2.5969839999999999E-5</c:v>
                </c:pt>
                <c:pt idx="3">
                  <c:v>3.4025210000000001E-5</c:v>
                </c:pt>
                <c:pt idx="4">
                  <c:v>4.4195379999999999E-5</c:v>
                </c:pt>
                <c:pt idx="5">
                  <c:v>5.69337E-5</c:v>
                </c:pt>
                <c:pt idx="6">
                  <c:v>7.2777729999999995E-5</c:v>
                </c:pt>
                <c:pt idx="7">
                  <c:v>9.2367429999999995E-5</c:v>
                </c:pt>
                <c:pt idx="8">
                  <c:v>1.16468E-4</c:v>
                </c:pt>
                <c:pt idx="9">
                  <c:v>1.4599799999999999E-4</c:v>
                </c:pt>
                <c:pt idx="10">
                  <c:v>1.820634E-4</c:v>
                </c:pt>
                <c:pt idx="11">
                  <c:v>2.259989E-4</c:v>
                </c:pt>
                <c:pt idx="12">
                  <c:v>2.7941720000000003E-4</c:v>
                </c:pt>
                <c:pt idx="13">
                  <c:v>3.442691E-4</c:v>
                </c:pt>
                <c:pt idx="14">
                  <c:v>4.2291460000000003E-4</c:v>
                </c:pt>
                <c:pt idx="15">
                  <c:v>5.1820939999999997E-4</c:v>
                </c:pt>
                <c:pt idx="16">
                  <c:v>6.336089E-4</c:v>
                </c:pt>
                <c:pt idx="17">
                  <c:v>7.7329289999999995E-4</c:v>
                </c:pt>
                <c:pt idx="18">
                  <c:v>9.4231770000000005E-4</c:v>
                </c:pt>
                <c:pt idx="19">
                  <c:v>1.146797E-3</c:v>
                </c:pt>
                <c:pt idx="20">
                  <c:v>1.394125E-3</c:v>
                </c:pt>
                <c:pt idx="21">
                  <c:v>1.6932360000000001E-3</c:v>
                </c:pt>
                <c:pt idx="22">
                  <c:v>2.0549330000000001E-3</c:v>
                </c:pt>
                <c:pt idx="23">
                  <c:v>2.492265E-3</c:v>
                </c:pt>
                <c:pt idx="24">
                  <c:v>3.0209989999999999E-3</c:v>
                </c:pt>
                <c:pt idx="25">
                  <c:v>3.6601759999999998E-3</c:v>
                </c:pt>
                <c:pt idx="26">
                  <c:v>4.4327849999999999E-3</c:v>
                </c:pt>
                <c:pt idx="27">
                  <c:v>5.366572E-3</c:v>
                </c:pt>
                <c:pt idx="28">
                  <c:v>6.4950069999999997E-3</c:v>
                </c:pt>
                <c:pt idx="29">
                  <c:v>7.8584499999999995E-3</c:v>
                </c:pt>
                <c:pt idx="30">
                  <c:v>9.5055309999999994E-3</c:v>
                </c:pt>
                <c:pt idx="31">
                  <c:v>1.1494799999999999E-2</c:v>
                </c:pt>
                <c:pt idx="32">
                  <c:v>1.389671E-2</c:v>
                </c:pt>
                <c:pt idx="33">
                  <c:v>1.6795870000000001E-2</c:v>
                </c:pt>
                <c:pt idx="34">
                  <c:v>2.0293869999999999E-2</c:v>
                </c:pt>
                <c:pt idx="35">
                  <c:v>2.4512349999999999E-2</c:v>
                </c:pt>
                <c:pt idx="36">
                  <c:v>2.959678E-2</c:v>
                </c:pt>
                <c:pt idx="37">
                  <c:v>3.5720639999999998E-2</c:v>
                </c:pt>
                <c:pt idx="38">
                  <c:v>4.3090179999999999E-2</c:v>
                </c:pt>
                <c:pt idx="39">
                  <c:v>5.1949759999999998E-2</c:v>
                </c:pt>
                <c:pt idx="40">
                  <c:v>6.2587530000000002E-2</c:v>
                </c:pt>
                <c:pt idx="41">
                  <c:v>7.5341430000000001E-2</c:v>
                </c:pt>
                <c:pt idx="42">
                  <c:v>9.0604970000000007E-2</c:v>
                </c:pt>
                <c:pt idx="43">
                  <c:v>0.1088325</c:v>
                </c:pt>
                <c:pt idx="44">
                  <c:v>0.13054289999999999</c:v>
                </c:pt>
                <c:pt idx="45">
                  <c:v>0.1563205</c:v>
                </c:pt>
                <c:pt idx="46">
                  <c:v>0.18681149999999999</c:v>
                </c:pt>
                <c:pt idx="47">
                  <c:v>0.22271379999999999</c:v>
                </c:pt>
                <c:pt idx="48">
                  <c:v>0.26475680000000001</c:v>
                </c:pt>
                <c:pt idx="49">
                  <c:v>0.3136678</c:v>
                </c:pt>
                <c:pt idx="50">
                  <c:v>0.37012099999999998</c:v>
                </c:pt>
                <c:pt idx="51">
                  <c:v>0.43466510000000003</c:v>
                </c:pt>
                <c:pt idx="52">
                  <c:v>0.50762640000000003</c:v>
                </c:pt>
                <c:pt idx="53">
                  <c:v>0.58898839999999997</c:v>
                </c:pt>
                <c:pt idx="54">
                  <c:v>0.6782511</c:v>
                </c:pt>
                <c:pt idx="55">
                  <c:v>0.77428330000000001</c:v>
                </c:pt>
                <c:pt idx="56">
                  <c:v>0.87518940000000001</c:v>
                </c:pt>
                <c:pt idx="57">
                  <c:v>0.97822209999999998</c:v>
                </c:pt>
                <c:pt idx="58">
                  <c:v>1.07978</c:v>
                </c:pt>
                <c:pt idx="59">
                  <c:v>1.175527</c:v>
                </c:pt>
                <c:pt idx="60">
                  <c:v>1.2606649999999999</c:v>
                </c:pt>
                <c:pt idx="61">
                  <c:v>1.3303499999999999</c:v>
                </c:pt>
                <c:pt idx="62">
                  <c:v>1.3802110000000001</c:v>
                </c:pt>
                <c:pt idx="63">
                  <c:v>1.4068989999999999</c:v>
                </c:pt>
                <c:pt idx="64">
                  <c:v>1.4085460000000001</c:v>
                </c:pt>
                <c:pt idx="65">
                  <c:v>1.3850340000000001</c:v>
                </c:pt>
                <c:pt idx="66">
                  <c:v>1.3380160000000001</c:v>
                </c:pt>
                <c:pt idx="67">
                  <c:v>1.270672</c:v>
                </c:pt>
                <c:pt idx="68">
                  <c:v>1.18727</c:v>
                </c:pt>
                <c:pt idx="69">
                  <c:v>1.0926229999999999</c:v>
                </c:pt>
                <c:pt idx="70">
                  <c:v>0.99156319999999998</c:v>
                </c:pt>
                <c:pt idx="71">
                  <c:v>0.88850359999999995</c:v>
                </c:pt>
                <c:pt idx="72">
                  <c:v>0.78715069999999998</c:v>
                </c:pt>
                <c:pt idx="73">
                  <c:v>0.6903648</c:v>
                </c:pt>
                <c:pt idx="74">
                  <c:v>0.60014829999999997</c:v>
                </c:pt>
                <c:pt idx="75">
                  <c:v>0.51772450000000003</c:v>
                </c:pt>
                <c:pt idx="76">
                  <c:v>0.44366670000000002</c:v>
                </c:pt>
                <c:pt idx="77">
                  <c:v>0.3780461</c:v>
                </c:pt>
                <c:pt idx="78">
                  <c:v>0.3205732</c:v>
                </c:pt>
                <c:pt idx="79">
                  <c:v>0.27072239999999997</c:v>
                </c:pt>
                <c:pt idx="80">
                  <c:v>0.22783100000000001</c:v>
                </c:pt>
                <c:pt idx="81">
                  <c:v>0.1911755</c:v>
                </c:pt>
                <c:pt idx="82">
                  <c:v>0.16002440000000001</c:v>
                </c:pt>
                <c:pt idx="83">
                  <c:v>0.1336745</c:v>
                </c:pt>
                <c:pt idx="84">
                  <c:v>0.111472</c:v>
                </c:pt>
                <c:pt idx="85">
                  <c:v>9.282427E-2</c:v>
                </c:pt>
                <c:pt idx="86">
                  <c:v>7.7204040000000002E-2</c:v>
                </c:pt>
                <c:pt idx="87">
                  <c:v>6.4148739999999996E-2</c:v>
                </c:pt>
                <c:pt idx="88">
                  <c:v>5.3257230000000003E-2</c:v>
                </c:pt>
                <c:pt idx="89">
                  <c:v>4.4184729999999998E-2</c:v>
                </c:pt>
                <c:pt idx="90">
                  <c:v>3.6636960000000003E-2</c:v>
                </c:pt>
                <c:pt idx="91">
                  <c:v>3.0364249999999999E-2</c:v>
                </c:pt>
                <c:pt idx="92">
                  <c:v>2.5155690000000001E-2</c:v>
                </c:pt>
                <c:pt idx="93">
                  <c:v>2.0833859999999999E-2</c:v>
                </c:pt>
                <c:pt idx="94">
                  <c:v>1.7249919999999998E-2</c:v>
                </c:pt>
                <c:pt idx="95">
                  <c:v>1.427934E-2</c:v>
                </c:pt>
                <c:pt idx="96">
                  <c:v>1.1818149999999999E-2</c:v>
                </c:pt>
                <c:pt idx="97">
                  <c:v>9.7796949999999997E-3</c:v>
                </c:pt>
                <c:pt idx="98">
                  <c:v>8.0918239999999992E-3</c:v>
                </c:pt>
                <c:pt idx="99">
                  <c:v>6.6945659999999999E-3</c:v>
                </c:pt>
                <c:pt idx="100">
                  <c:v>5.5381029999999999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C67-42F9-9DC7-2B4002AA8067}"/>
            </c:ext>
          </c:extLst>
        </c:ser>
        <c:ser>
          <c:idx val="5"/>
          <c:order val="5"/>
          <c:tx>
            <c:strRef>
              <c:f>Figure1!$BH$1</c:f>
              <c:strCache>
                <c:ptCount val="1"/>
                <c:pt idx="0">
                  <c:v>Do you discomfort feeling during or after your meal?  </c:v>
                </c:pt>
              </c:strCache>
            </c:strRef>
          </c:tx>
          <c:spPr>
            <a:ln w="19050" cap="rnd">
              <a:solidFill>
                <a:srgbClr val="FFC00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H$2:$BH$102</c:f>
              <c:numCache>
                <c:formatCode>General</c:formatCode>
                <c:ptCount val="101"/>
                <c:pt idx="0">
                  <c:v>3.677024E-4</c:v>
                </c:pt>
                <c:pt idx="1">
                  <c:v>4.2362399999999999E-4</c:v>
                </c:pt>
                <c:pt idx="2">
                  <c:v>4.8768759999999998E-4</c:v>
                </c:pt>
                <c:pt idx="3">
                  <c:v>5.6107019999999995E-4</c:v>
                </c:pt>
                <c:pt idx="4">
                  <c:v>6.4511940000000002E-4</c:v>
                </c:pt>
                <c:pt idx="5">
                  <c:v>7.4137819999999996E-4</c:v>
                </c:pt>
                <c:pt idx="6">
                  <c:v>8.5161280000000002E-4</c:v>
                </c:pt>
                <c:pt idx="7">
                  <c:v>9.7784489999999994E-4</c:v>
                </c:pt>
                <c:pt idx="8">
                  <c:v>1.1223886E-3</c:v>
                </c:pt>
                <c:pt idx="9">
                  <c:v>1.2878919999999999E-3</c:v>
                </c:pt>
                <c:pt idx="10">
                  <c:v>1.4773850999999999E-3</c:v>
                </c:pt>
                <c:pt idx="11">
                  <c:v>1.6943345E-3</c:v>
                </c:pt>
                <c:pt idx="12">
                  <c:v>1.9427057000000001E-3</c:v>
                </c:pt>
                <c:pt idx="13">
                  <c:v>2.2270340000000001E-3</c:v>
                </c:pt>
                <c:pt idx="14">
                  <c:v>2.5525055999999998E-3</c:v>
                </c:pt>
                <c:pt idx="15">
                  <c:v>2.9250490999999999E-3</c:v>
                </c:pt>
                <c:pt idx="16">
                  <c:v>3.3514410000000001E-3</c:v>
                </c:pt>
                <c:pt idx="17">
                  <c:v>3.8394235E-3</c:v>
                </c:pt>
                <c:pt idx="18">
                  <c:v>4.3978402000000002E-3</c:v>
                </c:pt>
                <c:pt idx="19">
                  <c:v>5.0367887000000002E-3</c:v>
                </c:pt>
                <c:pt idx="20">
                  <c:v>5.7677928999999998E-3</c:v>
                </c:pt>
                <c:pt idx="21">
                  <c:v>6.6039983999999999E-3</c:v>
                </c:pt>
                <c:pt idx="22">
                  <c:v>7.5603917999999999E-3</c:v>
                </c:pt>
                <c:pt idx="23">
                  <c:v>8.6540477000000005E-3</c:v>
                </c:pt>
                <c:pt idx="24">
                  <c:v>9.9044041999999995E-3</c:v>
                </c:pt>
                <c:pt idx="25">
                  <c:v>1.1333571299999999E-2</c:v>
                </c:pt>
                <c:pt idx="26">
                  <c:v>1.2966672699999999E-2</c:v>
                </c:pt>
                <c:pt idx="27">
                  <c:v>1.48322239E-2</c:v>
                </c:pt>
                <c:pt idx="28">
                  <c:v>1.6962546299999999E-2</c:v>
                </c:pt>
                <c:pt idx="29">
                  <c:v>1.93942197E-2</c:v>
                </c:pt>
                <c:pt idx="30">
                  <c:v>2.2168569400000001E-2</c:v>
                </c:pt>
                <c:pt idx="31">
                  <c:v>2.53321855E-2</c:v>
                </c:pt>
                <c:pt idx="32">
                  <c:v>2.89374692E-2</c:v>
                </c:pt>
                <c:pt idx="33">
                  <c:v>3.3043193399999997E-2</c:v>
                </c:pt>
                <c:pt idx="34">
                  <c:v>3.7715065399999997E-2</c:v>
                </c:pt>
                <c:pt idx="35">
                  <c:v>4.3026267999999999E-2</c:v>
                </c:pt>
                <c:pt idx="36">
                  <c:v>4.9057949699999999E-2</c:v>
                </c:pt>
                <c:pt idx="37">
                  <c:v>5.5899623099999997E-2</c:v>
                </c:pt>
                <c:pt idx="38">
                  <c:v>6.3649419099999993E-2</c:v>
                </c:pt>
                <c:pt idx="39">
                  <c:v>7.2414125999999995E-2</c:v>
                </c:pt>
                <c:pt idx="40">
                  <c:v>8.2308927700000006E-2</c:v>
                </c:pt>
                <c:pt idx="41">
                  <c:v>9.3456732000000001E-2</c:v>
                </c:pt>
                <c:pt idx="42">
                  <c:v>0.10598695819999999</c:v>
                </c:pt>
                <c:pt idx="43">
                  <c:v>0.1200336285</c:v>
                </c:pt>
                <c:pt idx="44">
                  <c:v>0.1357325891</c:v>
                </c:pt>
                <c:pt idx="45">
                  <c:v>0.15321766589999999</c:v>
                </c:pt>
                <c:pt idx="46">
                  <c:v>0.172615557</c:v>
                </c:pt>
                <c:pt idx="47">
                  <c:v>0.19403927269999999</c:v>
                </c:pt>
                <c:pt idx="48">
                  <c:v>0.21757997330000001</c:v>
                </c:pt>
                <c:pt idx="49">
                  <c:v>0.24329712370000001</c:v>
                </c:pt>
                <c:pt idx="50">
                  <c:v>0.27120701130000002</c:v>
                </c:pt>
                <c:pt idx="51">
                  <c:v>0.30126984839999998</c:v>
                </c:pt>
                <c:pt idx="52">
                  <c:v>0.3333759255</c:v>
                </c:pt>
                <c:pt idx="53">
                  <c:v>0.36733158589999998</c:v>
                </c:pt>
                <c:pt idx="54">
                  <c:v>0.40284614219999998</c:v>
                </c:pt>
                <c:pt idx="55">
                  <c:v>0.43952121280000001</c:v>
                </c:pt>
                <c:pt idx="56">
                  <c:v>0.4768442671</c:v>
                </c:pt>
                <c:pt idx="57">
                  <c:v>0.51418834599999996</c:v>
                </c:pt>
                <c:pt idx="58">
                  <c:v>0.55081987799999999</c:v>
                </c:pt>
                <c:pt idx="59">
                  <c:v>0.58591614550000004</c:v>
                </c:pt>
                <c:pt idx="60">
                  <c:v>0.61859320539999996</c:v>
                </c:pt>
                <c:pt idx="61">
                  <c:v>0.64794394369999997</c:v>
                </c:pt>
                <c:pt idx="62">
                  <c:v>0.67308452070000002</c:v>
                </c:pt>
                <c:pt idx="63">
                  <c:v>0.69320595699999998</c:v>
                </c:pt>
                <c:pt idx="64">
                  <c:v>0.70762629369999996</c:v>
                </c:pt>
                <c:pt idx="65">
                  <c:v>0.715837948</c:v>
                </c:pt>
                <c:pt idx="66">
                  <c:v>0.71754485459999995</c:v>
                </c:pt>
                <c:pt idx="67">
                  <c:v>0.71268484610000005</c:v>
                </c:pt>
                <c:pt idx="68">
                  <c:v>0.70143441809999996</c:v>
                </c:pt>
                <c:pt idx="69">
                  <c:v>0.68419525940000003</c:v>
                </c:pt>
                <c:pt idx="70">
                  <c:v>0.661564288</c:v>
                </c:pt>
                <c:pt idx="71">
                  <c:v>0.63429094929999996</c:v>
                </c:pt>
                <c:pt idx="72">
                  <c:v>0.60322685399999998</c:v>
                </c:pt>
                <c:pt idx="73">
                  <c:v>0.56927325780000004</c:v>
                </c:pt>
                <c:pt idx="74">
                  <c:v>0.53333145309999996</c:v>
                </c:pt>
                <c:pt idx="75">
                  <c:v>0.49626005000000001</c:v>
                </c:pt>
                <c:pt idx="76">
                  <c:v>0.45884167640000001</c:v>
                </c:pt>
                <c:pt idx="77">
                  <c:v>0.4217601279</c:v>
                </c:pt>
                <c:pt idx="78">
                  <c:v>0.38558770399999998</c:v>
                </c:pt>
                <c:pt idx="79">
                  <c:v>0.35078151480000003</c:v>
                </c:pt>
                <c:pt idx="80">
                  <c:v>0.3176869819</c:v>
                </c:pt>
                <c:pt idx="81">
                  <c:v>0.28654655890000003</c:v>
                </c:pt>
                <c:pt idx="82">
                  <c:v>0.25751176549999999</c:v>
                </c:pt>
                <c:pt idx="83">
                  <c:v>0.23065688749999999</c:v>
                </c:pt>
                <c:pt idx="84">
                  <c:v>0.2059930334</c:v>
                </c:pt>
                <c:pt idx="85">
                  <c:v>0.18348159999999999</c:v>
                </c:pt>
                <c:pt idx="86">
                  <c:v>0.16304653059999999</c:v>
                </c:pt>
                <c:pt idx="87">
                  <c:v>0.14458502349999999</c:v>
                </c:pt>
                <c:pt idx="88">
                  <c:v>0.12797656430000001</c:v>
                </c:pt>
                <c:pt idx="89">
                  <c:v>0.1130903011</c:v>
                </c:pt>
                <c:pt idx="90">
                  <c:v>9.9790883299999994E-2</c:v>
                </c:pt>
                <c:pt idx="91">
                  <c:v>8.7942935900000005E-2</c:v>
                </c:pt>
                <c:pt idx="92">
                  <c:v>7.7414366700000001E-2</c:v>
                </c:pt>
                <c:pt idx="93">
                  <c:v>6.8078702399999996E-2</c:v>
                </c:pt>
                <c:pt idx="94">
                  <c:v>5.9816641500000003E-2</c:v>
                </c:pt>
                <c:pt idx="95">
                  <c:v>5.2516988299999998E-2</c:v>
                </c:pt>
                <c:pt idx="96">
                  <c:v>4.6077112900000002E-2</c:v>
                </c:pt>
                <c:pt idx="97">
                  <c:v>4.0403055200000003E-2</c:v>
                </c:pt>
                <c:pt idx="98">
                  <c:v>3.5409373100000002E-2</c:v>
                </c:pt>
                <c:pt idx="99">
                  <c:v>3.1018811100000002E-2</c:v>
                </c:pt>
                <c:pt idx="100">
                  <c:v>2.7161851899999999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C67-42F9-9DC7-2B4002AA8067}"/>
            </c:ext>
          </c:extLst>
        </c:ser>
        <c:ser>
          <c:idx val="6"/>
          <c:order val="6"/>
          <c:tx>
            <c:strRef>
              <c:f>Figure1!$BI$1</c:f>
              <c:strCache>
                <c:ptCount val="1"/>
                <c:pt idx="0">
                  <c:v>Do you feel like food remains in your throat?  </c:v>
                </c:pt>
              </c:strCache>
            </c:strRef>
          </c:tx>
          <c:spPr>
            <a:ln w="19050" cap="rnd">
              <a:solidFill>
                <a:srgbClr val="92D050"/>
              </a:solidFill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I$2:$BI$102</c:f>
              <c:numCache>
                <c:formatCode>0.00E+00</c:formatCode>
                <c:ptCount val="101"/>
                <c:pt idx="0">
                  <c:v>1.727907E-11</c:v>
                </c:pt>
                <c:pt idx="1">
                  <c:v>3.1820080000000001E-11</c:v>
                </c:pt>
                <c:pt idx="2">
                  <c:v>5.859517E-11</c:v>
                </c:pt>
                <c:pt idx="3">
                  <c:v>1.078934E-10</c:v>
                </c:pt>
                <c:pt idx="4">
                  <c:v>1.9865090000000001E-10</c:v>
                </c:pt>
                <c:pt idx="5">
                  <c:v>3.657088E-10</c:v>
                </c:pt>
                <c:pt idx="6">
                  <c:v>6.7314959999999997E-10</c:v>
                </c:pt>
                <c:pt idx="7">
                  <c:v>1.238781E-9</c:v>
                </c:pt>
                <c:pt idx="8">
                  <c:v>2.2790379999999998E-9</c:v>
                </c:pt>
                <c:pt idx="9">
                  <c:v>4.1911909999999998E-9</c:v>
                </c:pt>
                <c:pt idx="10">
                  <c:v>7.7035730000000002E-9</c:v>
                </c:pt>
                <c:pt idx="11">
                  <c:v>1.414928E-8</c:v>
                </c:pt>
                <c:pt idx="12">
                  <c:v>2.5963009999999999E-8</c:v>
                </c:pt>
                <c:pt idx="13">
                  <c:v>4.7578160000000002E-8</c:v>
                </c:pt>
                <c:pt idx="14">
                  <c:v>8.7035699999999996E-8</c:v>
                </c:pt>
                <c:pt idx="15">
                  <c:v>1.5884229999999999E-7</c:v>
                </c:pt>
                <c:pt idx="16">
                  <c:v>2.8898469999999999E-7</c:v>
                </c:pt>
                <c:pt idx="17">
                  <c:v>5.235804E-7</c:v>
                </c:pt>
                <c:pt idx="18">
                  <c:v>9.4347270000000002E-7</c:v>
                </c:pt>
                <c:pt idx="19">
                  <c:v>1.6881410000000001E-6</c:v>
                </c:pt>
                <c:pt idx="20">
                  <c:v>2.9933950000000001E-6</c:v>
                </c:pt>
                <c:pt idx="21">
                  <c:v>5.2479390000000002E-6</c:v>
                </c:pt>
                <c:pt idx="22">
                  <c:v>9.0731589999999993E-6</c:v>
                </c:pt>
                <c:pt idx="23">
                  <c:v>1.5427550000000001E-5</c:v>
                </c:pt>
                <c:pt idx="24">
                  <c:v>2.5732490000000001E-5</c:v>
                </c:pt>
                <c:pt idx="25">
                  <c:v>4.2012489999999997E-5</c:v>
                </c:pt>
                <c:pt idx="26">
                  <c:v>6.7046579999999995E-5</c:v>
                </c:pt>
                <c:pt idx="27">
                  <c:v>1.045421E-4</c:v>
                </c:pt>
                <c:pt idx="28">
                  <c:v>1.5936530000000001E-4</c:v>
                </c:pt>
                <c:pt idx="29">
                  <c:v>2.3788450000000001E-4</c:v>
                </c:pt>
                <c:pt idx="30">
                  <c:v>3.4848970000000003E-4</c:v>
                </c:pt>
                <c:pt idx="31">
                  <c:v>5.0235030000000003E-4</c:v>
                </c:pt>
                <c:pt idx="32">
                  <c:v>7.1447790000000002E-4</c:v>
                </c:pt>
                <c:pt idx="33">
                  <c:v>1.005173E-3</c:v>
                </c:pt>
                <c:pt idx="34">
                  <c:v>1.4019740000000001E-3</c:v>
                </c:pt>
                <c:pt idx="35">
                  <c:v>1.94228E-3</c:v>
                </c:pt>
                <c:pt idx="36">
                  <c:v>2.6768790000000001E-3</c:v>
                </c:pt>
                <c:pt idx="37">
                  <c:v>3.6747149999999998E-3</c:v>
                </c:pt>
                <c:pt idx="38">
                  <c:v>5.0293270000000001E-3</c:v>
                </c:pt>
                <c:pt idx="39">
                  <c:v>6.8675489999999997E-3</c:v>
                </c:pt>
                <c:pt idx="40">
                  <c:v>9.3612460000000002E-3</c:v>
                </c:pt>
                <c:pt idx="41">
                  <c:v>1.274313E-2</c:v>
                </c:pt>
                <c:pt idx="42">
                  <c:v>1.7328E-2</c:v>
                </c:pt>
                <c:pt idx="43">
                  <c:v>2.354117E-2</c:v>
                </c:pt>
                <c:pt idx="44">
                  <c:v>3.195634E-2</c:v>
                </c:pt>
                <c:pt idx="45">
                  <c:v>4.3345599999999998E-2</c:v>
                </c:pt>
                <c:pt idx="46">
                  <c:v>5.8744949999999997E-2</c:v>
                </c:pt>
                <c:pt idx="47">
                  <c:v>7.9538689999999995E-2</c:v>
                </c:pt>
                <c:pt idx="48">
                  <c:v>0.1075661</c:v>
                </c:pt>
                <c:pt idx="49">
                  <c:v>0.14525170000000001</c:v>
                </c:pt>
                <c:pt idx="50">
                  <c:v>0.1957573</c:v>
                </c:pt>
                <c:pt idx="51">
                  <c:v>0.26314310000000002</c:v>
                </c:pt>
                <c:pt idx="52">
                  <c:v>0.35251139999999997</c:v>
                </c:pt>
                <c:pt idx="53">
                  <c:v>0.47007480000000001</c:v>
                </c:pt>
                <c:pt idx="54">
                  <c:v>0.62304590000000004</c:v>
                </c:pt>
                <c:pt idx="55">
                  <c:v>0.81918380000000002</c:v>
                </c:pt>
                <c:pt idx="56">
                  <c:v>1.0657589999999999</c:v>
                </c:pt>
                <c:pt idx="57">
                  <c:v>1.3676710000000001</c:v>
                </c:pt>
                <c:pt idx="58">
                  <c:v>1.7245360000000001</c:v>
                </c:pt>
                <c:pt idx="59">
                  <c:v>2.1269230000000001</c:v>
                </c:pt>
                <c:pt idx="60">
                  <c:v>2.5526680000000002</c:v>
                </c:pt>
                <c:pt idx="61">
                  <c:v>2.9651779999999999</c:v>
                </c:pt>
                <c:pt idx="62">
                  <c:v>3.3162769999999999</c:v>
                </c:pt>
                <c:pt idx="63">
                  <c:v>3.5552239999999999</c:v>
                </c:pt>
                <c:pt idx="64">
                  <c:v>3.642417</c:v>
                </c:pt>
                <c:pt idx="65">
                  <c:v>3.562392</c:v>
                </c:pt>
                <c:pt idx="66">
                  <c:v>3.3293650000000001</c:v>
                </c:pt>
                <c:pt idx="67">
                  <c:v>2.9821270000000002</c:v>
                </c:pt>
                <c:pt idx="68">
                  <c:v>2.5712380000000001</c:v>
                </c:pt>
                <c:pt idx="69">
                  <c:v>2.1452179999999998</c:v>
                </c:pt>
                <c:pt idx="70">
                  <c:v>1.7412639999999999</c:v>
                </c:pt>
                <c:pt idx="71">
                  <c:v>1.3821559999999999</c:v>
                </c:pt>
                <c:pt idx="72">
                  <c:v>1.0778049999999999</c:v>
                </c:pt>
                <c:pt idx="73">
                  <c:v>0.82890770000000003</c:v>
                </c:pt>
                <c:pt idx="74">
                  <c:v>0.6307258</c:v>
                </c:pt>
                <c:pt idx="75">
                  <c:v>0.47604560000000001</c:v>
                </c:pt>
                <c:pt idx="76">
                  <c:v>0.35710310000000001</c:v>
                </c:pt>
                <c:pt idx="77">
                  <c:v>0.26664929999999998</c:v>
                </c:pt>
                <c:pt idx="78">
                  <c:v>0.1984242</c:v>
                </c:pt>
                <c:pt idx="79">
                  <c:v>0.14727799999999999</c:v>
                </c:pt>
                <c:pt idx="80">
                  <c:v>0.109108</c:v>
                </c:pt>
                <c:pt idx="81">
                  <c:v>8.0716800000000005E-2</c:v>
                </c:pt>
                <c:pt idx="82">
                  <c:v>5.9651219999999998E-2</c:v>
                </c:pt>
                <c:pt idx="83">
                  <c:v>4.4049459999999999E-2</c:v>
                </c:pt>
                <c:pt idx="84">
                  <c:v>3.2509860000000002E-2</c:v>
                </c:pt>
                <c:pt idx="85">
                  <c:v>2.398322E-2</c:v>
                </c:pt>
                <c:pt idx="86">
                  <c:v>1.768747E-2</c:v>
                </c:pt>
                <c:pt idx="87">
                  <c:v>1.304141E-2</c:v>
                </c:pt>
                <c:pt idx="88">
                  <c:v>9.6141419999999991E-3</c:v>
                </c:pt>
                <c:pt idx="89">
                  <c:v>7.0866760000000001E-3</c:v>
                </c:pt>
                <c:pt idx="90">
                  <c:v>5.2231789999999997E-3</c:v>
                </c:pt>
                <c:pt idx="91">
                  <c:v>3.849444E-3</c:v>
                </c:pt>
                <c:pt idx="92">
                  <c:v>2.8368709999999999E-3</c:v>
                </c:pt>
                <c:pt idx="93">
                  <c:v>2.0905720000000002E-3</c:v>
                </c:pt>
                <c:pt idx="94">
                  <c:v>1.5405620000000001E-3</c:v>
                </c:pt>
                <c:pt idx="95">
                  <c:v>1.135231E-3</c:v>
                </c:pt>
                <c:pt idx="96">
                  <c:v>8.3653359999999997E-4</c:v>
                </c:pt>
                <c:pt idx="97">
                  <c:v>6.1642130000000002E-4</c:v>
                </c:pt>
                <c:pt idx="98">
                  <c:v>4.542223E-4</c:v>
                </c:pt>
                <c:pt idx="99">
                  <c:v>3.3470070000000003E-4</c:v>
                </c:pt>
                <c:pt idx="100">
                  <c:v>2.4662840000000001E-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EC67-42F9-9DC7-2B4002AA8067}"/>
            </c:ext>
          </c:extLst>
        </c:ser>
        <c:ser>
          <c:idx val="7"/>
          <c:order val="7"/>
          <c:tx>
            <c:strRef>
              <c:f>Figure1!$BJ$1</c:f>
              <c:strCache>
                <c:ptCount val="1"/>
                <c:pt idx="0">
                  <c:v>Have you been growing late for eating?  </c:v>
                </c:pt>
              </c:strCache>
            </c:strRef>
          </c:tx>
          <c:spPr>
            <a:ln w="19050" cap="rnd">
              <a:solidFill>
                <a:srgbClr val="92D050"/>
              </a:solidFill>
              <a:prstDash val="lgDash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J$2:$BJ$102</c:f>
              <c:numCache>
                <c:formatCode>General</c:formatCode>
                <c:ptCount val="101"/>
                <c:pt idx="0">
                  <c:v>6.7611889999999999E-3</c:v>
                </c:pt>
                <c:pt idx="1">
                  <c:v>7.4308810000000003E-3</c:v>
                </c:pt>
                <c:pt idx="2">
                  <c:v>8.1661259999999992E-3</c:v>
                </c:pt>
                <c:pt idx="3">
                  <c:v>8.9731810000000002E-3</c:v>
                </c:pt>
                <c:pt idx="4">
                  <c:v>9.8588619999999995E-3</c:v>
                </c:pt>
                <c:pt idx="5">
                  <c:v>1.0830594000000001E-2</c:v>
                </c:pt>
                <c:pt idx="6">
                  <c:v>1.1896452E-2</c:v>
                </c:pt>
                <c:pt idx="7">
                  <c:v>1.3065211E-2</c:v>
                </c:pt>
                <c:pt idx="8">
                  <c:v>1.4346391999999999E-2</c:v>
                </c:pt>
                <c:pt idx="9">
                  <c:v>1.575031E-2</c:v>
                </c:pt>
                <c:pt idx="10">
                  <c:v>1.7288125000000001E-2</c:v>
                </c:pt>
                <c:pt idx="11">
                  <c:v>1.8971885000000001E-2</c:v>
                </c:pt>
                <c:pt idx="12">
                  <c:v>2.0814572999999999E-2</c:v>
                </c:pt>
                <c:pt idx="13">
                  <c:v>2.2830146999999999E-2</c:v>
                </c:pt>
                <c:pt idx="14">
                  <c:v>2.5033577000000001E-2</c:v>
                </c:pt>
                <c:pt idx="15">
                  <c:v>2.7440868E-2</c:v>
                </c:pt>
                <c:pt idx="16">
                  <c:v>3.0069077E-2</c:v>
                </c:pt>
                <c:pt idx="17">
                  <c:v>3.2936320999999998E-2</c:v>
                </c:pt>
                <c:pt idx="18">
                  <c:v>3.6061755000000001E-2</c:v>
                </c:pt>
                <c:pt idx="19">
                  <c:v>3.9465537000000002E-2</c:v>
                </c:pt>
                <c:pt idx="20">
                  <c:v>4.3168765999999997E-2</c:v>
                </c:pt>
                <c:pt idx="21">
                  <c:v>4.7193383999999998E-2</c:v>
                </c:pt>
                <c:pt idx="22">
                  <c:v>5.1562040000000003E-2</c:v>
                </c:pt>
                <c:pt idx="23">
                  <c:v>5.6297908000000001E-2</c:v>
                </c:pt>
                <c:pt idx="24">
                  <c:v>6.1424449999999998E-2</c:v>
                </c:pt>
                <c:pt idx="25">
                  <c:v>6.6965118000000004E-2</c:v>
                </c:pt>
                <c:pt idx="26">
                  <c:v>7.2942985000000002E-2</c:v>
                </c:pt>
                <c:pt idx="27">
                  <c:v>7.9380297000000002E-2</c:v>
                </c:pt>
                <c:pt idx="28">
                  <c:v>8.6297936000000006E-2</c:v>
                </c:pt>
                <c:pt idx="29">
                  <c:v>9.3714789000000007E-2</c:v>
                </c:pt>
                <c:pt idx="30">
                  <c:v>0.101647022</c:v>
                </c:pt>
                <c:pt idx="31">
                  <c:v>0.11010724099999999</c:v>
                </c:pt>
                <c:pt idx="32">
                  <c:v>0.11910356699999999</c:v>
                </c:pt>
                <c:pt idx="33">
                  <c:v>0.12863860099999999</c:v>
                </c:pt>
                <c:pt idx="34">
                  <c:v>0.138708317</c:v>
                </c:pt>
                <c:pt idx="35">
                  <c:v>0.149300882</c:v>
                </c:pt>
                <c:pt idx="36">
                  <c:v>0.16039545199999999</c:v>
                </c:pt>
                <c:pt idx="37">
                  <c:v>0.17196096499999999</c:v>
                </c:pt>
                <c:pt idx="38">
                  <c:v>0.18395498900000001</c:v>
                </c:pt>
                <c:pt idx="39">
                  <c:v>0.196322687</c:v>
                </c:pt>
                <c:pt idx="40">
                  <c:v>0.208995972</c:v>
                </c:pt>
                <c:pt idx="41">
                  <c:v>0.221892913</c:v>
                </c:pt>
                <c:pt idx="42">
                  <c:v>0.234917511</c:v>
                </c:pt>
                <c:pt idx="43">
                  <c:v>0.24795989399999999</c:v>
                </c:pt>
                <c:pt idx="44">
                  <c:v>0.26089703199999997</c:v>
                </c:pt>
                <c:pt idx="45">
                  <c:v>0.27359403500000001</c:v>
                </c:pt>
                <c:pt idx="46">
                  <c:v>0.28590607800000001</c:v>
                </c:pt>
                <c:pt idx="47">
                  <c:v>0.297680958</c:v>
                </c:pt>
                <c:pt idx="48">
                  <c:v>0.30876228300000003</c:v>
                </c:pt>
                <c:pt idx="49">
                  <c:v>0.31899319900000001</c:v>
                </c:pt>
                <c:pt idx="50">
                  <c:v>0.32822057100000002</c:v>
                </c:pt>
                <c:pt idx="51">
                  <c:v>0.33629943000000001</c:v>
                </c:pt>
                <c:pt idx="52">
                  <c:v>0.34309752199999999</c:v>
                </c:pt>
                <c:pt idx="53">
                  <c:v>0.34849970000000002</c:v>
                </c:pt>
                <c:pt idx="54">
                  <c:v>0.35241194999999997</c:v>
                </c:pt>
                <c:pt idx="55">
                  <c:v>0.35476479900000002</c:v>
                </c:pt>
                <c:pt idx="56">
                  <c:v>0.35551590100000002</c:v>
                </c:pt>
                <c:pt idx="57">
                  <c:v>0.35465164999999998</c:v>
                </c:pt>
                <c:pt idx="58">
                  <c:v>0.35218769999999999</c:v>
                </c:pt>
                <c:pt idx="59">
                  <c:v>0.34816836099999998</c:v>
                </c:pt>
                <c:pt idx="60">
                  <c:v>0.34266492500000001</c:v>
                </c:pt>
                <c:pt idx="61">
                  <c:v>0.33577300799999998</c:v>
                </c:pt>
                <c:pt idx="62">
                  <c:v>0.32760909300000002</c:v>
                </c:pt>
                <c:pt idx="63">
                  <c:v>0.31830647400000001</c:v>
                </c:pt>
                <c:pt idx="64">
                  <c:v>0.30801083899999998</c:v>
                </c:pt>
                <c:pt idx="65">
                  <c:v>0.29687572899999998</c:v>
                </c:pt>
                <c:pt idx="66">
                  <c:v>0.28505809700000001</c:v>
                </c:pt>
                <c:pt idx="67">
                  <c:v>0.27271415599999999</c:v>
                </c:pt>
                <c:pt idx="68">
                  <c:v>0.25999568899999997</c:v>
                </c:pt>
                <c:pt idx="69">
                  <c:v>0.24704690100000001</c:v>
                </c:pt>
                <c:pt idx="70">
                  <c:v>0.23400190400000001</c:v>
                </c:pt>
                <c:pt idx="71">
                  <c:v>0.22098283899999999</c:v>
                </c:pt>
                <c:pt idx="72">
                  <c:v>0.20809862400000001</c:v>
                </c:pt>
                <c:pt idx="73">
                  <c:v>0.195444272</c:v>
                </c:pt>
                <c:pt idx="74">
                  <c:v>0.18310072799999999</c:v>
                </c:pt>
                <c:pt idx="75">
                  <c:v>0.17113513</c:v>
                </c:pt>
                <c:pt idx="76">
                  <c:v>0.159601413</c:v>
                </c:pt>
                <c:pt idx="77">
                  <c:v>0.148541175</c:v>
                </c:pt>
                <c:pt idx="78">
                  <c:v>0.137984724</c:v>
                </c:pt>
                <c:pt idx="79">
                  <c:v>0.127952233</c:v>
                </c:pt>
                <c:pt idx="80">
                  <c:v>0.11845494500000001</c:v>
                </c:pt>
                <c:pt idx="81">
                  <c:v>0.109496386</c:v>
                </c:pt>
                <c:pt idx="82">
                  <c:v>0.10107353199999999</c:v>
                </c:pt>
                <c:pt idx="83">
                  <c:v>9.3177915E-2</c:v>
                </c:pt>
                <c:pt idx="84">
                  <c:v>8.5796648000000003E-2</c:v>
                </c:pt>
                <c:pt idx="85">
                  <c:v>7.8913349999999993E-2</c:v>
                </c:pt>
                <c:pt idx="86">
                  <c:v>7.2508972000000005E-2</c:v>
                </c:pt>
                <c:pt idx="87">
                  <c:v>6.6562515000000003E-2</c:v>
                </c:pt>
                <c:pt idx="88">
                  <c:v>6.1051660000000001E-2</c:v>
                </c:pt>
                <c:pt idx="89">
                  <c:v>5.5953294000000001E-2</c:v>
                </c:pt>
                <c:pt idx="90">
                  <c:v>5.1243952000000002E-2</c:v>
                </c:pt>
                <c:pt idx="91">
                  <c:v>4.6900182999999998E-2</c:v>
                </c:pt>
                <c:pt idx="92">
                  <c:v>4.2898843999999998E-2</c:v>
                </c:pt>
                <c:pt idx="93">
                  <c:v>3.9217329000000002E-2</c:v>
                </c:pt>
                <c:pt idx="94">
                  <c:v>3.5833753000000003E-2</c:v>
                </c:pt>
                <c:pt idx="95">
                  <c:v>3.2727078999999999E-2</c:v>
                </c:pt>
                <c:pt idx="96">
                  <c:v>2.9877218000000001E-2</c:v>
                </c:pt>
                <c:pt idx="97">
                  <c:v>2.7265086000000001E-2</c:v>
                </c:pt>
                <c:pt idx="98">
                  <c:v>2.4872641000000001E-2</c:v>
                </c:pt>
                <c:pt idx="99">
                  <c:v>2.2682900999999998E-2</c:v>
                </c:pt>
                <c:pt idx="100">
                  <c:v>2.0679930999999999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EC67-42F9-9DC7-2B4002AA8067}"/>
            </c:ext>
          </c:extLst>
        </c:ser>
        <c:ser>
          <c:idx val="8"/>
          <c:order val="8"/>
          <c:tx>
            <c:strRef>
              <c:f>Figure1!$BK$1</c:f>
              <c:strCache>
                <c:ptCount val="1"/>
                <c:pt idx="0">
                  <c:v>Have you been feeling hard to eat hard food?  </c:v>
                </c:pt>
              </c:strCache>
            </c:strRef>
          </c:tx>
          <c:spPr>
            <a:ln w="19050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K$2:$BK$102</c:f>
              <c:numCache>
                <c:formatCode>General</c:formatCode>
                <c:ptCount val="101"/>
                <c:pt idx="0">
                  <c:v>1.4011E-3</c:v>
                </c:pt>
                <c:pt idx="1">
                  <c:v>1.670431E-3</c:v>
                </c:pt>
                <c:pt idx="2">
                  <c:v>1.9841469999999999E-3</c:v>
                </c:pt>
                <c:pt idx="3">
                  <c:v>2.3486000000000002E-3</c:v>
                </c:pt>
                <c:pt idx="4">
                  <c:v>2.7710270000000001E-3</c:v>
                </c:pt>
                <c:pt idx="5">
                  <c:v>3.2596819999999999E-3</c:v>
                </c:pt>
                <c:pt idx="6">
                  <c:v>3.8239910000000001E-3</c:v>
                </c:pt>
                <c:pt idx="7">
                  <c:v>4.4747249999999997E-3</c:v>
                </c:pt>
                <c:pt idx="8">
                  <c:v>5.2241989999999997E-3</c:v>
                </c:pt>
                <c:pt idx="9">
                  <c:v>6.0864869999999998E-3</c:v>
                </c:pt>
                <c:pt idx="10">
                  <c:v>7.0776750000000003E-3</c:v>
                </c:pt>
                <c:pt idx="11">
                  <c:v>8.2161390000000008E-3</c:v>
                </c:pt>
                <c:pt idx="12">
                  <c:v>9.5228510000000006E-3</c:v>
                </c:pt>
                <c:pt idx="13">
                  <c:v>1.1021735E-2</c:v>
                </c:pt>
                <c:pt idx="14">
                  <c:v>1.2740039999999999E-2</c:v>
                </c:pt>
                <c:pt idx="15">
                  <c:v>1.4708778E-2</c:v>
                </c:pt>
                <c:pt idx="16">
                  <c:v>1.6963178999999998E-2</c:v>
                </c:pt>
                <c:pt idx="17">
                  <c:v>1.9543207999999999E-2</c:v>
                </c:pt>
                <c:pt idx="18">
                  <c:v>2.2494112E-2</c:v>
                </c:pt>
                <c:pt idx="19">
                  <c:v>2.5867000000000001E-2</c:v>
                </c:pt>
                <c:pt idx="20">
                  <c:v>2.9719461999999999E-2</c:v>
                </c:pt>
                <c:pt idx="21">
                  <c:v>3.4116197000000001E-2</c:v>
                </c:pt>
                <c:pt idx="22">
                  <c:v>3.9129636000000002E-2</c:v>
                </c:pt>
                <c:pt idx="23">
                  <c:v>4.4840547000000001E-2</c:v>
                </c:pt>
                <c:pt idx="24">
                  <c:v>5.1338564000000003E-2</c:v>
                </c:pt>
                <c:pt idx="25">
                  <c:v>5.8722609000000002E-2</c:v>
                </c:pt>
                <c:pt idx="26">
                  <c:v>6.7101132999999993E-2</c:v>
                </c:pt>
                <c:pt idx="27">
                  <c:v>7.6592091000000001E-2</c:v>
                </c:pt>
                <c:pt idx="28">
                  <c:v>8.7322552999999997E-2</c:v>
                </c:pt>
                <c:pt idx="29">
                  <c:v>9.9427808000000006E-2</c:v>
                </c:pt>
                <c:pt idx="30">
                  <c:v>0.113049817</c:v>
                </c:pt>
                <c:pt idx="31">
                  <c:v>0.12833480999999999</c:v>
                </c:pt>
                <c:pt idx="32">
                  <c:v>0.14542984</c:v>
                </c:pt>
                <c:pt idx="33">
                  <c:v>0.16447804799999999</c:v>
                </c:pt>
                <c:pt idx="34">
                  <c:v>0.18561242</c:v>
                </c:pt>
                <c:pt idx="35">
                  <c:v>0.208947828</c:v>
                </c:pt>
                <c:pt idx="36">
                  <c:v>0.23457120300000001</c:v>
                </c:pt>
                <c:pt idx="37">
                  <c:v>0.26252979599999998</c:v>
                </c:pt>
                <c:pt idx="38">
                  <c:v>0.29281764900000001</c:v>
                </c:pt>
                <c:pt idx="39">
                  <c:v>0.32536064199999998</c:v>
                </c:pt>
                <c:pt idx="40">
                  <c:v>0.36000078099999999</c:v>
                </c:pt>
                <c:pt idx="41">
                  <c:v>0.39648081499999999</c:v>
                </c:pt>
                <c:pt idx="42">
                  <c:v>0.43443062999999998</c:v>
                </c:pt>
                <c:pt idx="43">
                  <c:v>0.47335733400000002</c:v>
                </c:pt>
                <c:pt idx="44">
                  <c:v>0.51264122199999995</c:v>
                </c:pt>
                <c:pt idx="45">
                  <c:v>0.55153987599999998</c:v>
                </c:pt>
                <c:pt idx="46">
                  <c:v>0.58920249199999997</c:v>
                </c:pt>
                <c:pt idx="47">
                  <c:v>0.62469578000000003</c:v>
                </c:pt>
                <c:pt idx="48">
                  <c:v>0.65704173499999996</c:v>
                </c:pt>
                <c:pt idx="49">
                  <c:v>0.68526599499999996</c:v>
                </c:pt>
                <c:pt idx="50">
                  <c:v>0.70845374500000002</c:v>
                </c:pt>
                <c:pt idx="51">
                  <c:v>0.72580849000000003</c:v>
                </c:pt>
                <c:pt idx="52">
                  <c:v>0.73670772399999995</c:v>
                </c:pt>
                <c:pt idx="53">
                  <c:v>0.74074918099999998</c:v>
                </c:pt>
                <c:pt idx="54">
                  <c:v>0.737781927</c:v>
                </c:pt>
                <c:pt idx="55">
                  <c:v>0.72791826000000004</c:v>
                </c:pt>
                <c:pt idx="56">
                  <c:v>0.71152482699999997</c:v>
                </c:pt>
                <c:pt idx="57">
                  <c:v>0.68919413900000004</c:v>
                </c:pt>
                <c:pt idx="58">
                  <c:v>0.66170023</c:v>
                </c:pt>
                <c:pt idx="59">
                  <c:v>0.62994396399999997</c:v>
                </c:pt>
                <c:pt idx="60">
                  <c:v>0.59489434799999996</c:v>
                </c:pt>
                <c:pt idx="61">
                  <c:v>0.55753187299999996</c:v>
                </c:pt>
                <c:pt idx="62">
                  <c:v>0.51879882600000005</c:v>
                </c:pt>
                <c:pt idx="63">
                  <c:v>0.47955985600000001</c:v>
                </c:pt>
                <c:pt idx="64">
                  <c:v>0.44057431800000002</c:v>
                </c:pt>
                <c:pt idx="65">
                  <c:v>0.40248032</c:v>
                </c:pt>
                <c:pt idx="66">
                  <c:v>0.36578923299999999</c:v>
                </c:pt>
                <c:pt idx="67">
                  <c:v>0.33088867500000002</c:v>
                </c:pt>
                <c:pt idx="68">
                  <c:v>0.29805170800000003</c:v>
                </c:pt>
                <c:pt idx="69">
                  <c:v>0.26745001299999999</c:v>
                </c:pt>
                <c:pt idx="70">
                  <c:v>0.23916911699999999</c:v>
                </c:pt>
                <c:pt idx="71">
                  <c:v>0.21322412199999999</c:v>
                </c:pt>
                <c:pt idx="72">
                  <c:v>0.18957482</c:v>
                </c:pt>
                <c:pt idx="73">
                  <c:v>0.16813945</c:v>
                </c:pt>
                <c:pt idx="74">
                  <c:v>0.14880671100000001</c:v>
                </c:pt>
                <c:pt idx="75">
                  <c:v>0.131445861</c:v>
                </c:pt>
                <c:pt idx="76">
                  <c:v>0.115914948</c:v>
                </c:pt>
                <c:pt idx="77">
                  <c:v>0.10206728</c:v>
                </c:pt>
                <c:pt idx="78">
                  <c:v>8.9756372000000001E-2</c:v>
                </c:pt>
                <c:pt idx="79">
                  <c:v>7.8839566E-2</c:v>
                </c:pt>
                <c:pt idx="80">
                  <c:v>6.9180567999999998E-2</c:v>
                </c:pt>
                <c:pt idx="81">
                  <c:v>6.0651111000000001E-2</c:v>
                </c:pt>
                <c:pt idx="82">
                  <c:v>5.3131934999999998E-2</c:v>
                </c:pt>
                <c:pt idx="83">
                  <c:v>4.6513240999999997E-2</c:v>
                </c:pt>
                <c:pt idx="84">
                  <c:v>4.0694763000000002E-2</c:v>
                </c:pt>
                <c:pt idx="85">
                  <c:v>3.5585560000000002E-2</c:v>
                </c:pt>
                <c:pt idx="86">
                  <c:v>3.1103616000000001E-2</c:v>
                </c:pt>
                <c:pt idx="87">
                  <c:v>2.7175324000000001E-2</c:v>
                </c:pt>
                <c:pt idx="88">
                  <c:v>2.3734891000000001E-2</c:v>
                </c:pt>
                <c:pt idx="89">
                  <c:v>2.0723710999999999E-2</c:v>
                </c:pt>
                <c:pt idx="90">
                  <c:v>1.8089744000000001E-2</c:v>
                </c:pt>
                <c:pt idx="91">
                  <c:v>1.5786887999999999E-2</c:v>
                </c:pt>
                <c:pt idx="92">
                  <c:v>1.3774401E-2</c:v>
                </c:pt>
                <c:pt idx="93">
                  <c:v>1.201634E-2</c:v>
                </c:pt>
                <c:pt idx="94">
                  <c:v>1.0481048E-2</c:v>
                </c:pt>
                <c:pt idx="95">
                  <c:v>9.1406879999999992E-3</c:v>
                </c:pt>
                <c:pt idx="96">
                  <c:v>7.9708039999999997E-3</c:v>
                </c:pt>
                <c:pt idx="97">
                  <c:v>6.9499389999999996E-3</c:v>
                </c:pt>
                <c:pt idx="98">
                  <c:v>6.059282E-3</c:v>
                </c:pt>
                <c:pt idx="99">
                  <c:v>5.2823540000000004E-3</c:v>
                </c:pt>
                <c:pt idx="100">
                  <c:v>4.6047329999999997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EC67-42F9-9DC7-2B4002AA8067}"/>
            </c:ext>
          </c:extLst>
        </c:ser>
        <c:ser>
          <c:idx val="9"/>
          <c:order val="9"/>
          <c:tx>
            <c:strRef>
              <c:f>Figure1!$BL$1</c:f>
              <c:strCache>
                <c:ptCount val="1"/>
                <c:pt idx="0">
                  <c:v>Have you been spilling food from your mouth? </c:v>
                </c:pt>
              </c:strCache>
            </c:strRef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L$2:$BL$102</c:f>
              <c:numCache>
                <c:formatCode>0.00E+00</c:formatCode>
                <c:ptCount val="101"/>
                <c:pt idx="0">
                  <c:v>1.0434570000000001E-10</c:v>
                </c:pt>
                <c:pt idx="1">
                  <c:v>1.5954440000000001E-10</c:v>
                </c:pt>
                <c:pt idx="2">
                  <c:v>2.439428E-10</c:v>
                </c:pt>
                <c:pt idx="3">
                  <c:v>3.7298709999999998E-10</c:v>
                </c:pt>
                <c:pt idx="4">
                  <c:v>5.7029400000000004E-10</c:v>
                </c:pt>
                <c:pt idx="5">
                  <c:v>8.7197230000000005E-10</c:v>
                </c:pt>
                <c:pt idx="6">
                  <c:v>1.3332310000000001E-9</c:v>
                </c:pt>
                <c:pt idx="7">
                  <c:v>2.0384800000000002E-9</c:v>
                </c:pt>
                <c:pt idx="8">
                  <c:v>3.1167750000000001E-9</c:v>
                </c:pt>
                <c:pt idx="9">
                  <c:v>4.7654299999999997E-9</c:v>
                </c:pt>
                <c:pt idx="10">
                  <c:v>7.2861089999999999E-9</c:v>
                </c:pt>
                <c:pt idx="11">
                  <c:v>1.1140010000000001E-8</c:v>
                </c:pt>
                <c:pt idx="12">
                  <c:v>1.7032210000000001E-8</c:v>
                </c:pt>
                <c:pt idx="13">
                  <c:v>2.604057E-8</c:v>
                </c:pt>
                <c:pt idx="14">
                  <c:v>3.9812829999999999E-8</c:v>
                </c:pt>
                <c:pt idx="15">
                  <c:v>6.0867710000000006E-8</c:v>
                </c:pt>
                <c:pt idx="16">
                  <c:v>9.3055069999999998E-8</c:v>
                </c:pt>
                <c:pt idx="17">
                  <c:v>1.42259E-7</c:v>
                </c:pt>
                <c:pt idx="18">
                  <c:v>2.17472E-7</c:v>
                </c:pt>
                <c:pt idx="19">
                  <c:v>3.3243470000000002E-7</c:v>
                </c:pt>
                <c:pt idx="20">
                  <c:v>5.0814100000000002E-7</c:v>
                </c:pt>
                <c:pt idx="21">
                  <c:v>7.7666049999999998E-7</c:v>
                </c:pt>
                <c:pt idx="22">
                  <c:v>1.18697E-6</c:v>
                </c:pt>
                <c:pt idx="23">
                  <c:v>1.813848E-6</c:v>
                </c:pt>
                <c:pt idx="24">
                  <c:v>2.7714280000000002E-6</c:v>
                </c:pt>
                <c:pt idx="25">
                  <c:v>4.2338360000000002E-6</c:v>
                </c:pt>
                <c:pt idx="26">
                  <c:v>6.4665879999999997E-6</c:v>
                </c:pt>
                <c:pt idx="27">
                  <c:v>9.8742969999999998E-6</c:v>
                </c:pt>
                <c:pt idx="28">
                  <c:v>1.507306E-5</c:v>
                </c:pt>
                <c:pt idx="29">
                  <c:v>2.3000060000000001E-5</c:v>
                </c:pt>
                <c:pt idx="30">
                  <c:v>3.5079249999999998E-5</c:v>
                </c:pt>
                <c:pt idx="31">
                  <c:v>5.3470890000000003E-5</c:v>
                </c:pt>
                <c:pt idx="32">
                  <c:v>8.1446459999999997E-5</c:v>
                </c:pt>
                <c:pt idx="33">
                  <c:v>1.2394899999999999E-4</c:v>
                </c:pt>
                <c:pt idx="34">
                  <c:v>1.884272E-4</c:v>
                </c:pt>
                <c:pt idx="35">
                  <c:v>2.8606710000000002E-4</c:v>
                </c:pt>
                <c:pt idx="36">
                  <c:v>4.3359969999999997E-4</c:v>
                </c:pt>
                <c:pt idx="37">
                  <c:v>6.55924E-4</c:v>
                </c:pt>
                <c:pt idx="38">
                  <c:v>9.8987129999999991E-4</c:v>
                </c:pt>
                <c:pt idx="39">
                  <c:v>1.4895259999999999E-3</c:v>
                </c:pt>
                <c:pt idx="40">
                  <c:v>2.2336080000000002E-3</c:v>
                </c:pt>
                <c:pt idx="41">
                  <c:v>3.3354980000000001E-3</c:v>
                </c:pt>
                <c:pt idx="42">
                  <c:v>4.9564630000000004E-3</c:v>
                </c:pt>
                <c:pt idx="43">
                  <c:v>7.3225249999999999E-3</c:v>
                </c:pt>
                <c:pt idx="44">
                  <c:v>1.0745070000000001E-2</c:v>
                </c:pt>
                <c:pt idx="45">
                  <c:v>1.5644680000000001E-2</c:v>
                </c:pt>
                <c:pt idx="46">
                  <c:v>2.257675E-2</c:v>
                </c:pt>
                <c:pt idx="47">
                  <c:v>3.2256439999999997E-2</c:v>
                </c:pt>
                <c:pt idx="48">
                  <c:v>4.5579130000000002E-2</c:v>
                </c:pt>
                <c:pt idx="49">
                  <c:v>6.3632049999999996E-2</c:v>
                </c:pt>
                <c:pt idx="50">
                  <c:v>8.7692019999999996E-2</c:v>
                </c:pt>
                <c:pt idx="51">
                  <c:v>0.1192048</c:v>
                </c:pt>
                <c:pt idx="52">
                  <c:v>0.1597412</c:v>
                </c:pt>
                <c:pt idx="53">
                  <c:v>0.21092640000000001</c:v>
                </c:pt>
                <c:pt idx="54">
                  <c:v>0.27433580000000002</c:v>
                </c:pt>
                <c:pt idx="55">
                  <c:v>0.35135119999999997</c:v>
                </c:pt>
                <c:pt idx="56">
                  <c:v>0.44296960000000002</c:v>
                </c:pt>
                <c:pt idx="57">
                  <c:v>0.54955949999999998</c:v>
                </c:pt>
                <c:pt idx="58">
                  <c:v>0.67057020000000001</c:v>
                </c:pt>
                <c:pt idx="59">
                  <c:v>0.80421580000000004</c:v>
                </c:pt>
                <c:pt idx="60">
                  <c:v>0.94718559999999996</c:v>
                </c:pt>
                <c:pt idx="61">
                  <c:v>1.0944609999999999</c:v>
                </c:pt>
                <c:pt idx="62">
                  <c:v>1.239341</c:v>
                </c:pt>
                <c:pt idx="63">
                  <c:v>1.3737839999999999</c:v>
                </c:pt>
                <c:pt idx="64">
                  <c:v>1.489106</c:v>
                </c:pt>
                <c:pt idx="65">
                  <c:v>1.577013</c:v>
                </c:pt>
                <c:pt idx="66">
                  <c:v>1.6307849999999999</c:v>
                </c:pt>
                <c:pt idx="67">
                  <c:v>1.6463589999999999</c:v>
                </c:pt>
                <c:pt idx="68">
                  <c:v>1.623014</c:v>
                </c:pt>
                <c:pt idx="69">
                  <c:v>1.563464</c:v>
                </c:pt>
                <c:pt idx="70">
                  <c:v>1.4733309999999999</c:v>
                </c:pt>
                <c:pt idx="71">
                  <c:v>1.3601589999999999</c:v>
                </c:pt>
                <c:pt idx="72">
                  <c:v>1.232246</c:v>
                </c:pt>
                <c:pt idx="73">
                  <c:v>1.097569</c:v>
                </c:pt>
                <c:pt idx="74">
                  <c:v>0.96299809999999997</c:v>
                </c:pt>
                <c:pt idx="75">
                  <c:v>0.83386890000000002</c:v>
                </c:pt>
                <c:pt idx="76">
                  <c:v>0.71388470000000004</c:v>
                </c:pt>
                <c:pt idx="77">
                  <c:v>0.60525079999999998</c:v>
                </c:pt>
                <c:pt idx="78">
                  <c:v>0.50894110000000004</c:v>
                </c:pt>
                <c:pt idx="79">
                  <c:v>0.42500769999999999</c:v>
                </c:pt>
                <c:pt idx="80">
                  <c:v>0.35287479999999999</c:v>
                </c:pt>
                <c:pt idx="81">
                  <c:v>0.29158539999999999</c:v>
                </c:pt>
                <c:pt idx="82">
                  <c:v>0.2399906</c:v>
                </c:pt>
                <c:pt idx="83">
                  <c:v>0.1968839</c:v>
                </c:pt>
                <c:pt idx="84">
                  <c:v>0.16108980000000001</c:v>
                </c:pt>
                <c:pt idx="85">
                  <c:v>0.13151599999999999</c:v>
                </c:pt>
                <c:pt idx="86">
                  <c:v>0.1071804</c:v>
                </c:pt>
                <c:pt idx="87">
                  <c:v>8.7221290000000007E-2</c:v>
                </c:pt>
                <c:pt idx="88">
                  <c:v>7.0895189999999997E-2</c:v>
                </c:pt>
                <c:pt idx="89">
                  <c:v>5.7569750000000003E-2</c:v>
                </c:pt>
                <c:pt idx="90">
                  <c:v>4.6712549999999999E-2</c:v>
                </c:pt>
                <c:pt idx="91">
                  <c:v>3.7878990000000001E-2</c:v>
                </c:pt>
                <c:pt idx="92">
                  <c:v>3.0700149999999999E-2</c:v>
                </c:pt>
                <c:pt idx="93">
                  <c:v>2.4871520000000001E-2</c:v>
                </c:pt>
                <c:pt idx="94">
                  <c:v>2.0142710000000001E-2</c:v>
                </c:pt>
                <c:pt idx="95">
                  <c:v>1.6308550000000002E-2</c:v>
                </c:pt>
                <c:pt idx="96">
                  <c:v>1.3201299999999999E-2</c:v>
                </c:pt>
                <c:pt idx="97">
                  <c:v>1.068417E-2</c:v>
                </c:pt>
                <c:pt idx="98">
                  <c:v>8.6457329999999992E-3</c:v>
                </c:pt>
                <c:pt idx="99">
                  <c:v>6.9953940000000003E-3</c:v>
                </c:pt>
                <c:pt idx="100">
                  <c:v>5.6595439999999999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EC67-42F9-9DC7-2B4002AA8067}"/>
            </c:ext>
          </c:extLst>
        </c:ser>
        <c:ser>
          <c:idx val="10"/>
          <c:order val="10"/>
          <c:tx>
            <c:strRef>
              <c:f>Figure1!$BM$1</c:f>
              <c:strCache>
                <c:ptCount val="1"/>
                <c:pt idx="0">
                  <c:v>Does food remains in my mouth?  </c:v>
                </c:pt>
              </c:strCache>
            </c:strRef>
          </c:tx>
          <c:spPr>
            <a:ln w="19050" cap="rnd">
              <a:solidFill>
                <a:srgbClr val="0070C0"/>
              </a:solidFill>
              <a:prstDash val="lgDash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M$2:$BM$102</c:f>
              <c:numCache>
                <c:formatCode>0.00E+00</c:formatCode>
                <c:ptCount val="101"/>
                <c:pt idx="0">
                  <c:v>1.2470750000000001E-5</c:v>
                </c:pt>
                <c:pt idx="1">
                  <c:v>1.7394220000000002E-5</c:v>
                </c:pt>
                <c:pt idx="2">
                  <c:v>2.40227E-5</c:v>
                </c:pt>
                <c:pt idx="3">
                  <c:v>3.2839380000000001E-5</c:v>
                </c:pt>
                <c:pt idx="4">
                  <c:v>4.4428690000000003E-5</c:v>
                </c:pt>
                <c:pt idx="5">
                  <c:v>5.949211E-5</c:v>
                </c:pt>
                <c:pt idx="6">
                  <c:v>7.8868550000000002E-5</c:v>
                </c:pt>
                <c:pt idx="7">
                  <c:v>1.0356159999999999E-4</c:v>
                </c:pt>
                <c:pt idx="8">
                  <c:v>1.347756E-4</c:v>
                </c:pt>
                <c:pt idx="9">
                  <c:v>1.7396220000000001E-4</c:v>
                </c:pt>
                <c:pt idx="10">
                  <c:v>2.228803E-4</c:v>
                </c:pt>
                <c:pt idx="11">
                  <c:v>2.8366989999999999E-4</c:v>
                </c:pt>
                <c:pt idx="12">
                  <c:v>3.5894410000000002E-4</c:v>
                </c:pt>
                <c:pt idx="13">
                  <c:v>4.519007E-4</c:v>
                </c:pt>
                <c:pt idx="14">
                  <c:v>5.6645860000000003E-4</c:v>
                </c:pt>
                <c:pt idx="15">
                  <c:v>7.0742419999999997E-4</c:v>
                </c:pt>
                <c:pt idx="16">
                  <c:v>8.8069340000000002E-4</c:v>
                </c:pt>
                <c:pt idx="17">
                  <c:v>1.0934989999999999E-3</c:v>
                </c:pt>
                <c:pt idx="18">
                  <c:v>1.354711E-3</c:v>
                </c:pt>
                <c:pt idx="19">
                  <c:v>1.6752080000000001E-3</c:v>
                </c:pt>
                <c:pt idx="20">
                  <c:v>2.0683229999999999E-3</c:v>
                </c:pt>
                <c:pt idx="21">
                  <c:v>2.5503980000000002E-3</c:v>
                </c:pt>
                <c:pt idx="22">
                  <c:v>3.1414540000000001E-3</c:v>
                </c:pt>
                <c:pt idx="23">
                  <c:v>3.8660130000000002E-3</c:v>
                </c:pt>
                <c:pt idx="24">
                  <c:v>4.7540940000000004E-3</c:v>
                </c:pt>
                <c:pt idx="25">
                  <c:v>5.8424369999999998E-3</c:v>
                </c:pt>
                <c:pt idx="26">
                  <c:v>7.1759830000000004E-3</c:v>
                </c:pt>
                <c:pt idx="27">
                  <c:v>8.8096700000000003E-3</c:v>
                </c:pt>
                <c:pt idx="28">
                  <c:v>1.081061E-2</c:v>
                </c:pt>
                <c:pt idx="29">
                  <c:v>1.326072E-2</c:v>
                </c:pt>
                <c:pt idx="30">
                  <c:v>1.6259889999999999E-2</c:v>
                </c:pt>
                <c:pt idx="31">
                  <c:v>1.992973E-2</c:v>
                </c:pt>
                <c:pt idx="32">
                  <c:v>2.441811E-2</c:v>
                </c:pt>
                <c:pt idx="33">
                  <c:v>2.9904440000000001E-2</c:v>
                </c:pt>
                <c:pt idx="34">
                  <c:v>3.6605909999999998E-2</c:v>
                </c:pt>
                <c:pt idx="35">
                  <c:v>4.4784589999999999E-2</c:v>
                </c:pt>
                <c:pt idx="36">
                  <c:v>5.4755579999999998E-2</c:v>
                </c:pt>
                <c:pt idx="37">
                  <c:v>6.6895999999999997E-2</c:v>
                </c:pt>
                <c:pt idx="38">
                  <c:v>8.1654519999999994E-2</c:v>
                </c:pt>
                <c:pt idx="39">
                  <c:v>9.95611E-2</c:v>
                </c:pt>
                <c:pt idx="40">
                  <c:v>0.12123589999999999</c:v>
                </c:pt>
                <c:pt idx="41">
                  <c:v>0.14739640000000001</c:v>
                </c:pt>
                <c:pt idx="42">
                  <c:v>0.1788595</c:v>
                </c:pt>
                <c:pt idx="43">
                  <c:v>0.21653749999999999</c:v>
                </c:pt>
                <c:pt idx="44">
                  <c:v>0.26142149999999997</c:v>
                </c:pt>
                <c:pt idx="45">
                  <c:v>0.31454870000000001</c:v>
                </c:pt>
                <c:pt idx="46">
                  <c:v>0.37694460000000002</c:v>
                </c:pt>
                <c:pt idx="47">
                  <c:v>0.44953530000000003</c:v>
                </c:pt>
                <c:pt idx="48">
                  <c:v>0.53301969999999999</c:v>
                </c:pt>
                <c:pt idx="49">
                  <c:v>0.62770020000000004</c:v>
                </c:pt>
                <c:pt idx="50">
                  <c:v>0.73327160000000002</c:v>
                </c:pt>
                <c:pt idx="51">
                  <c:v>0.84858449999999996</c:v>
                </c:pt>
                <c:pt idx="52">
                  <c:v>0.97141140000000004</c:v>
                </c:pt>
                <c:pt idx="53">
                  <c:v>1.098268</c:v>
                </c:pt>
                <c:pt idx="54">
                  <c:v>1.2243550000000001</c:v>
                </c:pt>
                <c:pt idx="55">
                  <c:v>1.3436999999999999</c:v>
                </c:pt>
                <c:pt idx="56">
                  <c:v>1.449551</c:v>
                </c:pt>
                <c:pt idx="57">
                  <c:v>1.5350250000000001</c:v>
                </c:pt>
                <c:pt idx="58">
                  <c:v>1.593955</c:v>
                </c:pt>
                <c:pt idx="59">
                  <c:v>1.621772</c:v>
                </c:pt>
                <c:pt idx="60">
                  <c:v>1.6162300000000001</c:v>
                </c:pt>
                <c:pt idx="61">
                  <c:v>1.5777829999999999</c:v>
                </c:pt>
                <c:pt idx="62">
                  <c:v>1.5095019999999999</c:v>
                </c:pt>
                <c:pt idx="63">
                  <c:v>1.416577</c:v>
                </c:pt>
                <c:pt idx="64">
                  <c:v>1.3055110000000001</c:v>
                </c:pt>
                <c:pt idx="65">
                  <c:v>1.183227</c:v>
                </c:pt>
                <c:pt idx="66">
                  <c:v>1.0562830000000001</c:v>
                </c:pt>
                <c:pt idx="67">
                  <c:v>0.93029379999999995</c:v>
                </c:pt>
                <c:pt idx="68">
                  <c:v>0.80962849999999997</c:v>
                </c:pt>
                <c:pt idx="69">
                  <c:v>0.69734359999999995</c:v>
                </c:pt>
                <c:pt idx="70">
                  <c:v>0.59528700000000001</c:v>
                </c:pt>
                <c:pt idx="71">
                  <c:v>0.50430319999999995</c:v>
                </c:pt>
                <c:pt idx="72">
                  <c:v>0.4244713</c:v>
                </c:pt>
                <c:pt idx="73">
                  <c:v>0.35533690000000001</c:v>
                </c:pt>
                <c:pt idx="74">
                  <c:v>0.29610950000000003</c:v>
                </c:pt>
                <c:pt idx="75">
                  <c:v>0.24581829999999999</c:v>
                </c:pt>
                <c:pt idx="76">
                  <c:v>0.20342569999999999</c:v>
                </c:pt>
                <c:pt idx="77">
                  <c:v>0.1679049</c:v>
                </c:pt>
                <c:pt idx="78">
                  <c:v>0.1382881</c:v>
                </c:pt>
                <c:pt idx="79">
                  <c:v>0.1136934</c:v>
                </c:pt>
                <c:pt idx="80">
                  <c:v>9.3336550000000004E-2</c:v>
                </c:pt>
                <c:pt idx="81">
                  <c:v>7.6532810000000007E-2</c:v>
                </c:pt>
                <c:pt idx="82">
                  <c:v>6.2692659999999997E-2</c:v>
                </c:pt>
                <c:pt idx="83">
                  <c:v>5.1314029999999997E-2</c:v>
                </c:pt>
                <c:pt idx="84">
                  <c:v>4.197294E-2</c:v>
                </c:pt>
                <c:pt idx="85">
                  <c:v>3.4313780000000002E-2</c:v>
                </c:pt>
                <c:pt idx="86">
                  <c:v>2.8039890000000001E-2</c:v>
                </c:pt>
                <c:pt idx="87">
                  <c:v>2.2904859999999999E-2</c:v>
                </c:pt>
                <c:pt idx="88">
                  <c:v>1.8704720000000001E-2</c:v>
                </c:pt>
                <c:pt idx="89">
                  <c:v>1.5271099999999999E-2</c:v>
                </c:pt>
                <c:pt idx="90">
                  <c:v>1.246535E-2</c:v>
                </c:pt>
                <c:pt idx="91">
                  <c:v>1.017347E-2</c:v>
                </c:pt>
                <c:pt idx="92">
                  <c:v>8.3018859999999996E-3</c:v>
                </c:pt>
                <c:pt idx="93">
                  <c:v>6.7738909999999998E-3</c:v>
                </c:pt>
                <c:pt idx="94">
                  <c:v>5.5266489999999998E-3</c:v>
                </c:pt>
                <c:pt idx="95">
                  <c:v>4.5087349999999998E-3</c:v>
                </c:pt>
                <c:pt idx="96">
                  <c:v>3.6780910000000001E-3</c:v>
                </c:pt>
                <c:pt idx="97">
                  <c:v>3.0003339999999999E-3</c:v>
                </c:pt>
                <c:pt idx="98">
                  <c:v>2.4473720000000002E-3</c:v>
                </c:pt>
                <c:pt idx="99">
                  <c:v>1.9962589999999998E-3</c:v>
                </c:pt>
                <c:pt idx="100">
                  <c:v>1.6282549999999999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EC67-42F9-9DC7-2B4002AA8067}"/>
            </c:ext>
          </c:extLst>
        </c:ser>
        <c:ser>
          <c:idx val="11"/>
          <c:order val="11"/>
          <c:tx>
            <c:strRef>
              <c:f>Figure1!$BN$1</c:f>
              <c:strCache>
                <c:ptCount val="1"/>
                <c:pt idx="0">
                  <c:v>Have you experience reverse flow form stomach? </c:v>
                </c:pt>
              </c:strCache>
            </c:strRef>
          </c:tx>
          <c:spPr>
            <a:ln w="19050" cap="rnd">
              <a:solidFill>
                <a:srgbClr val="0070C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N$2:$BN$102</c:f>
              <c:numCache>
                <c:formatCode>0.00E+00</c:formatCode>
                <c:ptCount val="101"/>
                <c:pt idx="0">
                  <c:v>2.4698670000000002E-102</c:v>
                </c:pt>
                <c:pt idx="1">
                  <c:v>7.5570459999999997E-101</c:v>
                </c:pt>
                <c:pt idx="2">
                  <c:v>2.3122270000000002E-99</c:v>
                </c:pt>
                <c:pt idx="3">
                  <c:v>7.0747169999999996E-98</c:v>
                </c:pt>
                <c:pt idx="4">
                  <c:v>2.1646489999999998E-96</c:v>
                </c:pt>
                <c:pt idx="5">
                  <c:v>6.6231719999999999E-95</c:v>
                </c:pt>
                <c:pt idx="6">
                  <c:v>2.0264899999999999E-93</c:v>
                </c:pt>
                <c:pt idx="7">
                  <c:v>6.2004469999999999E-92</c:v>
                </c:pt>
                <c:pt idx="8">
                  <c:v>1.8971489999999999E-90</c:v>
                </c:pt>
                <c:pt idx="9">
                  <c:v>5.804703E-89</c:v>
                </c:pt>
                <c:pt idx="10">
                  <c:v>1.7760639999999999E-87</c:v>
                </c:pt>
                <c:pt idx="11">
                  <c:v>5.4342169999999997E-86</c:v>
                </c:pt>
                <c:pt idx="12">
                  <c:v>1.6627059999999999E-84</c:v>
                </c:pt>
                <c:pt idx="13">
                  <c:v>5.0873780000000003E-83</c:v>
                </c:pt>
                <c:pt idx="14">
                  <c:v>1.556584E-81</c:v>
                </c:pt>
                <c:pt idx="15">
                  <c:v>4.7626750000000002E-80</c:v>
                </c:pt>
                <c:pt idx="16">
                  <c:v>1.4572349999999999E-78</c:v>
                </c:pt>
                <c:pt idx="17">
                  <c:v>4.4586969999999998E-77</c:v>
                </c:pt>
                <c:pt idx="18">
                  <c:v>1.3642259999999999E-75</c:v>
                </c:pt>
                <c:pt idx="19">
                  <c:v>4.1741200000000003E-74</c:v>
                </c:pt>
                <c:pt idx="20">
                  <c:v>1.2771549999999999E-72</c:v>
                </c:pt>
                <c:pt idx="21">
                  <c:v>3.9077069999999997E-71</c:v>
                </c:pt>
                <c:pt idx="22">
                  <c:v>1.1956399999999999E-69</c:v>
                </c:pt>
                <c:pt idx="23">
                  <c:v>3.658297E-68</c:v>
                </c:pt>
                <c:pt idx="24">
                  <c:v>1.119328E-66</c:v>
                </c:pt>
                <c:pt idx="25">
                  <c:v>3.4248060000000001E-65</c:v>
                </c:pt>
                <c:pt idx="26">
                  <c:v>1.0478870000000001E-63</c:v>
                </c:pt>
                <c:pt idx="27">
                  <c:v>3.2062169999999998E-62</c:v>
                </c:pt>
                <c:pt idx="28">
                  <c:v>9.8100540000000002E-61</c:v>
                </c:pt>
                <c:pt idx="29">
                  <c:v>3.0015800000000002E-59</c:v>
                </c:pt>
                <c:pt idx="30">
                  <c:v>9.1839259999999997E-58</c:v>
                </c:pt>
                <c:pt idx="31">
                  <c:v>2.8100040000000001E-56</c:v>
                </c:pt>
                <c:pt idx="32">
                  <c:v>8.5977609999999993E-55</c:v>
                </c:pt>
                <c:pt idx="33">
                  <c:v>2.6306549999999999E-53</c:v>
                </c:pt>
                <c:pt idx="34">
                  <c:v>8.0490080000000001E-52</c:v>
                </c:pt>
                <c:pt idx="35">
                  <c:v>2.4627529999999998E-50</c:v>
                </c:pt>
                <c:pt idx="36">
                  <c:v>7.5352789999999999E-49</c:v>
                </c:pt>
                <c:pt idx="37">
                  <c:v>2.305568E-47</c:v>
                </c:pt>
                <c:pt idx="38">
                  <c:v>7.0543389999999993E-46</c:v>
                </c:pt>
                <c:pt idx="39">
                  <c:v>2.1584140000000001E-44</c:v>
                </c:pt>
                <c:pt idx="40">
                  <c:v>6.6040949999999998E-43</c:v>
                </c:pt>
                <c:pt idx="41">
                  <c:v>2.020653E-41</c:v>
                </c:pt>
                <c:pt idx="42">
                  <c:v>6.1825879999999998E-40</c:v>
                </c:pt>
                <c:pt idx="43">
                  <c:v>1.8916849999999999E-38</c:v>
                </c:pt>
                <c:pt idx="44">
                  <c:v>5.7879839999999997E-37</c:v>
                </c:pt>
                <c:pt idx="45">
                  <c:v>1.770948E-35</c:v>
                </c:pt>
                <c:pt idx="46">
                  <c:v>5.4185649999999998E-34</c:v>
                </c:pt>
                <c:pt idx="47">
                  <c:v>1.6579169999999999E-32</c:v>
                </c:pt>
                <c:pt idx="48">
                  <c:v>5.0727239999999999E-31</c:v>
                </c:pt>
                <c:pt idx="49">
                  <c:v>1.5521E-29</c:v>
                </c:pt>
                <c:pt idx="50">
                  <c:v>4.7489570000000003E-28</c:v>
                </c:pt>
                <c:pt idx="51">
                  <c:v>1.4530370000000001E-26</c:v>
                </c:pt>
                <c:pt idx="52">
                  <c:v>4.4458549999999996E-25</c:v>
                </c:pt>
                <c:pt idx="53">
                  <c:v>1.3602969999999999E-23</c:v>
                </c:pt>
                <c:pt idx="54">
                  <c:v>4.1620970000000002E-22</c:v>
                </c:pt>
                <c:pt idx="55">
                  <c:v>1.2734760000000001E-20</c:v>
                </c:pt>
                <c:pt idx="56">
                  <c:v>3.896451E-19</c:v>
                </c:pt>
                <c:pt idx="57">
                  <c:v>1.192196E-17</c:v>
                </c:pt>
                <c:pt idx="58">
                  <c:v>3.6477600000000001E-16</c:v>
                </c:pt>
                <c:pt idx="59">
                  <c:v>1.116104E-14</c:v>
                </c:pt>
                <c:pt idx="60">
                  <c:v>3.4149409999999999E-13</c:v>
                </c:pt>
                <c:pt idx="61">
                  <c:v>1.0448680000000001E-11</c:v>
                </c:pt>
                <c:pt idx="62">
                  <c:v>3.1969700000000002E-10</c:v>
                </c:pt>
                <c:pt idx="63">
                  <c:v>9.7815870000000002E-9</c:v>
                </c:pt>
                <c:pt idx="64">
                  <c:v>2.9925770000000002E-7</c:v>
                </c:pt>
                <c:pt idx="65">
                  <c:v>9.1514229999999997E-6</c:v>
                </c:pt>
                <c:pt idx="66">
                  <c:v>2.7916969999999998E-4</c:v>
                </c:pt>
                <c:pt idx="67">
                  <c:v>8.4026799999999992E-3</c:v>
                </c:pt>
                <c:pt idx="68">
                  <c:v>0.23564350000000001</c:v>
                </c:pt>
                <c:pt idx="69">
                  <c:v>4.8402950000000002</c:v>
                </c:pt>
                <c:pt idx="70">
                  <c:v>42.996830000000003</c:v>
                </c:pt>
                <c:pt idx="71">
                  <c:v>101.19840000000001</c:v>
                </c:pt>
                <c:pt idx="72">
                  <c:v>53.581009999999999</c:v>
                </c:pt>
                <c:pt idx="73">
                  <c:v>12.65906</c:v>
                </c:pt>
                <c:pt idx="74">
                  <c:v>2.4111720000000001</c:v>
                </c:pt>
                <c:pt idx="75">
                  <c:v>0.44009540000000003</c:v>
                </c:pt>
                <c:pt idx="76">
                  <c:v>7.970054E-2</c:v>
                </c:pt>
                <c:pt idx="77">
                  <c:v>1.441313E-2</c:v>
                </c:pt>
                <c:pt idx="78">
                  <c:v>2.6058159999999999E-3</c:v>
                </c:pt>
                <c:pt idx="79">
                  <c:v>4.710955E-4</c:v>
                </c:pt>
                <c:pt idx="80">
                  <c:v>8.5166839999999995E-5</c:v>
                </c:pt>
                <c:pt idx="81">
                  <c:v>1.539683E-5</c:v>
                </c:pt>
                <c:pt idx="82">
                  <c:v>2.7835059999999999E-6</c:v>
                </c:pt>
                <c:pt idx="83">
                  <c:v>5.0321419999999995E-7</c:v>
                </c:pt>
                <c:pt idx="84">
                  <c:v>9.097328E-8</c:v>
                </c:pt>
                <c:pt idx="85">
                  <c:v>1.6446520000000001E-8</c:v>
                </c:pt>
                <c:pt idx="86">
                  <c:v>2.9732929999999999E-9</c:v>
                </c:pt>
                <c:pt idx="87">
                  <c:v>5.3746139999999995E-10</c:v>
                </c:pt>
                <c:pt idx="88">
                  <c:v>9.7138919999999997E-11</c:v>
                </c:pt>
                <c:pt idx="89">
                  <c:v>1.7509370000000001E-11</c:v>
                </c:pt>
                <c:pt idx="90">
                  <c:v>3.1466109999999998E-12</c:v>
                </c:pt>
                <c:pt idx="91">
                  <c:v>5.5826959999999997E-13</c:v>
                </c:pt>
                <c:pt idx="92">
                  <c:v>1.015036E-13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EC67-42F9-9DC7-2B4002AA8067}"/>
            </c:ext>
          </c:extLst>
        </c:ser>
        <c:ser>
          <c:idx val="12"/>
          <c:order val="12"/>
          <c:tx>
            <c:strRef>
              <c:f>Figure1!$BO$1</c:f>
              <c:strCache>
                <c:ptCount val="1"/>
                <c:pt idx="0">
                  <c:v>Have you feel food left in your chest or feel clogged up? 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O$2:$BO$102</c:f>
              <c:numCache>
                <c:formatCode>0.00E+00</c:formatCode>
                <c:ptCount val="101"/>
                <c:pt idx="0">
                  <c:v>8.2709170000000001E-10</c:v>
                </c:pt>
                <c:pt idx="1">
                  <c:v>1.4268999999999999E-9</c:v>
                </c:pt>
                <c:pt idx="2">
                  <c:v>2.4609510000000002E-9</c:v>
                </c:pt>
                <c:pt idx="3">
                  <c:v>4.2426940000000004E-9</c:v>
                </c:pt>
                <c:pt idx="4">
                  <c:v>7.3106600000000001E-9</c:v>
                </c:pt>
                <c:pt idx="5">
                  <c:v>1.258864E-8</c:v>
                </c:pt>
                <c:pt idx="6">
                  <c:v>2.1658010000000001E-8</c:v>
                </c:pt>
                <c:pt idx="7">
                  <c:v>3.7218569999999999E-8</c:v>
                </c:pt>
                <c:pt idx="8">
                  <c:v>6.3863360000000003E-8</c:v>
                </c:pt>
                <c:pt idx="9">
                  <c:v>1.0937099999999999E-7</c:v>
                </c:pt>
                <c:pt idx="10">
                  <c:v>1.8683769999999999E-7</c:v>
                </c:pt>
                <c:pt idx="11">
                  <c:v>3.1814769999999999E-7</c:v>
                </c:pt>
                <c:pt idx="12">
                  <c:v>5.3951969999999997E-7</c:v>
                </c:pt>
                <c:pt idx="13">
                  <c:v>9.1017260000000001E-7</c:v>
                </c:pt>
                <c:pt idx="14">
                  <c:v>1.525476E-6</c:v>
                </c:pt>
                <c:pt idx="15">
                  <c:v>2.5361819999999999E-6</c:v>
                </c:pt>
                <c:pt idx="16">
                  <c:v>4.1753020000000001E-6</c:v>
                </c:pt>
                <c:pt idx="17">
                  <c:v>6.7936539999999999E-6</c:v>
                </c:pt>
                <c:pt idx="18">
                  <c:v>1.090396E-5</c:v>
                </c:pt>
                <c:pt idx="19">
                  <c:v>1.7231910000000001E-5</c:v>
                </c:pt>
                <c:pt idx="20">
                  <c:v>2.6771979999999999E-5</c:v>
                </c:pt>
                <c:pt idx="21">
                  <c:v>4.0846780000000002E-5</c:v>
                </c:pt>
                <c:pt idx="22">
                  <c:v>6.1173590000000006E-5</c:v>
                </c:pt>
                <c:pt idx="23">
                  <c:v>8.9948040000000003E-5</c:v>
                </c:pt>
                <c:pt idx="24">
                  <c:v>1.299614E-4</c:v>
                </c:pt>
                <c:pt idx="25">
                  <c:v>1.8477190000000001E-4</c:v>
                </c:pt>
                <c:pt idx="26">
                  <c:v>2.5894930000000001E-4</c:v>
                </c:pt>
                <c:pt idx="27">
                  <c:v>3.5841369999999999E-4</c:v>
                </c:pt>
                <c:pt idx="28">
                  <c:v>4.9088820000000005E-4</c:v>
                </c:pt>
                <c:pt idx="29">
                  <c:v>6.6649470000000003E-4</c:v>
                </c:pt>
                <c:pt idx="30">
                  <c:v>8.9853000000000003E-4</c:v>
                </c:pt>
                <c:pt idx="31">
                  <c:v>1.2044779999999999E-3</c:v>
                </c:pt>
                <c:pt idx="32">
                  <c:v>1.6073330000000001E-3</c:v>
                </c:pt>
                <c:pt idx="33">
                  <c:v>2.1373220000000001E-3</c:v>
                </c:pt>
                <c:pt idx="34">
                  <c:v>2.8341730000000002E-3</c:v>
                </c:pt>
                <c:pt idx="35">
                  <c:v>3.750073E-3</c:v>
                </c:pt>
                <c:pt idx="36">
                  <c:v>4.953547E-3</c:v>
                </c:pt>
                <c:pt idx="37">
                  <c:v>6.5345289999999999E-3</c:v>
                </c:pt>
                <c:pt idx="38">
                  <c:v>8.610988E-3</c:v>
                </c:pt>
                <c:pt idx="39">
                  <c:v>1.133756E-2</c:v>
                </c:pt>
                <c:pt idx="40">
                  <c:v>1.4916769999999999E-2</c:v>
                </c:pt>
                <c:pt idx="41">
                  <c:v>1.961359E-2</c:v>
                </c:pt>
                <c:pt idx="42">
                  <c:v>2.5774200000000001E-2</c:v>
                </c:pt>
                <c:pt idx="43">
                  <c:v>3.3849999999999998E-2</c:v>
                </c:pt>
                <c:pt idx="44">
                  <c:v>4.4428170000000003E-2</c:v>
                </c:pt>
                <c:pt idx="45">
                  <c:v>5.8270059999999999E-2</c:v>
                </c:pt>
                <c:pt idx="46">
                  <c:v>7.6358510000000004E-2</c:v>
                </c:pt>
                <c:pt idx="47">
                  <c:v>9.9955080000000002E-2</c:v>
                </c:pt>
                <c:pt idx="48">
                  <c:v>0.13066659999999999</c:v>
                </c:pt>
                <c:pt idx="49">
                  <c:v>0.1705187</c:v>
                </c:pt>
                <c:pt idx="50">
                  <c:v>0.2220287</c:v>
                </c:pt>
                <c:pt idx="51">
                  <c:v>0.2882652</c:v>
                </c:pt>
                <c:pt idx="52">
                  <c:v>0.37286740000000002</c:v>
                </c:pt>
                <c:pt idx="53">
                  <c:v>0.47998299999999999</c:v>
                </c:pt>
                <c:pt idx="54">
                  <c:v>0.61405960000000004</c:v>
                </c:pt>
                <c:pt idx="55">
                  <c:v>0.77940399999999999</c:v>
                </c:pt>
                <c:pt idx="56">
                  <c:v>0.97940479999999996</c:v>
                </c:pt>
                <c:pt idx="57">
                  <c:v>1.2153400000000001</c:v>
                </c:pt>
                <c:pt idx="58">
                  <c:v>1.4847710000000001</c:v>
                </c:pt>
                <c:pt idx="59">
                  <c:v>1.7797270000000001</c:v>
                </c:pt>
                <c:pt idx="60">
                  <c:v>2.0851989999999998</c:v>
                </c:pt>
                <c:pt idx="61">
                  <c:v>2.3787790000000002</c:v>
                </c:pt>
                <c:pt idx="62">
                  <c:v>2.6324169999999998</c:v>
                </c:pt>
                <c:pt idx="63">
                  <c:v>2.8167819999999999</c:v>
                </c:pt>
                <c:pt idx="64">
                  <c:v>2.9076110000000002</c:v>
                </c:pt>
                <c:pt idx="65">
                  <c:v>2.8920460000000001</c:v>
                </c:pt>
                <c:pt idx="66">
                  <c:v>2.7723330000000002</c:v>
                </c:pt>
                <c:pt idx="67">
                  <c:v>2.5651609999999998</c:v>
                </c:pt>
                <c:pt idx="68">
                  <c:v>2.2969539999999999</c:v>
                </c:pt>
                <c:pt idx="69">
                  <c:v>1.9972650000000001</c:v>
                </c:pt>
                <c:pt idx="70">
                  <c:v>1.692849</c:v>
                </c:pt>
                <c:pt idx="71">
                  <c:v>1.40405</c:v>
                </c:pt>
                <c:pt idx="72">
                  <c:v>1.143743</c:v>
                </c:pt>
                <c:pt idx="73">
                  <c:v>0.91812090000000002</c:v>
                </c:pt>
                <c:pt idx="74">
                  <c:v>0.72836800000000002</c:v>
                </c:pt>
                <c:pt idx="75">
                  <c:v>0.5724494</c:v>
                </c:pt>
                <c:pt idx="76">
                  <c:v>0.44660870000000003</c:v>
                </c:pt>
                <c:pt idx="77">
                  <c:v>0.34643570000000001</c:v>
                </c:pt>
                <c:pt idx="78">
                  <c:v>0.2675361</c:v>
                </c:pt>
                <c:pt idx="79">
                  <c:v>0.20589550000000001</c:v>
                </c:pt>
                <c:pt idx="80">
                  <c:v>0.1580376</c:v>
                </c:pt>
                <c:pt idx="81">
                  <c:v>0.1210571</c:v>
                </c:pt>
                <c:pt idx="82">
                  <c:v>9.2585609999999999E-2</c:v>
                </c:pt>
                <c:pt idx="83">
                  <c:v>7.0725960000000004E-2</c:v>
                </c:pt>
                <c:pt idx="84">
                  <c:v>5.3978239999999997E-2</c:v>
                </c:pt>
                <c:pt idx="85">
                  <c:v>4.1167700000000002E-2</c:v>
                </c:pt>
                <c:pt idx="86">
                  <c:v>3.1380819999999997E-2</c:v>
                </c:pt>
                <c:pt idx="87">
                  <c:v>2.391093E-2</c:v>
                </c:pt>
                <c:pt idx="88">
                  <c:v>1.8213569999999998E-2</c:v>
                </c:pt>
                <c:pt idx="89">
                  <c:v>1.3870479999999999E-2</c:v>
                </c:pt>
                <c:pt idx="90">
                  <c:v>1.056113E-2</c:v>
                </c:pt>
                <c:pt idx="91">
                  <c:v>8.0402670000000002E-3</c:v>
                </c:pt>
                <c:pt idx="92">
                  <c:v>6.1204789999999999E-3</c:v>
                </c:pt>
                <c:pt idx="93">
                  <c:v>4.6587149999999999E-3</c:v>
                </c:pt>
                <c:pt idx="94">
                  <c:v>3.5458529999999999E-3</c:v>
                </c:pt>
                <c:pt idx="95">
                  <c:v>2.6987059999999999E-3</c:v>
                </c:pt>
                <c:pt idx="96">
                  <c:v>2.053881E-3</c:v>
                </c:pt>
                <c:pt idx="97">
                  <c:v>1.563088E-3</c:v>
                </c:pt>
                <c:pt idx="98">
                  <c:v>1.1895510000000001E-3</c:v>
                </c:pt>
                <c:pt idx="99">
                  <c:v>9.052652E-4</c:v>
                </c:pt>
                <c:pt idx="100">
                  <c:v>6.8891180000000001E-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EC67-42F9-9DC7-2B4002AA8067}"/>
            </c:ext>
          </c:extLst>
        </c:ser>
        <c:ser>
          <c:idx val="13"/>
          <c:order val="13"/>
          <c:tx>
            <c:strRef>
              <c:f>Figure1!$BP$1</c:f>
              <c:strCache>
                <c:ptCount val="1"/>
                <c:pt idx="0">
                  <c:v>Can you not sleep or wake up at night by coughing?  </c:v>
                </c:pt>
              </c:strCache>
            </c:strRef>
          </c:tx>
          <c:spPr>
            <a:ln w="19050" cap="rnd">
              <a:solidFill>
                <a:srgbClr val="7030A0"/>
              </a:solidFill>
              <a:prstDash val="lgDash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P$2:$BP$102</c:f>
              <c:numCache>
                <c:formatCode>0.00E+00</c:formatCode>
                <c:ptCount val="101"/>
                <c:pt idx="0">
                  <c:v>4.3180689999999999E-147</c:v>
                </c:pt>
                <c:pt idx="1">
                  <c:v>5.2997639999999997E-145</c:v>
                </c:pt>
                <c:pt idx="2">
                  <c:v>6.5046430000000001E-143</c:v>
                </c:pt>
                <c:pt idx="3">
                  <c:v>7.9834450000000001E-141</c:v>
                </c:pt>
                <c:pt idx="4">
                  <c:v>9.798448E-139</c:v>
                </c:pt>
                <c:pt idx="5">
                  <c:v>1.2026079999999999E-136</c:v>
                </c:pt>
                <c:pt idx="6">
                  <c:v>1.4760160000000001E-134</c:v>
                </c:pt>
                <c:pt idx="7">
                  <c:v>1.811582E-132</c:v>
                </c:pt>
                <c:pt idx="8">
                  <c:v>2.2234379999999999E-130</c:v>
                </c:pt>
                <c:pt idx="9">
                  <c:v>2.728927E-128</c:v>
                </c:pt>
                <c:pt idx="10">
                  <c:v>3.3493359999999999E-126</c:v>
                </c:pt>
                <c:pt idx="11">
                  <c:v>4.1107939999999998E-124</c:v>
                </c:pt>
                <c:pt idx="12">
                  <c:v>5.045365E-122</c:v>
                </c:pt>
                <c:pt idx="13">
                  <c:v>6.1924069999999998E-120</c:v>
                </c:pt>
                <c:pt idx="14">
                  <c:v>7.600225E-118</c:v>
                </c:pt>
                <c:pt idx="15">
                  <c:v>9.3281030000000003E-116</c:v>
                </c:pt>
                <c:pt idx="16">
                  <c:v>1.1448810000000001E-113</c:v>
                </c:pt>
                <c:pt idx="17">
                  <c:v>1.405164E-111</c:v>
                </c:pt>
                <c:pt idx="18">
                  <c:v>1.7246229999999999E-109</c:v>
                </c:pt>
                <c:pt idx="19">
                  <c:v>2.1167080000000001E-107</c:v>
                </c:pt>
                <c:pt idx="20">
                  <c:v>2.5979330000000001E-105</c:v>
                </c:pt>
                <c:pt idx="21">
                  <c:v>3.1885619999999999E-103</c:v>
                </c:pt>
                <c:pt idx="22">
                  <c:v>3.9134679999999998E-101</c:v>
                </c:pt>
                <c:pt idx="23">
                  <c:v>4.8031779999999997E-99</c:v>
                </c:pt>
                <c:pt idx="24">
                  <c:v>5.8951599999999998E-97</c:v>
                </c:pt>
                <c:pt idx="25">
                  <c:v>7.2353989999999997E-95</c:v>
                </c:pt>
                <c:pt idx="26">
                  <c:v>8.8803360000000004E-93</c:v>
                </c:pt>
                <c:pt idx="27">
                  <c:v>1.0899239999999999E-90</c:v>
                </c:pt>
                <c:pt idx="28">
                  <c:v>1.3377140000000001E-88</c:v>
                </c:pt>
                <c:pt idx="29">
                  <c:v>1.6418369999999999E-86</c:v>
                </c:pt>
                <c:pt idx="30">
                  <c:v>2.015102E-84</c:v>
                </c:pt>
                <c:pt idx="31">
                  <c:v>2.4732269999999999E-82</c:v>
                </c:pt>
                <c:pt idx="32">
                  <c:v>3.0355050000000001E-80</c:v>
                </c:pt>
                <c:pt idx="33">
                  <c:v>3.7256130000000002E-78</c:v>
                </c:pt>
                <c:pt idx="34">
                  <c:v>4.572616E-76</c:v>
                </c:pt>
                <c:pt idx="35">
                  <c:v>5.6121800000000003E-74</c:v>
                </c:pt>
                <c:pt idx="36">
                  <c:v>6.8880859999999997E-72</c:v>
                </c:pt>
                <c:pt idx="37">
                  <c:v>8.4540630000000006E-70</c:v>
                </c:pt>
                <c:pt idx="38">
                  <c:v>1.037606E-67</c:v>
                </c:pt>
                <c:pt idx="39">
                  <c:v>1.2735009999999999E-65</c:v>
                </c:pt>
                <c:pt idx="40">
                  <c:v>1.5630259999999999E-63</c:v>
                </c:pt>
                <c:pt idx="41">
                  <c:v>1.9183730000000002E-61</c:v>
                </c:pt>
                <c:pt idx="42">
                  <c:v>2.354507E-59</c:v>
                </c:pt>
                <c:pt idx="43">
                  <c:v>2.8897939999999998E-57</c:v>
                </c:pt>
                <c:pt idx="44">
                  <c:v>3.5467769999999999E-55</c:v>
                </c:pt>
                <c:pt idx="45">
                  <c:v>4.3531209999999996E-53</c:v>
                </c:pt>
                <c:pt idx="46">
                  <c:v>5.342785E-51</c:v>
                </c:pt>
                <c:pt idx="47">
                  <c:v>6.5574440000000001E-49</c:v>
                </c:pt>
                <c:pt idx="48">
                  <c:v>8.0482509999999998E-47</c:v>
                </c:pt>
                <c:pt idx="49">
                  <c:v>9.8779869999999996E-45</c:v>
                </c:pt>
                <c:pt idx="50">
                  <c:v>1.21237E-42</c:v>
                </c:pt>
                <c:pt idx="51">
                  <c:v>1.487998E-40</c:v>
                </c:pt>
                <c:pt idx="52">
                  <c:v>1.826288E-38</c:v>
                </c:pt>
                <c:pt idx="53">
                  <c:v>2.2414860000000001E-36</c:v>
                </c:pt>
                <c:pt idx="54">
                  <c:v>2.751079E-34</c:v>
                </c:pt>
                <c:pt idx="55">
                  <c:v>3.3765250000000002E-32</c:v>
                </c:pt>
                <c:pt idx="56">
                  <c:v>4.1441630000000001E-30</c:v>
                </c:pt>
                <c:pt idx="57">
                  <c:v>5.0863210000000001E-28</c:v>
                </c:pt>
                <c:pt idx="58">
                  <c:v>6.2426740000000004E-26</c:v>
                </c:pt>
                <c:pt idx="59">
                  <c:v>7.6619190000000003E-24</c:v>
                </c:pt>
                <c:pt idx="60">
                  <c:v>9.4038239999999995E-22</c:v>
                </c:pt>
                <c:pt idx="61">
                  <c:v>1.154174E-19</c:v>
                </c:pt>
                <c:pt idx="62">
                  <c:v>1.416571E-17</c:v>
                </c:pt>
                <c:pt idx="63">
                  <c:v>1.7386220000000001E-15</c:v>
                </c:pt>
                <c:pt idx="64">
                  <c:v>2.1338899999999999E-13</c:v>
                </c:pt>
                <c:pt idx="65">
                  <c:v>2.6190200000000001E-11</c:v>
                </c:pt>
                <c:pt idx="66">
                  <c:v>3.2144200000000002E-9</c:v>
                </c:pt>
                <c:pt idx="67">
                  <c:v>3.9448999999999998E-7</c:v>
                </c:pt>
                <c:pt idx="68">
                  <c:v>4.8376169999999997E-5</c:v>
                </c:pt>
                <c:pt idx="69">
                  <c:v>5.8816399999999996E-3</c:v>
                </c:pt>
                <c:pt idx="70">
                  <c:v>0.65282980000000002</c:v>
                </c:pt>
                <c:pt idx="71">
                  <c:v>35.537500000000001</c:v>
                </c:pt>
                <c:pt idx="72">
                  <c:v>188.04929999999999</c:v>
                </c:pt>
                <c:pt idx="73">
                  <c:v>55.749139999999997</c:v>
                </c:pt>
                <c:pt idx="74">
                  <c:v>5.8263150000000001</c:v>
                </c:pt>
                <c:pt idx="75">
                  <c:v>0.53317550000000002</c:v>
                </c:pt>
                <c:pt idx="76">
                  <c:v>4.8186619999999999E-2</c:v>
                </c:pt>
                <c:pt idx="77">
                  <c:v>4.3500250000000004E-3</c:v>
                </c:pt>
                <c:pt idx="78">
                  <c:v>3.9265639999999999E-4</c:v>
                </c:pt>
                <c:pt idx="79">
                  <c:v>3.5442930000000001E-5</c:v>
                </c:pt>
                <c:pt idx="80">
                  <c:v>3.1992359999999999E-6</c:v>
                </c:pt>
                <c:pt idx="81">
                  <c:v>2.8877699999999999E-7</c:v>
                </c:pt>
                <c:pt idx="82">
                  <c:v>2.606627E-8</c:v>
                </c:pt>
                <c:pt idx="83">
                  <c:v>2.352922E-9</c:v>
                </c:pt>
                <c:pt idx="84">
                  <c:v>2.124152E-10</c:v>
                </c:pt>
                <c:pt idx="85">
                  <c:v>1.926487E-11</c:v>
                </c:pt>
                <c:pt idx="86">
                  <c:v>1.8060810000000001E-12</c:v>
                </c:pt>
                <c:pt idx="87">
                  <c:v>2.006757E-13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EC67-42F9-9DC7-2B4002AA8067}"/>
            </c:ext>
          </c:extLst>
        </c:ser>
        <c:ser>
          <c:idx val="14"/>
          <c:order val="14"/>
          <c:tx>
            <c:strRef>
              <c:f>Figure1!$BQ$1</c:f>
              <c:strCache>
                <c:ptCount val="1"/>
                <c:pt idx="0">
                  <c:v>Has your voice faded? </c:v>
                </c:pt>
              </c:strCache>
            </c:strRef>
          </c:tx>
          <c:spPr>
            <a:ln w="19050" cap="rnd">
              <a:solidFill>
                <a:srgbClr val="7030A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Figure1!$AL$2:$AL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Figure1!$BQ$2:$BQ$102</c:f>
              <c:numCache>
                <c:formatCode>General</c:formatCode>
                <c:ptCount val="101"/>
                <c:pt idx="0">
                  <c:v>6.4751529999999998E-4</c:v>
                </c:pt>
                <c:pt idx="1">
                  <c:v>7.5030690000000004E-4</c:v>
                </c:pt>
                <c:pt idx="2">
                  <c:v>8.6940759999999998E-4</c:v>
                </c:pt>
                <c:pt idx="3">
                  <c:v>1.0074023E-3</c:v>
                </c:pt>
                <c:pt idx="4">
                  <c:v>1.1672844999999999E-3</c:v>
                </c:pt>
                <c:pt idx="5">
                  <c:v>1.3525206000000001E-3</c:v>
                </c:pt>
                <c:pt idx="6">
                  <c:v>1.5671242000000001E-3</c:v>
                </c:pt>
                <c:pt idx="7">
                  <c:v>1.815742E-3</c:v>
                </c:pt>
                <c:pt idx="8">
                  <c:v>2.1037527000000002E-3</c:v>
                </c:pt>
                <c:pt idx="9">
                  <c:v>2.4373811000000002E-3</c:v>
                </c:pt>
                <c:pt idx="10">
                  <c:v>2.8238301999999999E-3</c:v>
                </c:pt>
                <c:pt idx="11">
                  <c:v>3.2714323E-3</c:v>
                </c:pt>
                <c:pt idx="12">
                  <c:v>3.7898239999999998E-3</c:v>
                </c:pt>
                <c:pt idx="13">
                  <c:v>4.3901464000000003E-3</c:v>
                </c:pt>
                <c:pt idx="14">
                  <c:v>5.0852756000000004E-3</c:v>
                </c:pt>
                <c:pt idx="15">
                  <c:v>5.8900858999999996E-3</c:v>
                </c:pt>
                <c:pt idx="16">
                  <c:v>6.8217523E-3</c:v>
                </c:pt>
                <c:pt idx="17">
                  <c:v>7.9000939000000003E-3</c:v>
                </c:pt>
                <c:pt idx="18">
                  <c:v>9.1479661999999996E-3</c:v>
                </c:pt>
                <c:pt idx="19">
                  <c:v>1.05917053E-2</c:v>
                </c:pt>
                <c:pt idx="20">
                  <c:v>1.22616306E-2</c:v>
                </c:pt>
                <c:pt idx="21">
                  <c:v>1.41926103E-2</c:v>
                </c:pt>
                <c:pt idx="22">
                  <c:v>1.64246937E-2</c:v>
                </c:pt>
                <c:pt idx="23">
                  <c:v>1.9003815699999999E-2</c:v>
                </c:pt>
                <c:pt idx="24">
                  <c:v>2.19825721E-2</c:v>
                </c:pt>
                <c:pt idx="25">
                  <c:v>2.5421067499999998E-2</c:v>
                </c:pt>
                <c:pt idx="26">
                  <c:v>2.9387828500000001E-2</c:v>
                </c:pt>
                <c:pt idx="27">
                  <c:v>3.3960772399999999E-2</c:v>
                </c:pt>
                <c:pt idx="28">
                  <c:v>3.9228211499999999E-2</c:v>
                </c:pt>
                <c:pt idx="29">
                  <c:v>4.5289864200000002E-2</c:v>
                </c:pt>
                <c:pt idx="30">
                  <c:v>5.2257826399999999E-2</c:v>
                </c:pt>
                <c:pt idx="31">
                  <c:v>6.0257441100000003E-2</c:v>
                </c:pt>
                <c:pt idx="32">
                  <c:v>6.9427977500000002E-2</c:v>
                </c:pt>
                <c:pt idx="33">
                  <c:v>7.9923000600000002E-2</c:v>
                </c:pt>
                <c:pt idx="34">
                  <c:v>9.1910274900000005E-2</c:v>
                </c:pt>
                <c:pt idx="35">
                  <c:v>0.1055710027</c:v>
                </c:pt>
                <c:pt idx="36">
                  <c:v>0.1210981466</c:v>
                </c:pt>
                <c:pt idx="37">
                  <c:v>0.13869353139999999</c:v>
                </c:pt>
                <c:pt idx="38">
                  <c:v>0.15856337039999999</c:v>
                </c:pt>
                <c:pt idx="39">
                  <c:v>0.18091181579999999</c:v>
                </c:pt>
                <c:pt idx="40">
                  <c:v>0.20593211240000001</c:v>
                </c:pt>
                <c:pt idx="41">
                  <c:v>0.23379495089999999</c:v>
                </c:pt>
                <c:pt idx="42">
                  <c:v>0.26463369549999999</c:v>
                </c:pt>
                <c:pt idx="43">
                  <c:v>0.29852633420000002</c:v>
                </c:pt>
                <c:pt idx="44">
                  <c:v>0.33547428620000003</c:v>
                </c:pt>
                <c:pt idx="45">
                  <c:v>0.37537864539999999</c:v>
                </c:pt>
                <c:pt idx="46">
                  <c:v>0.41801503280000002</c:v>
                </c:pt>
                <c:pt idx="47">
                  <c:v>0.46300897410000003</c:v>
                </c:pt>
                <c:pt idx="48">
                  <c:v>0.5098145436</c:v>
                </c:pt>
                <c:pt idx="49">
                  <c:v>0.55769979400000003</c:v>
                </c:pt>
                <c:pt idx="50">
                  <c:v>0.60574304160000003</c:v>
                </c:pt>
                <c:pt idx="51">
                  <c:v>0.65284413910000005</c:v>
                </c:pt>
                <c:pt idx="52">
                  <c:v>0.69775419650000003</c:v>
                </c:pt>
                <c:pt idx="53">
                  <c:v>0.7391256074</c:v>
                </c:pt>
                <c:pt idx="54">
                  <c:v>0.77558168029999996</c:v>
                </c:pt>
                <c:pt idx="55">
                  <c:v>0.80580191059999995</c:v>
                </c:pt>
                <c:pt idx="56">
                  <c:v>0.82861549800000001</c:v>
                </c:pt>
                <c:pt idx="57">
                  <c:v>0.84309289980000002</c:v>
                </c:pt>
                <c:pt idx="58">
                  <c:v>0.84862385809999996</c:v>
                </c:pt>
                <c:pt idx="59">
                  <c:v>0.84497105510000003</c:v>
                </c:pt>
                <c:pt idx="60">
                  <c:v>0.83229148100000006</c:v>
                </c:pt>
                <c:pt idx="61">
                  <c:v>0.81112226779999996</c:v>
                </c:pt>
                <c:pt idx="62">
                  <c:v>0.78233314649999997</c:v>
                </c:pt>
                <c:pt idx="63">
                  <c:v>0.74705260259999995</c:v>
                </c:pt>
                <c:pt idx="64">
                  <c:v>0.70657814490000004</c:v>
                </c:pt>
                <c:pt idx="65">
                  <c:v>0.66228228870000005</c:v>
                </c:pt>
                <c:pt idx="66">
                  <c:v>0.61552488110000003</c:v>
                </c:pt>
                <c:pt idx="67">
                  <c:v>0.56757982240000004</c:v>
                </c:pt>
                <c:pt idx="68">
                  <c:v>0.51958086029999995</c:v>
                </c:pt>
                <c:pt idx="69">
                  <c:v>0.47248778289999999</c:v>
                </c:pt>
                <c:pt idx="70">
                  <c:v>0.42707160370000002</c:v>
                </c:pt>
                <c:pt idx="71">
                  <c:v>0.38391552890000002</c:v>
                </c:pt>
                <c:pt idx="72">
                  <c:v>0.34342764219999999</c:v>
                </c:pt>
                <c:pt idx="73">
                  <c:v>0.30586117819999997</c:v>
                </c:pt>
                <c:pt idx="74">
                  <c:v>0.27133872530000003</c:v>
                </c:pt>
                <c:pt idx="75">
                  <c:v>0.23987744820000001</c:v>
                </c:pt>
                <c:pt idx="76">
                  <c:v>0.21141324819999999</c:v>
                </c:pt>
                <c:pt idx="77">
                  <c:v>0.18582254579999999</c:v>
                </c:pt>
                <c:pt idx="78">
                  <c:v>0.16294099910000001</c:v>
                </c:pt>
                <c:pt idx="79">
                  <c:v>0.14257894369999999</c:v>
                </c:pt>
                <c:pt idx="80">
                  <c:v>0.1245336581</c:v>
                </c:pt>
                <c:pt idx="81">
                  <c:v>0.1085987538</c:v>
                </c:pt>
                <c:pt idx="82">
                  <c:v>9.4571081900000006E-2</c:v>
                </c:pt>
                <c:pt idx="83">
                  <c:v>8.2255578800000007E-2</c:v>
                </c:pt>
                <c:pt idx="84">
                  <c:v>7.1468456599999994E-2</c:v>
                </c:pt>
                <c:pt idx="85">
                  <c:v>6.20391052E-2</c:v>
                </c:pt>
                <c:pt idx="86">
                  <c:v>5.3811019100000003E-2</c:v>
                </c:pt>
                <c:pt idx="87">
                  <c:v>4.6642012900000002E-2</c:v>
                </c:pt>
                <c:pt idx="88">
                  <c:v>4.04039328E-2</c:v>
                </c:pt>
                <c:pt idx="89">
                  <c:v>3.4982030400000003E-2</c:v>
                </c:pt>
                <c:pt idx="90">
                  <c:v>3.0274124499999999E-2</c:v>
                </c:pt>
                <c:pt idx="91">
                  <c:v>2.6189643700000001E-2</c:v>
                </c:pt>
                <c:pt idx="92">
                  <c:v>2.2648620099999999E-2</c:v>
                </c:pt>
                <c:pt idx="93">
                  <c:v>1.9580680600000001E-2</c:v>
                </c:pt>
                <c:pt idx="94">
                  <c:v>1.6924068800000001E-2</c:v>
                </c:pt>
                <c:pt idx="95">
                  <c:v>1.4624719099999999E-2</c:v>
                </c:pt>
                <c:pt idx="96">
                  <c:v>1.26353956E-2</c:v>
                </c:pt>
                <c:pt idx="97">
                  <c:v>1.0914900700000001E-2</c:v>
                </c:pt>
                <c:pt idx="98">
                  <c:v>9.4273570000000008E-3</c:v>
                </c:pt>
                <c:pt idx="99">
                  <c:v>8.1415597999999999E-3</c:v>
                </c:pt>
                <c:pt idx="100">
                  <c:v>7.0303984000000003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EC67-42F9-9DC7-2B4002AA80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580720"/>
        <c:axId val="205581896"/>
      </c:scatterChart>
      <c:valAx>
        <c:axId val="205580720"/>
        <c:scaling>
          <c:orientation val="minMax"/>
          <c:max val="4"/>
          <c:min val="-4"/>
        </c:scaling>
        <c:delete val="0"/>
        <c:axPos val="b"/>
        <c:numFmt formatCode="#,##0_ 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5581896"/>
        <c:crosses val="autoZero"/>
        <c:crossBetween val="midCat"/>
      </c:valAx>
      <c:valAx>
        <c:axId val="205581896"/>
        <c:scaling>
          <c:orientation val="minMax"/>
          <c:max val="100"/>
          <c:min val="0"/>
        </c:scaling>
        <c:delete val="0"/>
        <c:axPos val="l"/>
        <c:numFmt formatCode="#,##0_);[Red]\(#,##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5580720"/>
        <c:crosses val="autoZero"/>
        <c:crossBetween val="midCat"/>
        <c:majorUnit val="25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3.9954535125628736E-2"/>
          <c:y val="0.66676419854956159"/>
          <c:w val="0.8965098191658305"/>
          <c:h val="0.3097547649327100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F$3</c:f>
              <c:strCache>
                <c:ptCount val="1"/>
                <c:pt idx="0">
                  <c:v>Not us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rgbClr val="0070C0"/>
                </a:solidFill>
              </a:ln>
              <a:effectLst/>
            </c:spPr>
          </c:marker>
          <c:dPt>
            <c:idx val="19"/>
            <c:marker>
              <c:symbol val="circle"/>
              <c:size val="5"/>
              <c:spPr>
                <a:solidFill>
                  <a:srgbClr val="0070C0"/>
                </a:solidFill>
                <a:ln w="9525">
                  <a:solidFill>
                    <a:srgbClr val="0070C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8285-492F-A934-2C3FFBF05B1E}"/>
              </c:ext>
            </c:extLst>
          </c:dPt>
          <c:trendline>
            <c:spPr>
              <a:ln w="9525" cap="rnd">
                <a:solidFill>
                  <a:srgbClr val="0070C0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3597812773403326"/>
                  <c:y val="-5.1793445544077631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5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2!$A$4:$A$23</c:f>
              <c:numCache>
                <c:formatCode>General</c:formatCode>
                <c:ptCount val="20"/>
                <c:pt idx="0">
                  <c:v>27</c:v>
                </c:pt>
                <c:pt idx="1">
                  <c:v>26</c:v>
                </c:pt>
                <c:pt idx="2">
                  <c:v>21</c:v>
                </c:pt>
                <c:pt idx="3">
                  <c:v>21</c:v>
                </c:pt>
                <c:pt idx="4">
                  <c:v>24</c:v>
                </c:pt>
                <c:pt idx="5">
                  <c:v>3</c:v>
                </c:pt>
                <c:pt idx="6">
                  <c:v>19</c:v>
                </c:pt>
                <c:pt idx="7">
                  <c:v>18</c:v>
                </c:pt>
                <c:pt idx="8">
                  <c:v>28</c:v>
                </c:pt>
                <c:pt idx="9">
                  <c:v>20</c:v>
                </c:pt>
                <c:pt idx="10">
                  <c:v>26</c:v>
                </c:pt>
                <c:pt idx="11">
                  <c:v>28</c:v>
                </c:pt>
                <c:pt idx="12">
                  <c:v>26</c:v>
                </c:pt>
                <c:pt idx="13">
                  <c:v>22</c:v>
                </c:pt>
                <c:pt idx="14">
                  <c:v>29</c:v>
                </c:pt>
                <c:pt idx="15">
                  <c:v>27</c:v>
                </c:pt>
                <c:pt idx="16">
                  <c:v>24</c:v>
                </c:pt>
                <c:pt idx="17">
                  <c:v>4</c:v>
                </c:pt>
                <c:pt idx="18">
                  <c:v>12</c:v>
                </c:pt>
                <c:pt idx="19">
                  <c:v>26</c:v>
                </c:pt>
              </c:numCache>
            </c:numRef>
          </c:xVal>
          <c:yVal>
            <c:numRef>
              <c:f>Sheet2!$B$4:$B$23</c:f>
              <c:numCache>
                <c:formatCode>General</c:formatCode>
                <c:ptCount val="20"/>
                <c:pt idx="1">
                  <c:v>290.3</c:v>
                </c:pt>
                <c:pt idx="2">
                  <c:v>411.2</c:v>
                </c:pt>
                <c:pt idx="4">
                  <c:v>896.9</c:v>
                </c:pt>
                <c:pt idx="5">
                  <c:v>616</c:v>
                </c:pt>
                <c:pt idx="6">
                  <c:v>629</c:v>
                </c:pt>
                <c:pt idx="7">
                  <c:v>1016</c:v>
                </c:pt>
                <c:pt idx="10">
                  <c:v>462</c:v>
                </c:pt>
                <c:pt idx="13">
                  <c:v>108.2</c:v>
                </c:pt>
                <c:pt idx="14">
                  <c:v>2571.1999999999998</c:v>
                </c:pt>
                <c:pt idx="15">
                  <c:v>596.6</c:v>
                </c:pt>
                <c:pt idx="16">
                  <c:v>856.5</c:v>
                </c:pt>
                <c:pt idx="18">
                  <c:v>265</c:v>
                </c:pt>
                <c:pt idx="19">
                  <c:v>4900.1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285-492F-A934-2C3FFBF05B1E}"/>
            </c:ext>
          </c:extLst>
        </c:ser>
        <c:ser>
          <c:idx val="1"/>
          <c:order val="1"/>
          <c:tx>
            <c:strRef>
              <c:f>Sheet2!$E$3</c:f>
              <c:strCache>
                <c:ptCount val="1"/>
                <c:pt idx="0">
                  <c:v>Us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trendline>
            <c:spPr>
              <a:ln w="12700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5222987751531056"/>
                  <c:y val="-0.14351152206891571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5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2!$A$24:$A$87</c:f>
              <c:numCache>
                <c:formatCode>General</c:formatCode>
                <c:ptCount val="64"/>
                <c:pt idx="0">
                  <c:v>13</c:v>
                </c:pt>
                <c:pt idx="1">
                  <c:v>0</c:v>
                </c:pt>
                <c:pt idx="2">
                  <c:v>20</c:v>
                </c:pt>
                <c:pt idx="3">
                  <c:v>9</c:v>
                </c:pt>
                <c:pt idx="4">
                  <c:v>0</c:v>
                </c:pt>
                <c:pt idx="5">
                  <c:v>5</c:v>
                </c:pt>
                <c:pt idx="6">
                  <c:v>22</c:v>
                </c:pt>
                <c:pt idx="7">
                  <c:v>0</c:v>
                </c:pt>
                <c:pt idx="8">
                  <c:v>12</c:v>
                </c:pt>
                <c:pt idx="9">
                  <c:v>19</c:v>
                </c:pt>
                <c:pt idx="10">
                  <c:v>21</c:v>
                </c:pt>
                <c:pt idx="11">
                  <c:v>9</c:v>
                </c:pt>
                <c:pt idx="12">
                  <c:v>7</c:v>
                </c:pt>
                <c:pt idx="13">
                  <c:v>10</c:v>
                </c:pt>
                <c:pt idx="14">
                  <c:v>7</c:v>
                </c:pt>
                <c:pt idx="15">
                  <c:v>9</c:v>
                </c:pt>
                <c:pt idx="16">
                  <c:v>7</c:v>
                </c:pt>
                <c:pt idx="17">
                  <c:v>0</c:v>
                </c:pt>
                <c:pt idx="18">
                  <c:v>0</c:v>
                </c:pt>
                <c:pt idx="19">
                  <c:v>24</c:v>
                </c:pt>
                <c:pt idx="20">
                  <c:v>1</c:v>
                </c:pt>
                <c:pt idx="21">
                  <c:v>23</c:v>
                </c:pt>
                <c:pt idx="22">
                  <c:v>10</c:v>
                </c:pt>
                <c:pt idx="23">
                  <c:v>7</c:v>
                </c:pt>
                <c:pt idx="24">
                  <c:v>10</c:v>
                </c:pt>
                <c:pt idx="25">
                  <c:v>0</c:v>
                </c:pt>
                <c:pt idx="26">
                  <c:v>0</c:v>
                </c:pt>
                <c:pt idx="27">
                  <c:v>14</c:v>
                </c:pt>
                <c:pt idx="28">
                  <c:v>1</c:v>
                </c:pt>
                <c:pt idx="29">
                  <c:v>22</c:v>
                </c:pt>
                <c:pt idx="30">
                  <c:v>11</c:v>
                </c:pt>
                <c:pt idx="31">
                  <c:v>11</c:v>
                </c:pt>
                <c:pt idx="32">
                  <c:v>8</c:v>
                </c:pt>
                <c:pt idx="33">
                  <c:v>1</c:v>
                </c:pt>
                <c:pt idx="34">
                  <c:v>7</c:v>
                </c:pt>
                <c:pt idx="35">
                  <c:v>17</c:v>
                </c:pt>
                <c:pt idx="36">
                  <c:v>0</c:v>
                </c:pt>
                <c:pt idx="37">
                  <c:v>12</c:v>
                </c:pt>
                <c:pt idx="38">
                  <c:v>13</c:v>
                </c:pt>
                <c:pt idx="39">
                  <c:v>0</c:v>
                </c:pt>
                <c:pt idx="40">
                  <c:v>5</c:v>
                </c:pt>
                <c:pt idx="41">
                  <c:v>0</c:v>
                </c:pt>
                <c:pt idx="42">
                  <c:v>1</c:v>
                </c:pt>
                <c:pt idx="43">
                  <c:v>0</c:v>
                </c:pt>
                <c:pt idx="44">
                  <c:v>9</c:v>
                </c:pt>
                <c:pt idx="45">
                  <c:v>1</c:v>
                </c:pt>
                <c:pt idx="46">
                  <c:v>17</c:v>
                </c:pt>
                <c:pt idx="47">
                  <c:v>21</c:v>
                </c:pt>
                <c:pt idx="48">
                  <c:v>14</c:v>
                </c:pt>
                <c:pt idx="49">
                  <c:v>7</c:v>
                </c:pt>
                <c:pt idx="50">
                  <c:v>14</c:v>
                </c:pt>
                <c:pt idx="51">
                  <c:v>11</c:v>
                </c:pt>
                <c:pt idx="52">
                  <c:v>2</c:v>
                </c:pt>
                <c:pt idx="53">
                  <c:v>2</c:v>
                </c:pt>
                <c:pt idx="54">
                  <c:v>9</c:v>
                </c:pt>
                <c:pt idx="55">
                  <c:v>14</c:v>
                </c:pt>
                <c:pt idx="56">
                  <c:v>0</c:v>
                </c:pt>
                <c:pt idx="57">
                  <c:v>11</c:v>
                </c:pt>
                <c:pt idx="58">
                  <c:v>4</c:v>
                </c:pt>
                <c:pt idx="59">
                  <c:v>0</c:v>
                </c:pt>
                <c:pt idx="60">
                  <c:v>6</c:v>
                </c:pt>
                <c:pt idx="61">
                  <c:v>10</c:v>
                </c:pt>
                <c:pt idx="62">
                  <c:v>0</c:v>
                </c:pt>
              </c:numCache>
            </c:numRef>
          </c:xVal>
          <c:yVal>
            <c:numRef>
              <c:f>Sheet2!$B$24:$B$87</c:f>
              <c:numCache>
                <c:formatCode>General</c:formatCode>
                <c:ptCount val="64"/>
                <c:pt idx="0">
                  <c:v>1012.9</c:v>
                </c:pt>
                <c:pt idx="1">
                  <c:v>1795.3</c:v>
                </c:pt>
                <c:pt idx="2">
                  <c:v>575</c:v>
                </c:pt>
                <c:pt idx="5">
                  <c:v>380.6</c:v>
                </c:pt>
                <c:pt idx="6">
                  <c:v>3017.2</c:v>
                </c:pt>
                <c:pt idx="7">
                  <c:v>76.8</c:v>
                </c:pt>
                <c:pt idx="8">
                  <c:v>488</c:v>
                </c:pt>
                <c:pt idx="9">
                  <c:v>773.3</c:v>
                </c:pt>
                <c:pt idx="10">
                  <c:v>388.7</c:v>
                </c:pt>
                <c:pt idx="11">
                  <c:v>887.8</c:v>
                </c:pt>
                <c:pt idx="12">
                  <c:v>474.8</c:v>
                </c:pt>
                <c:pt idx="13">
                  <c:v>143</c:v>
                </c:pt>
                <c:pt idx="14">
                  <c:v>188</c:v>
                </c:pt>
                <c:pt idx="15">
                  <c:v>471</c:v>
                </c:pt>
                <c:pt idx="16">
                  <c:v>150</c:v>
                </c:pt>
                <c:pt idx="17">
                  <c:v>1087.0999999999999</c:v>
                </c:pt>
                <c:pt idx="18">
                  <c:v>1283</c:v>
                </c:pt>
                <c:pt idx="23">
                  <c:v>325</c:v>
                </c:pt>
                <c:pt idx="25">
                  <c:v>193.1</c:v>
                </c:pt>
                <c:pt idx="26">
                  <c:v>273.5</c:v>
                </c:pt>
                <c:pt idx="27">
                  <c:v>185.3</c:v>
                </c:pt>
                <c:pt idx="28">
                  <c:v>75.8</c:v>
                </c:pt>
                <c:pt idx="29">
                  <c:v>1077.5999999999999</c:v>
                </c:pt>
                <c:pt idx="30">
                  <c:v>642.29999999999995</c:v>
                </c:pt>
                <c:pt idx="31">
                  <c:v>337.6</c:v>
                </c:pt>
                <c:pt idx="32">
                  <c:v>258.60000000000002</c:v>
                </c:pt>
                <c:pt idx="33">
                  <c:v>129.69999999999999</c:v>
                </c:pt>
                <c:pt idx="34">
                  <c:v>900.5</c:v>
                </c:pt>
                <c:pt idx="35">
                  <c:v>1133.5999999999999</c:v>
                </c:pt>
                <c:pt idx="36">
                  <c:v>1684.3</c:v>
                </c:pt>
                <c:pt idx="37">
                  <c:v>772</c:v>
                </c:pt>
                <c:pt idx="38">
                  <c:v>3386</c:v>
                </c:pt>
                <c:pt idx="39">
                  <c:v>651.20000000000005</c:v>
                </c:pt>
                <c:pt idx="40">
                  <c:v>225.7</c:v>
                </c:pt>
                <c:pt idx="41">
                  <c:v>801.4</c:v>
                </c:pt>
                <c:pt idx="42">
                  <c:v>1022.8</c:v>
                </c:pt>
                <c:pt idx="43">
                  <c:v>314.89999999999998</c:v>
                </c:pt>
                <c:pt idx="44">
                  <c:v>1112</c:v>
                </c:pt>
                <c:pt idx="45">
                  <c:v>739.5</c:v>
                </c:pt>
                <c:pt idx="46">
                  <c:v>817</c:v>
                </c:pt>
                <c:pt idx="47">
                  <c:v>447.6</c:v>
                </c:pt>
                <c:pt idx="48">
                  <c:v>574.5</c:v>
                </c:pt>
                <c:pt idx="50">
                  <c:v>1310.3</c:v>
                </c:pt>
                <c:pt idx="51">
                  <c:v>341</c:v>
                </c:pt>
                <c:pt idx="55">
                  <c:v>278</c:v>
                </c:pt>
                <c:pt idx="56">
                  <c:v>714</c:v>
                </c:pt>
                <c:pt idx="57">
                  <c:v>600</c:v>
                </c:pt>
                <c:pt idx="58">
                  <c:v>1320</c:v>
                </c:pt>
                <c:pt idx="59">
                  <c:v>575</c:v>
                </c:pt>
                <c:pt idx="61">
                  <c:v>1283.0999999999999</c:v>
                </c:pt>
                <c:pt idx="63">
                  <c:v>10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285-492F-A934-2C3FFBF05B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12251736"/>
        <c:axId val="612253048"/>
      </c:scatterChart>
      <c:valAx>
        <c:axId val="612251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2253048"/>
        <c:crosses val="autoZero"/>
        <c:crossBetween val="midCat"/>
      </c:valAx>
      <c:valAx>
        <c:axId val="6122530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225173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909426946631672"/>
          <c:y val="0.91169688651303904"/>
          <c:w val="0.71792257217847777"/>
          <c:h val="4.854776180500373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5109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5971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7931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0643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053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1714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8474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7507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561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956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3148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A0449E-39C4-447E-AC4C-214F31808A57}" type="datetimeFigureOut">
              <a:rPr kumimoji="1" lang="ja-JP" altLang="en-US" smtClean="0"/>
              <a:t>2020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26095-86F2-475B-AACC-58858A9981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985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5035612"/>
              </p:ext>
            </p:extLst>
          </p:nvPr>
        </p:nvGraphicFramePr>
        <p:xfrm>
          <a:off x="659697" y="198178"/>
          <a:ext cx="4631584" cy="48286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6129069"/>
              </p:ext>
            </p:extLst>
          </p:nvPr>
        </p:nvGraphicFramePr>
        <p:xfrm>
          <a:off x="110339" y="172330"/>
          <a:ext cx="10669662" cy="63637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/>
          <p:cNvSpPr txBox="1"/>
          <p:nvPr/>
        </p:nvSpPr>
        <p:spPr>
          <a:xfrm rot="16200000">
            <a:off x="4557747" y="1782758"/>
            <a:ext cx="14670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tem informatio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-869730" y="1850618"/>
            <a:ext cx="27510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obability of a correct respons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034043" y="4116574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8453642" y="4156368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7893300" y="635139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1 Figur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474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5BC621D3-C044-40AA-933B-B1E65A8052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2191033"/>
              </p:ext>
            </p:extLst>
          </p:nvPr>
        </p:nvGraphicFramePr>
        <p:xfrm>
          <a:off x="1953936" y="1067324"/>
          <a:ext cx="4572000" cy="46204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E097DE4-4E2D-417B-8019-5F240641A542}"/>
              </a:ext>
            </a:extLst>
          </p:cNvPr>
          <p:cNvSpPr txBox="1"/>
          <p:nvPr/>
        </p:nvSpPr>
        <p:spPr>
          <a:xfrm rot="16200000">
            <a:off x="1015961" y="2790917"/>
            <a:ext cx="16674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cclusal force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N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9AB7B63-01AA-491A-AD66-5EC05C1DBD76}"/>
              </a:ext>
            </a:extLst>
          </p:cNvPr>
          <p:cNvSpPr txBox="1"/>
          <p:nvPr/>
        </p:nvSpPr>
        <p:spPr>
          <a:xfrm>
            <a:off x="4990657" y="4712516"/>
            <a:ext cx="2183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umber of remaining teeth</a:t>
            </a:r>
            <a:endParaRPr kumimoji="1" lang="ja-JP" altLang="en-US" sz="14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22A72EA-F6E4-4931-B04C-79800D1F93DF}"/>
              </a:ext>
            </a:extLst>
          </p:cNvPr>
          <p:cNvSpPr txBox="1"/>
          <p:nvPr/>
        </p:nvSpPr>
        <p:spPr>
          <a:xfrm>
            <a:off x="2306973" y="5184396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entur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483E562-B84B-4D4E-88E0-5D4E6FCA99B1}"/>
              </a:ext>
            </a:extLst>
          </p:cNvPr>
          <p:cNvSpPr txBox="1"/>
          <p:nvPr/>
        </p:nvSpPr>
        <p:spPr>
          <a:xfrm>
            <a:off x="6082238" y="3290500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=0.37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C2294B7-F6E7-480A-8D33-7EBCC10B519B}"/>
              </a:ext>
            </a:extLst>
          </p:cNvPr>
          <p:cNvSpPr txBox="1"/>
          <p:nvPr/>
        </p:nvSpPr>
        <p:spPr>
          <a:xfrm>
            <a:off x="2552232" y="2667807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=0.199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60B13B1-00F2-48A1-B2F6-AE3E2D4C6BB6}"/>
              </a:ext>
            </a:extLst>
          </p:cNvPr>
          <p:cNvSpPr txBox="1"/>
          <p:nvPr/>
        </p:nvSpPr>
        <p:spPr>
          <a:xfrm>
            <a:off x="7893300" y="635139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2 Figur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55468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38412B11-AA7B-47F6-B71B-92C239D447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8482675"/>
              </p:ext>
            </p:extLst>
          </p:nvPr>
        </p:nvGraphicFramePr>
        <p:xfrm>
          <a:off x="1032281" y="711804"/>
          <a:ext cx="5307965" cy="2619375"/>
        </p:xfrm>
        <a:graphic>
          <a:graphicData uri="http://schemas.openxmlformats.org/drawingml/2006/table">
            <a:tbl>
              <a:tblPr firstRow="1" firstCol="1" bandRow="1"/>
              <a:tblGrid>
                <a:gridCol w="1887220">
                  <a:extLst>
                    <a:ext uri="{9D8B030D-6E8A-4147-A177-3AD203B41FA5}">
                      <a16:colId xmlns:a16="http://schemas.microsoft.com/office/drawing/2014/main" val="3966069629"/>
                    </a:ext>
                  </a:extLst>
                </a:gridCol>
                <a:gridCol w="1350010">
                  <a:extLst>
                    <a:ext uri="{9D8B030D-6E8A-4147-A177-3AD203B41FA5}">
                      <a16:colId xmlns:a16="http://schemas.microsoft.com/office/drawing/2014/main" val="3690550180"/>
                    </a:ext>
                  </a:extLst>
                </a:gridCol>
                <a:gridCol w="1170305">
                  <a:extLst>
                    <a:ext uri="{9D8B030D-6E8A-4147-A177-3AD203B41FA5}">
                      <a16:colId xmlns:a16="http://schemas.microsoft.com/office/drawing/2014/main" val="1775395052"/>
                    </a:ext>
                  </a:extLst>
                </a:gridCol>
                <a:gridCol w="900430">
                  <a:extLst>
                    <a:ext uri="{9D8B030D-6E8A-4147-A177-3AD203B41FA5}">
                      <a16:colId xmlns:a16="http://schemas.microsoft.com/office/drawing/2014/main" val="4225717686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algn="just"/>
                      <a:endParaRPr lang="ja-JP" sz="1050" kern="100" dirty="0"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Dementia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-value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3237951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just"/>
                      <a:endParaRPr lang="ja-JP" sz="1050" kern="100"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+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2204826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Xerostomia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27.3 +/- 15.8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24.2 +/- 6.2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434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0742142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Oral hygiene status</a:t>
                      </a:r>
                      <a:r>
                        <a:rPr lang="ja-JP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(TCI)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52.4 +/- 27.1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55.2 +/- 28.1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720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7168853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Oral hygiene status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6.3 +/- 131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8.3 +/- 23.8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169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7945624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Occlusal force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392.4 +/- 2049.5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740.2 +/- 693.5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208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3976345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Tongue and labium function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.6 +/- 1.5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.4 +/- 1.3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504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6267009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Tongue pressure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6.1 +/- 10.9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21.2 +/- 38.0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563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7626921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Masticatory Function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94 +/- 71.2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84.3 +/- 82.0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180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6116614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Swallowing function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 +/- 0.5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3 +/- 0.8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545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307875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Ability</a:t>
                      </a:r>
                      <a:endParaRPr lang="ja-JP" sz="105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176+/-0.867</a:t>
                      </a:r>
                      <a:endParaRPr lang="ja-JP" sz="105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756 +/- 0.741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472</a:t>
                      </a:r>
                      <a:endParaRPr lang="ja-JP" sz="105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816545"/>
                  </a:ext>
                </a:extLst>
              </a:tr>
            </a:tbl>
          </a:graphicData>
        </a:graphic>
      </p:graphicFrame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A7044B66-B8C7-49FD-A1A9-E0F960C627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5229952"/>
              </p:ext>
            </p:extLst>
          </p:nvPr>
        </p:nvGraphicFramePr>
        <p:xfrm>
          <a:off x="1032281" y="3783486"/>
          <a:ext cx="4138930" cy="1190625"/>
        </p:xfrm>
        <a:graphic>
          <a:graphicData uri="http://schemas.openxmlformats.org/drawingml/2006/table">
            <a:tbl>
              <a:tblPr firstRow="1" firstCol="1" bandRow="1"/>
              <a:tblGrid>
                <a:gridCol w="1257300">
                  <a:extLst>
                    <a:ext uri="{9D8B030D-6E8A-4147-A177-3AD203B41FA5}">
                      <a16:colId xmlns:a16="http://schemas.microsoft.com/office/drawing/2014/main" val="1026201174"/>
                    </a:ext>
                  </a:extLst>
                </a:gridCol>
                <a:gridCol w="755015">
                  <a:extLst>
                    <a:ext uri="{9D8B030D-6E8A-4147-A177-3AD203B41FA5}">
                      <a16:colId xmlns:a16="http://schemas.microsoft.com/office/drawing/2014/main" val="257056969"/>
                    </a:ext>
                  </a:extLst>
                </a:gridCol>
                <a:gridCol w="755015">
                  <a:extLst>
                    <a:ext uri="{9D8B030D-6E8A-4147-A177-3AD203B41FA5}">
                      <a16:colId xmlns:a16="http://schemas.microsoft.com/office/drawing/2014/main" val="365698210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690950860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388271194"/>
                    </a:ext>
                  </a:extLst>
                </a:gridCol>
              </a:tblGrid>
              <a:tr h="238125">
                <a:tc rowSpan="2">
                  <a:txBody>
                    <a:bodyPr/>
                    <a:lstStyle/>
                    <a:p>
                      <a:pPr algn="just"/>
                      <a:endParaRPr lang="ja-JP" sz="1050" kern="100">
                        <a:effectLst/>
                        <a:latin typeface="Century" panose="020406040505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133350"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Dementia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Total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-value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4132423"/>
                  </a:ext>
                </a:extLst>
              </a:tr>
              <a:tr h="23812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+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173340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Ordinary meal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1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25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6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504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393373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rocessed meal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1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22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3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50886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133350" algn="just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Total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22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47</a:t>
                      </a:r>
                      <a:endParaRPr lang="ja-JP" sz="1050" kern="10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33350" algn="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69</a:t>
                      </a:r>
                      <a:endParaRPr lang="ja-JP" sz="105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29530190"/>
                  </a:ext>
                </a:extLst>
              </a:tr>
            </a:tbl>
          </a:graphicData>
        </a:graphic>
      </p:graphicFrame>
      <p:sp>
        <p:nvSpPr>
          <p:cNvPr id="4" name="Rectangle 1">
            <a:extLst>
              <a:ext uri="{FF2B5EF4-FFF2-40B4-BE49-F238E27FC236}">
                <a16:creationId xmlns:a16="http://schemas.microsoft.com/office/drawing/2014/main" id="{E954235A-34C9-4120-82C7-600AE471B7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7931" y="252013"/>
            <a:ext cx="4608469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 Table Oral functions and meal styles against with or without dementia</a:t>
            </a:r>
            <a:endParaRPr kumimoji="0" lang="en-US" altLang="ja-JP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695000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5</TotalTime>
  <Words>148</Words>
  <Application>Microsoft Office PowerPoint</Application>
  <PresentationFormat>A4 210 x 297 mm</PresentationFormat>
  <Paragraphs>70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野村 義明</dc:creator>
  <cp:lastModifiedBy>義明 野村</cp:lastModifiedBy>
  <cp:revision>32</cp:revision>
  <cp:lastPrinted>2019-07-31T11:49:27Z</cp:lastPrinted>
  <dcterms:created xsi:type="dcterms:W3CDTF">2019-07-09T03:53:43Z</dcterms:created>
  <dcterms:modified xsi:type="dcterms:W3CDTF">2020-01-14T10:50:52Z</dcterms:modified>
</cp:coreProperties>
</file>